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sldIdLst>
    <p:sldId id="258" r:id="rId2"/>
    <p:sldId id="256" r:id="rId3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606" userDrawn="1">
          <p15:clr>
            <a:srgbClr val="A4A3A4"/>
          </p15:clr>
        </p15:guide>
        <p15:guide id="2" pos="2614" userDrawn="1">
          <p15:clr>
            <a:srgbClr val="A4A3A4"/>
          </p15:clr>
        </p15:guide>
        <p15:guide id="3" orient="horz" pos="2472" userDrawn="1">
          <p15:clr>
            <a:srgbClr val="A4A3A4"/>
          </p15:clr>
        </p15:guide>
        <p15:guide id="4" orient="horz" pos="437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524" autoAdjust="0"/>
  </p:normalViewPr>
  <p:slideViewPr>
    <p:cSldViewPr snapToObjects="1" showGuides="1">
      <p:cViewPr varScale="1">
        <p:scale>
          <a:sx n="81" d="100"/>
          <a:sy n="81" d="100"/>
        </p:scale>
        <p:origin x="-138" y="-102"/>
      </p:cViewPr>
      <p:guideLst>
        <p:guide orient="horz" pos="5329"/>
        <p:guide orient="horz" pos="431"/>
        <p:guide orient="horz" pos="5375"/>
        <p:guide orient="horz" pos="5284"/>
        <p:guide orient="horz" pos="4150"/>
        <p:guide pos="3748"/>
        <p:guide pos="2523"/>
        <p:guide pos="2387"/>
        <p:guide pos="333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5D996-30B0-4F4A-B8FC-E464944D70B8}" type="datetimeFigureOut">
              <a:rPr lang="zh-CN" altLang="en-US" smtClean="0"/>
              <a:pPr/>
              <a:t>2015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DCE28-4204-438B-9EAF-F34A92DB7697}" type="slidenum">
              <a:rPr lang="zh-CN" altLang="en-US" smtClean="0"/>
              <a:pPr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98585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5D996-30B0-4F4A-B8FC-E464944D70B8}" type="datetimeFigureOut">
              <a:rPr lang="zh-CN" altLang="en-US" smtClean="0"/>
              <a:pPr/>
              <a:t>2015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DCE28-4204-438B-9EAF-F34A92DB7697}" type="slidenum">
              <a:rPr lang="zh-CN" altLang="en-US" smtClean="0"/>
              <a:pPr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117230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5D996-30B0-4F4A-B8FC-E464944D70B8}" type="datetimeFigureOut">
              <a:rPr lang="zh-CN" altLang="en-US" smtClean="0"/>
              <a:pPr/>
              <a:t>2015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DCE28-4204-438B-9EAF-F34A92DB7697}" type="slidenum">
              <a:rPr lang="zh-CN" altLang="en-US" smtClean="0"/>
              <a:pPr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04491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5D996-30B0-4F4A-B8FC-E464944D70B8}" type="datetimeFigureOut">
              <a:rPr lang="zh-CN" altLang="en-US" smtClean="0"/>
              <a:pPr/>
              <a:t>2015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DCE28-4204-438B-9EAF-F34A92DB7697}" type="slidenum">
              <a:rPr lang="zh-CN" altLang="en-US" smtClean="0"/>
              <a:pPr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70226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5D996-30B0-4F4A-B8FC-E464944D70B8}" type="datetimeFigureOut">
              <a:rPr lang="zh-CN" altLang="en-US" smtClean="0"/>
              <a:pPr/>
              <a:t>2015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DCE28-4204-438B-9EAF-F34A92DB7697}" type="slidenum">
              <a:rPr lang="zh-CN" altLang="en-US" smtClean="0"/>
              <a:pPr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41065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5D996-30B0-4F4A-B8FC-E464944D70B8}" type="datetimeFigureOut">
              <a:rPr lang="zh-CN" altLang="en-US" smtClean="0"/>
              <a:pPr/>
              <a:t>2015/12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DCE28-4204-438B-9EAF-F34A92DB7697}" type="slidenum">
              <a:rPr lang="zh-CN" altLang="en-US" smtClean="0"/>
              <a:pPr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66015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5D996-30B0-4F4A-B8FC-E464944D70B8}" type="datetimeFigureOut">
              <a:rPr lang="zh-CN" altLang="en-US" smtClean="0"/>
              <a:pPr/>
              <a:t>2015/12/1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DCE28-4204-438B-9EAF-F34A92DB7697}" type="slidenum">
              <a:rPr lang="zh-CN" altLang="en-US" smtClean="0"/>
              <a:pPr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51797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5D996-30B0-4F4A-B8FC-E464944D70B8}" type="datetimeFigureOut">
              <a:rPr lang="zh-CN" altLang="en-US" smtClean="0"/>
              <a:pPr/>
              <a:t>2015/12/1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DCE28-4204-438B-9EAF-F34A92DB7697}" type="slidenum">
              <a:rPr lang="zh-CN" altLang="en-US" smtClean="0"/>
              <a:pPr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392705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5D996-30B0-4F4A-B8FC-E464944D70B8}" type="datetimeFigureOut">
              <a:rPr lang="zh-CN" altLang="en-US" smtClean="0"/>
              <a:pPr/>
              <a:t>2015/12/1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DCE28-4204-438B-9EAF-F34A92DB7697}" type="slidenum">
              <a:rPr lang="zh-CN" altLang="en-US" smtClean="0"/>
              <a:pPr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026778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5D996-30B0-4F4A-B8FC-E464944D70B8}" type="datetimeFigureOut">
              <a:rPr lang="zh-CN" altLang="en-US" smtClean="0"/>
              <a:pPr/>
              <a:t>2015/12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DCE28-4204-438B-9EAF-F34A92DB7697}" type="slidenum">
              <a:rPr lang="zh-CN" altLang="en-US" smtClean="0"/>
              <a:pPr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534537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5D996-30B0-4F4A-B8FC-E464944D70B8}" type="datetimeFigureOut">
              <a:rPr lang="zh-CN" altLang="en-US" smtClean="0"/>
              <a:pPr/>
              <a:t>2015/12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DCE28-4204-438B-9EAF-F34A92DB7697}" type="slidenum">
              <a:rPr lang="zh-CN" altLang="en-US" smtClean="0"/>
              <a:pPr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31996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05D996-30B0-4F4A-B8FC-E464944D70B8}" type="datetimeFigureOut">
              <a:rPr lang="zh-CN" altLang="en-US" smtClean="0"/>
              <a:pPr/>
              <a:t>2015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ADCE28-4204-438B-9EAF-F34A92DB7697}" type="slidenum">
              <a:rPr lang="zh-CN" altLang="en-US" smtClean="0"/>
              <a:pPr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22508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6.emf"/><Relationship Id="rId4" Type="http://schemas.openxmlformats.org/officeDocument/2006/relationships/image" Target="../media/image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 preferRelativeResize="0">
            <a:picLocks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75008" y="749895"/>
            <a:ext cx="2788920" cy="16459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" name="Picture 2"/>
          <p:cNvPicPr preferRelativeResize="0">
            <a:picLocks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617344" y="2965741"/>
            <a:ext cx="2743200" cy="16411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9" name="ZoneTexte 9"/>
          <p:cNvSpPr txBox="1">
            <a:spLocks noChangeArrowheads="1"/>
          </p:cNvSpPr>
          <p:nvPr/>
        </p:nvSpPr>
        <p:spPr bwMode="auto">
          <a:xfrm>
            <a:off x="685562" y="4693981"/>
            <a:ext cx="2518064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1000" b="1" dirty="0">
                <a:latin typeface="Arial" pitchFamily="34" charset="0"/>
                <a:cs typeface="Arial" pitchFamily="34" charset="0"/>
              </a:rPr>
              <a:t>PC-1 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(80%)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ZoneTexte 9"/>
          <p:cNvSpPr txBox="1"/>
          <p:nvPr/>
        </p:nvSpPr>
        <p:spPr bwMode="auto">
          <a:xfrm>
            <a:off x="158911" y="3054183"/>
            <a:ext cx="338554" cy="1463293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000" b="1" dirty="0">
                <a:latin typeface="Arial" pitchFamily="34" charset="0"/>
                <a:cs typeface="Arial" pitchFamily="34" charset="0"/>
              </a:rPr>
              <a:t>PC-2 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(17%)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1" name="组合 18"/>
          <p:cNvGrpSpPr/>
          <p:nvPr/>
        </p:nvGrpSpPr>
        <p:grpSpPr>
          <a:xfrm>
            <a:off x="468900" y="4537744"/>
            <a:ext cx="3010136" cy="256736"/>
            <a:chOff x="81618" y="4806468"/>
            <a:chExt cx="3010136" cy="256736"/>
          </a:xfrm>
        </p:grpSpPr>
        <p:sp>
          <p:nvSpPr>
            <p:cNvPr id="12" name="ZoneTexte 3"/>
            <p:cNvSpPr txBox="1">
              <a:spLocks noChangeArrowheads="1"/>
            </p:cNvSpPr>
            <p:nvPr/>
          </p:nvSpPr>
          <p:spPr bwMode="auto">
            <a:xfrm>
              <a:off x="1067720" y="4809288"/>
              <a:ext cx="158915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>
                  <a:latin typeface="Arial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13" name="ZoneTexte 12"/>
            <p:cNvSpPr txBox="1">
              <a:spLocks noChangeArrowheads="1"/>
            </p:cNvSpPr>
            <p:nvPr/>
          </p:nvSpPr>
          <p:spPr bwMode="auto">
            <a:xfrm>
              <a:off x="2554111" y="4810840"/>
              <a:ext cx="537643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0.8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ZoneTexte 13"/>
            <p:cNvSpPr txBox="1">
              <a:spLocks noChangeArrowheads="1"/>
            </p:cNvSpPr>
            <p:nvPr/>
          </p:nvSpPr>
          <p:spPr bwMode="auto">
            <a:xfrm>
              <a:off x="81618" y="4806468"/>
              <a:ext cx="43404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-0.4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5" name="ZoneTexte 19"/>
          <p:cNvSpPr txBox="1">
            <a:spLocks noChangeArrowheads="1"/>
          </p:cNvSpPr>
          <p:nvPr/>
        </p:nvSpPr>
        <p:spPr bwMode="auto">
          <a:xfrm>
            <a:off x="4062866" y="4696276"/>
            <a:ext cx="251899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1000" b="1" dirty="0" err="1">
                <a:latin typeface="Arial" pitchFamily="34" charset="0"/>
                <a:cs typeface="Arial" pitchFamily="34" charset="0"/>
              </a:rPr>
              <a:t>Wavenumbers</a:t>
            </a:r>
            <a:r>
              <a:rPr lang="en-US" sz="1000" b="1" dirty="0">
                <a:latin typeface="Arial" pitchFamily="34" charset="0"/>
                <a:cs typeface="Arial" pitchFamily="34" charset="0"/>
              </a:rPr>
              <a:t> (cm</a:t>
            </a:r>
            <a:r>
              <a:rPr lang="en-US" sz="1000" b="1" baseline="30000" dirty="0">
                <a:latin typeface="Arial" pitchFamily="34" charset="0"/>
                <a:cs typeface="Arial" pitchFamily="34" charset="0"/>
              </a:rPr>
              <a:t>-1</a:t>
            </a:r>
            <a:r>
              <a:rPr lang="en-US" sz="1000" b="1" dirty="0">
                <a:latin typeface="Arial" pitchFamily="34" charset="0"/>
                <a:cs typeface="Arial" pitchFamily="34" charset="0"/>
              </a:rPr>
              <a:t>)</a:t>
            </a:r>
          </a:p>
        </p:txBody>
      </p:sp>
      <p:sp>
        <p:nvSpPr>
          <p:cNvPr id="16" name="TextBox 59"/>
          <p:cNvSpPr txBox="1">
            <a:spLocks noChangeArrowheads="1"/>
          </p:cNvSpPr>
          <p:nvPr/>
        </p:nvSpPr>
        <p:spPr bwMode="auto">
          <a:xfrm>
            <a:off x="3487278" y="3066709"/>
            <a:ext cx="338554" cy="148356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vert270"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Absorbance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Line 14"/>
          <p:cNvSpPr>
            <a:spLocks noChangeShapeType="1"/>
          </p:cNvSpPr>
          <p:nvPr/>
        </p:nvSpPr>
        <p:spPr bwMode="auto">
          <a:xfrm flipV="1">
            <a:off x="4069812" y="4525571"/>
            <a:ext cx="0" cy="30336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8" name="Line 15"/>
          <p:cNvSpPr>
            <a:spLocks noChangeShapeType="1"/>
          </p:cNvSpPr>
          <p:nvPr/>
        </p:nvSpPr>
        <p:spPr bwMode="auto">
          <a:xfrm flipV="1">
            <a:off x="4489117" y="4525571"/>
            <a:ext cx="0" cy="1573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9" name="Line 16"/>
          <p:cNvSpPr>
            <a:spLocks noChangeShapeType="1"/>
          </p:cNvSpPr>
          <p:nvPr/>
        </p:nvSpPr>
        <p:spPr bwMode="auto">
          <a:xfrm flipV="1">
            <a:off x="4907024" y="4525571"/>
            <a:ext cx="0" cy="30336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20" name="Line 17"/>
          <p:cNvSpPr>
            <a:spLocks noChangeShapeType="1"/>
          </p:cNvSpPr>
          <p:nvPr/>
        </p:nvSpPr>
        <p:spPr bwMode="auto">
          <a:xfrm flipV="1">
            <a:off x="5326329" y="4525571"/>
            <a:ext cx="0" cy="1573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21" name="Line 18"/>
          <p:cNvSpPr>
            <a:spLocks noChangeShapeType="1"/>
          </p:cNvSpPr>
          <p:nvPr/>
        </p:nvSpPr>
        <p:spPr bwMode="auto">
          <a:xfrm flipV="1">
            <a:off x="5745634" y="4525571"/>
            <a:ext cx="0" cy="30336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22" name="Line 19"/>
          <p:cNvSpPr>
            <a:spLocks noChangeShapeType="1"/>
          </p:cNvSpPr>
          <p:nvPr/>
        </p:nvSpPr>
        <p:spPr bwMode="auto">
          <a:xfrm flipV="1">
            <a:off x="6163542" y="4525571"/>
            <a:ext cx="0" cy="1573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23" name="Line 20"/>
          <p:cNvSpPr>
            <a:spLocks noChangeShapeType="1"/>
          </p:cNvSpPr>
          <p:nvPr/>
        </p:nvSpPr>
        <p:spPr bwMode="auto">
          <a:xfrm flipV="1">
            <a:off x="6582847" y="4525571"/>
            <a:ext cx="0" cy="30336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24" name="Line 21"/>
          <p:cNvSpPr>
            <a:spLocks noChangeShapeType="1"/>
          </p:cNvSpPr>
          <p:nvPr/>
        </p:nvSpPr>
        <p:spPr bwMode="auto">
          <a:xfrm>
            <a:off x="4069812" y="4525571"/>
            <a:ext cx="2513035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25" name="Line 22"/>
          <p:cNvSpPr>
            <a:spLocks noChangeShapeType="1"/>
          </p:cNvSpPr>
          <p:nvPr/>
        </p:nvSpPr>
        <p:spPr bwMode="auto">
          <a:xfrm>
            <a:off x="4033472" y="4525571"/>
            <a:ext cx="36340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26" name="Line 23"/>
          <p:cNvSpPr>
            <a:spLocks noChangeShapeType="1"/>
          </p:cNvSpPr>
          <p:nvPr/>
        </p:nvSpPr>
        <p:spPr bwMode="auto">
          <a:xfrm>
            <a:off x="4051641" y="4340187"/>
            <a:ext cx="18170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27" name="Line 24"/>
          <p:cNvSpPr>
            <a:spLocks noChangeShapeType="1"/>
          </p:cNvSpPr>
          <p:nvPr/>
        </p:nvSpPr>
        <p:spPr bwMode="auto">
          <a:xfrm>
            <a:off x="4033472" y="4153679"/>
            <a:ext cx="36340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28" name="Line 25"/>
          <p:cNvSpPr>
            <a:spLocks noChangeShapeType="1"/>
          </p:cNvSpPr>
          <p:nvPr/>
        </p:nvSpPr>
        <p:spPr bwMode="auto">
          <a:xfrm>
            <a:off x="4051641" y="3968295"/>
            <a:ext cx="18170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29" name="Line 26"/>
          <p:cNvSpPr>
            <a:spLocks noChangeShapeType="1"/>
          </p:cNvSpPr>
          <p:nvPr/>
        </p:nvSpPr>
        <p:spPr bwMode="auto">
          <a:xfrm>
            <a:off x="4033472" y="3781787"/>
            <a:ext cx="36340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30" name="Line 27"/>
          <p:cNvSpPr>
            <a:spLocks noChangeShapeType="1"/>
          </p:cNvSpPr>
          <p:nvPr/>
        </p:nvSpPr>
        <p:spPr bwMode="auto">
          <a:xfrm>
            <a:off x="4051641" y="3595279"/>
            <a:ext cx="18170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31" name="Line 28"/>
          <p:cNvSpPr>
            <a:spLocks noChangeShapeType="1"/>
          </p:cNvSpPr>
          <p:nvPr/>
        </p:nvSpPr>
        <p:spPr bwMode="auto">
          <a:xfrm>
            <a:off x="4033472" y="3409895"/>
            <a:ext cx="36340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32" name="Line 29"/>
          <p:cNvSpPr>
            <a:spLocks noChangeShapeType="1"/>
          </p:cNvSpPr>
          <p:nvPr/>
        </p:nvSpPr>
        <p:spPr bwMode="auto">
          <a:xfrm>
            <a:off x="4051641" y="3224511"/>
            <a:ext cx="18170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33" name="Line 30"/>
          <p:cNvSpPr>
            <a:spLocks noChangeShapeType="1"/>
          </p:cNvSpPr>
          <p:nvPr/>
        </p:nvSpPr>
        <p:spPr bwMode="auto">
          <a:xfrm>
            <a:off x="4033472" y="3038003"/>
            <a:ext cx="36340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34" name="Line 31"/>
          <p:cNvSpPr>
            <a:spLocks noChangeShapeType="1"/>
          </p:cNvSpPr>
          <p:nvPr/>
        </p:nvSpPr>
        <p:spPr bwMode="auto">
          <a:xfrm flipV="1">
            <a:off x="4069812" y="3038003"/>
            <a:ext cx="0" cy="1487568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grpSp>
        <p:nvGrpSpPr>
          <p:cNvPr id="35" name="组合 324"/>
          <p:cNvGrpSpPr/>
          <p:nvPr/>
        </p:nvGrpSpPr>
        <p:grpSpPr>
          <a:xfrm>
            <a:off x="3818831" y="2973740"/>
            <a:ext cx="183172" cy="1633816"/>
            <a:chOff x="3918564" y="717941"/>
            <a:chExt cx="136539" cy="3720859"/>
          </a:xfrm>
        </p:grpSpPr>
        <p:sp>
          <p:nvSpPr>
            <p:cNvPr id="36" name="Rectangle 11"/>
            <p:cNvSpPr>
              <a:spLocks noChangeArrowheads="1"/>
            </p:cNvSpPr>
            <p:nvPr/>
          </p:nvSpPr>
          <p:spPr bwMode="auto">
            <a:xfrm>
              <a:off x="4000392" y="4088335"/>
              <a:ext cx="52575" cy="3504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0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Rectangle 15"/>
            <p:cNvSpPr>
              <a:spLocks noChangeArrowheads="1"/>
            </p:cNvSpPr>
            <p:nvPr/>
          </p:nvSpPr>
          <p:spPr bwMode="auto">
            <a:xfrm>
              <a:off x="3923177" y="1611089"/>
              <a:ext cx="131439" cy="3504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0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3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Rectangle 15"/>
            <p:cNvSpPr>
              <a:spLocks noChangeArrowheads="1"/>
            </p:cNvSpPr>
            <p:nvPr/>
          </p:nvSpPr>
          <p:spPr bwMode="auto">
            <a:xfrm>
              <a:off x="3918584" y="2368066"/>
              <a:ext cx="131438" cy="3504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0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Rectangle 15"/>
            <p:cNvSpPr>
              <a:spLocks noChangeArrowheads="1"/>
            </p:cNvSpPr>
            <p:nvPr/>
          </p:nvSpPr>
          <p:spPr bwMode="auto">
            <a:xfrm>
              <a:off x="3923664" y="717941"/>
              <a:ext cx="131439" cy="3504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0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Rectangle 15"/>
            <p:cNvSpPr>
              <a:spLocks noChangeArrowheads="1"/>
            </p:cNvSpPr>
            <p:nvPr/>
          </p:nvSpPr>
          <p:spPr bwMode="auto">
            <a:xfrm>
              <a:off x="3918564" y="3229906"/>
              <a:ext cx="131438" cy="3504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0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1" name="组合 331"/>
          <p:cNvGrpSpPr/>
          <p:nvPr/>
        </p:nvGrpSpPr>
        <p:grpSpPr>
          <a:xfrm>
            <a:off x="3924253" y="4588052"/>
            <a:ext cx="2797795" cy="163756"/>
            <a:chOff x="3611822" y="4999408"/>
            <a:chExt cx="2085502" cy="372936"/>
          </a:xfrm>
        </p:grpSpPr>
        <p:sp>
          <p:nvSpPr>
            <p:cNvPr id="42" name="Rectangle 5"/>
            <p:cNvSpPr>
              <a:spLocks noChangeArrowheads="1"/>
            </p:cNvSpPr>
            <p:nvPr/>
          </p:nvSpPr>
          <p:spPr bwMode="auto">
            <a:xfrm>
              <a:off x="3611822" y="4999659"/>
              <a:ext cx="210302" cy="3504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1480</a:t>
              </a:r>
              <a:endParaRPr kumimoji="0" lang="zh-CN" altLang="zh-CN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3" name="Rectangle 5"/>
            <p:cNvSpPr>
              <a:spLocks noChangeArrowheads="1"/>
            </p:cNvSpPr>
            <p:nvPr/>
          </p:nvSpPr>
          <p:spPr bwMode="auto">
            <a:xfrm>
              <a:off x="4241373" y="5005988"/>
              <a:ext cx="210302" cy="3504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1440</a:t>
              </a:r>
              <a:endParaRPr kumimoji="0" lang="zh-CN" altLang="zh-CN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4" name="Rectangle 5"/>
            <p:cNvSpPr>
              <a:spLocks noChangeArrowheads="1"/>
            </p:cNvSpPr>
            <p:nvPr/>
          </p:nvSpPr>
          <p:spPr bwMode="auto">
            <a:xfrm>
              <a:off x="4864198" y="4999408"/>
              <a:ext cx="210302" cy="3504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1400</a:t>
              </a:r>
              <a:endParaRPr kumimoji="0" lang="zh-CN" altLang="zh-CN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5" name="Rectangle 5"/>
            <p:cNvSpPr>
              <a:spLocks noChangeArrowheads="1"/>
            </p:cNvSpPr>
            <p:nvPr/>
          </p:nvSpPr>
          <p:spPr bwMode="auto">
            <a:xfrm>
              <a:off x="5487022" y="5021879"/>
              <a:ext cx="210302" cy="3504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1360</a:t>
              </a:r>
              <a:endParaRPr kumimoji="0" lang="zh-CN" altLang="zh-CN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sp>
        <p:nvSpPr>
          <p:cNvPr id="156" name="Line 15"/>
          <p:cNvSpPr>
            <a:spLocks noChangeShapeType="1"/>
          </p:cNvSpPr>
          <p:nvPr/>
        </p:nvSpPr>
        <p:spPr bwMode="auto">
          <a:xfrm flipV="1">
            <a:off x="4072074" y="2311843"/>
            <a:ext cx="0" cy="29718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57" name="Line 16"/>
          <p:cNvSpPr>
            <a:spLocks noChangeShapeType="1"/>
          </p:cNvSpPr>
          <p:nvPr/>
        </p:nvSpPr>
        <p:spPr bwMode="auto">
          <a:xfrm flipV="1">
            <a:off x="4489909" y="2311843"/>
            <a:ext cx="0" cy="14859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58" name="Line 17"/>
          <p:cNvSpPr>
            <a:spLocks noChangeShapeType="1"/>
          </p:cNvSpPr>
          <p:nvPr/>
        </p:nvSpPr>
        <p:spPr bwMode="auto">
          <a:xfrm flipV="1">
            <a:off x="4909160" y="2311843"/>
            <a:ext cx="0" cy="29718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59" name="Line 18"/>
          <p:cNvSpPr>
            <a:spLocks noChangeShapeType="1"/>
          </p:cNvSpPr>
          <p:nvPr/>
        </p:nvSpPr>
        <p:spPr bwMode="auto">
          <a:xfrm flipV="1">
            <a:off x="5326995" y="2311843"/>
            <a:ext cx="0" cy="14859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60" name="Line 19"/>
          <p:cNvSpPr>
            <a:spLocks noChangeShapeType="1"/>
          </p:cNvSpPr>
          <p:nvPr/>
        </p:nvSpPr>
        <p:spPr bwMode="auto">
          <a:xfrm flipV="1">
            <a:off x="5746247" y="2311843"/>
            <a:ext cx="0" cy="29718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61" name="Line 20"/>
          <p:cNvSpPr>
            <a:spLocks noChangeShapeType="1"/>
          </p:cNvSpPr>
          <p:nvPr/>
        </p:nvSpPr>
        <p:spPr bwMode="auto">
          <a:xfrm flipV="1">
            <a:off x="6165498" y="2311843"/>
            <a:ext cx="0" cy="14859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62" name="Line 21"/>
          <p:cNvSpPr>
            <a:spLocks noChangeShapeType="1"/>
          </p:cNvSpPr>
          <p:nvPr/>
        </p:nvSpPr>
        <p:spPr bwMode="auto">
          <a:xfrm flipV="1">
            <a:off x="6583333" y="2311843"/>
            <a:ext cx="0" cy="29718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63" name="Line 22"/>
          <p:cNvSpPr>
            <a:spLocks noChangeShapeType="1"/>
          </p:cNvSpPr>
          <p:nvPr/>
        </p:nvSpPr>
        <p:spPr bwMode="auto">
          <a:xfrm>
            <a:off x="4072074" y="2311843"/>
            <a:ext cx="2511260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64" name="Line 23"/>
          <p:cNvSpPr>
            <a:spLocks noChangeShapeType="1"/>
          </p:cNvSpPr>
          <p:nvPr/>
        </p:nvSpPr>
        <p:spPr bwMode="auto">
          <a:xfrm>
            <a:off x="4033831" y="2311843"/>
            <a:ext cx="38243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65" name="Line 24"/>
          <p:cNvSpPr>
            <a:spLocks noChangeShapeType="1"/>
          </p:cNvSpPr>
          <p:nvPr/>
        </p:nvSpPr>
        <p:spPr bwMode="auto">
          <a:xfrm>
            <a:off x="4053660" y="2162110"/>
            <a:ext cx="18414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66" name="Line 25"/>
          <p:cNvSpPr>
            <a:spLocks noChangeShapeType="1"/>
          </p:cNvSpPr>
          <p:nvPr/>
        </p:nvSpPr>
        <p:spPr bwMode="auto">
          <a:xfrm>
            <a:off x="4033831" y="2012377"/>
            <a:ext cx="38243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67" name="Line 26"/>
          <p:cNvSpPr>
            <a:spLocks noChangeShapeType="1"/>
          </p:cNvSpPr>
          <p:nvPr/>
        </p:nvSpPr>
        <p:spPr bwMode="auto">
          <a:xfrm>
            <a:off x="4053660" y="1862644"/>
            <a:ext cx="18414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68" name="Line 27"/>
          <p:cNvSpPr>
            <a:spLocks noChangeShapeType="1"/>
          </p:cNvSpPr>
          <p:nvPr/>
        </p:nvSpPr>
        <p:spPr bwMode="auto">
          <a:xfrm>
            <a:off x="4033831" y="1712911"/>
            <a:ext cx="38243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69" name="Line 28"/>
          <p:cNvSpPr>
            <a:spLocks noChangeShapeType="1"/>
          </p:cNvSpPr>
          <p:nvPr/>
        </p:nvSpPr>
        <p:spPr bwMode="auto">
          <a:xfrm>
            <a:off x="4053660" y="1563178"/>
            <a:ext cx="18414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70" name="Line 29"/>
          <p:cNvSpPr>
            <a:spLocks noChangeShapeType="1"/>
          </p:cNvSpPr>
          <p:nvPr/>
        </p:nvSpPr>
        <p:spPr bwMode="auto">
          <a:xfrm>
            <a:off x="4033831" y="1413445"/>
            <a:ext cx="38243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71" name="Line 30"/>
          <p:cNvSpPr>
            <a:spLocks noChangeShapeType="1"/>
          </p:cNvSpPr>
          <p:nvPr/>
        </p:nvSpPr>
        <p:spPr bwMode="auto">
          <a:xfrm>
            <a:off x="4053660" y="1263712"/>
            <a:ext cx="18414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72" name="Line 31"/>
          <p:cNvSpPr>
            <a:spLocks noChangeShapeType="1"/>
          </p:cNvSpPr>
          <p:nvPr/>
        </p:nvSpPr>
        <p:spPr bwMode="auto">
          <a:xfrm>
            <a:off x="4033831" y="1113979"/>
            <a:ext cx="38243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73" name="Line 32"/>
          <p:cNvSpPr>
            <a:spLocks noChangeShapeType="1"/>
          </p:cNvSpPr>
          <p:nvPr/>
        </p:nvSpPr>
        <p:spPr bwMode="auto">
          <a:xfrm>
            <a:off x="4053660" y="964246"/>
            <a:ext cx="18414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74" name="Line 33"/>
          <p:cNvSpPr>
            <a:spLocks noChangeShapeType="1"/>
          </p:cNvSpPr>
          <p:nvPr/>
        </p:nvSpPr>
        <p:spPr bwMode="auto">
          <a:xfrm>
            <a:off x="4033831" y="814513"/>
            <a:ext cx="38243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75" name="Line 34"/>
          <p:cNvSpPr>
            <a:spLocks noChangeShapeType="1"/>
          </p:cNvSpPr>
          <p:nvPr/>
        </p:nvSpPr>
        <p:spPr bwMode="auto">
          <a:xfrm flipV="1">
            <a:off x="4072074" y="814513"/>
            <a:ext cx="0" cy="149733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76" name="ZoneTexte 19"/>
          <p:cNvSpPr txBox="1">
            <a:spLocks noChangeArrowheads="1"/>
          </p:cNvSpPr>
          <p:nvPr/>
        </p:nvSpPr>
        <p:spPr bwMode="auto">
          <a:xfrm>
            <a:off x="4076545" y="2484270"/>
            <a:ext cx="250637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1000" b="1" dirty="0" err="1">
                <a:latin typeface="Arial" pitchFamily="34" charset="0"/>
                <a:cs typeface="Arial" pitchFamily="34" charset="0"/>
              </a:rPr>
              <a:t>Wavenumbers</a:t>
            </a:r>
            <a:r>
              <a:rPr lang="en-US" sz="1000" b="1" dirty="0">
                <a:latin typeface="Arial" pitchFamily="34" charset="0"/>
                <a:cs typeface="Arial" pitchFamily="34" charset="0"/>
              </a:rPr>
              <a:t> (cm</a:t>
            </a:r>
            <a:r>
              <a:rPr lang="en-US" sz="1000" b="1" baseline="30000" dirty="0">
                <a:latin typeface="Arial" pitchFamily="34" charset="0"/>
                <a:cs typeface="Arial" pitchFamily="34" charset="0"/>
              </a:rPr>
              <a:t>-1</a:t>
            </a:r>
            <a:r>
              <a:rPr lang="en-US" sz="1000" b="1" dirty="0">
                <a:latin typeface="Arial" pitchFamily="34" charset="0"/>
                <a:cs typeface="Arial" pitchFamily="34" charset="0"/>
              </a:rPr>
              <a:t>)</a:t>
            </a:r>
          </a:p>
        </p:txBody>
      </p:sp>
      <p:sp>
        <p:nvSpPr>
          <p:cNvPr id="177" name="TextBox 59"/>
          <p:cNvSpPr txBox="1">
            <a:spLocks noChangeArrowheads="1"/>
          </p:cNvSpPr>
          <p:nvPr/>
        </p:nvSpPr>
        <p:spPr bwMode="auto">
          <a:xfrm>
            <a:off x="3477255" y="827040"/>
            <a:ext cx="338554" cy="15032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vert270"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Absorbance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78" name="组合 245"/>
          <p:cNvGrpSpPr/>
          <p:nvPr/>
        </p:nvGrpSpPr>
        <p:grpSpPr>
          <a:xfrm>
            <a:off x="3939479" y="2370414"/>
            <a:ext cx="2785232" cy="156898"/>
            <a:chOff x="3279148" y="5191705"/>
            <a:chExt cx="2785232" cy="156898"/>
          </a:xfrm>
        </p:grpSpPr>
        <p:sp>
          <p:nvSpPr>
            <p:cNvPr id="179" name="Rectangle 5"/>
            <p:cNvSpPr>
              <a:spLocks noChangeArrowheads="1"/>
            </p:cNvSpPr>
            <p:nvPr/>
          </p:nvSpPr>
          <p:spPr bwMode="auto">
            <a:xfrm>
              <a:off x="3279148" y="5194684"/>
              <a:ext cx="28212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1480</a:t>
              </a:r>
              <a:endParaRPr kumimoji="0" lang="zh-CN" altLang="zh-CN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80" name="Rectangle 5"/>
            <p:cNvSpPr>
              <a:spLocks noChangeArrowheads="1"/>
            </p:cNvSpPr>
            <p:nvPr/>
          </p:nvSpPr>
          <p:spPr bwMode="auto">
            <a:xfrm>
              <a:off x="4112515" y="5192379"/>
              <a:ext cx="28212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1440</a:t>
              </a:r>
              <a:endParaRPr kumimoji="0" lang="zh-CN" altLang="zh-CN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81" name="Rectangle 5"/>
            <p:cNvSpPr>
              <a:spLocks noChangeArrowheads="1"/>
            </p:cNvSpPr>
            <p:nvPr/>
          </p:nvSpPr>
          <p:spPr bwMode="auto">
            <a:xfrm>
              <a:off x="4947383" y="5194715"/>
              <a:ext cx="28212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1400</a:t>
              </a:r>
              <a:endParaRPr kumimoji="0" lang="zh-CN" altLang="zh-CN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82" name="Rectangle 5"/>
            <p:cNvSpPr>
              <a:spLocks noChangeArrowheads="1"/>
            </p:cNvSpPr>
            <p:nvPr/>
          </p:nvSpPr>
          <p:spPr bwMode="auto">
            <a:xfrm>
              <a:off x="5782251" y="5191705"/>
              <a:ext cx="28212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1360</a:t>
              </a:r>
              <a:endParaRPr kumimoji="0" lang="zh-CN" altLang="zh-CN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183" name="组合 250"/>
          <p:cNvGrpSpPr/>
          <p:nvPr/>
        </p:nvGrpSpPr>
        <p:grpSpPr>
          <a:xfrm>
            <a:off x="3759977" y="737570"/>
            <a:ext cx="248340" cy="1641384"/>
            <a:chOff x="3936131" y="2156825"/>
            <a:chExt cx="248340" cy="1641384"/>
          </a:xfrm>
        </p:grpSpPr>
        <p:sp>
          <p:nvSpPr>
            <p:cNvPr id="184" name="Rectangle 11"/>
            <p:cNvSpPr>
              <a:spLocks noChangeArrowheads="1"/>
            </p:cNvSpPr>
            <p:nvPr/>
          </p:nvSpPr>
          <p:spPr bwMode="auto">
            <a:xfrm>
              <a:off x="4113842" y="3644321"/>
              <a:ext cx="7053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0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5" name="Rectangle 15"/>
            <p:cNvSpPr>
              <a:spLocks noChangeArrowheads="1"/>
            </p:cNvSpPr>
            <p:nvPr/>
          </p:nvSpPr>
          <p:spPr bwMode="auto">
            <a:xfrm>
              <a:off x="3936131" y="2771477"/>
              <a:ext cx="24686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0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15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6" name="Rectangle 15"/>
            <p:cNvSpPr>
              <a:spLocks noChangeArrowheads="1"/>
            </p:cNvSpPr>
            <p:nvPr/>
          </p:nvSpPr>
          <p:spPr bwMode="auto">
            <a:xfrm>
              <a:off x="3937088" y="3068157"/>
              <a:ext cx="24686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0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10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7" name="Rectangle 15"/>
            <p:cNvSpPr>
              <a:spLocks noChangeArrowheads="1"/>
            </p:cNvSpPr>
            <p:nvPr/>
          </p:nvSpPr>
          <p:spPr bwMode="auto">
            <a:xfrm>
              <a:off x="3936131" y="2156825"/>
              <a:ext cx="24686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0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25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8" name="Rectangle 15"/>
            <p:cNvSpPr>
              <a:spLocks noChangeArrowheads="1"/>
            </p:cNvSpPr>
            <p:nvPr/>
          </p:nvSpPr>
          <p:spPr bwMode="auto">
            <a:xfrm>
              <a:off x="3936131" y="2467055"/>
              <a:ext cx="24686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0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20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9" name="Rectangle 15"/>
            <p:cNvSpPr>
              <a:spLocks noChangeArrowheads="1"/>
            </p:cNvSpPr>
            <p:nvPr/>
          </p:nvSpPr>
          <p:spPr bwMode="auto">
            <a:xfrm>
              <a:off x="3937609" y="3360167"/>
              <a:ext cx="24686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0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05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90" name="ZoneTexte 9"/>
          <p:cNvSpPr txBox="1">
            <a:spLocks noChangeArrowheads="1"/>
          </p:cNvSpPr>
          <p:nvPr/>
        </p:nvSpPr>
        <p:spPr bwMode="auto">
          <a:xfrm>
            <a:off x="687641" y="2471744"/>
            <a:ext cx="251806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1000" b="1" dirty="0">
                <a:latin typeface="Arial" pitchFamily="34" charset="0"/>
                <a:cs typeface="Arial" pitchFamily="34" charset="0"/>
              </a:rPr>
              <a:t>PC-1 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(49%)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1" name="ZoneTexte 190"/>
          <p:cNvSpPr txBox="1"/>
          <p:nvPr/>
        </p:nvSpPr>
        <p:spPr bwMode="auto">
          <a:xfrm>
            <a:off x="158640" y="812024"/>
            <a:ext cx="338554" cy="1505282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000" b="1" dirty="0">
                <a:latin typeface="Arial" pitchFamily="34" charset="0"/>
                <a:cs typeface="Arial" pitchFamily="34" charset="0"/>
              </a:rPr>
              <a:t>PC-2 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(25%)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92" name="组合 3"/>
          <p:cNvGrpSpPr/>
          <p:nvPr/>
        </p:nvGrpSpPr>
        <p:grpSpPr>
          <a:xfrm>
            <a:off x="316929" y="687874"/>
            <a:ext cx="424039" cy="1727002"/>
            <a:chOff x="317181" y="786332"/>
            <a:chExt cx="424039" cy="1727002"/>
          </a:xfrm>
        </p:grpSpPr>
        <p:sp>
          <p:nvSpPr>
            <p:cNvPr id="193" name="ZoneTexte 9"/>
            <p:cNvSpPr txBox="1">
              <a:spLocks noChangeArrowheads="1"/>
            </p:cNvSpPr>
            <p:nvPr/>
          </p:nvSpPr>
          <p:spPr bwMode="auto">
            <a:xfrm>
              <a:off x="337355" y="786332"/>
              <a:ext cx="403865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0.6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4" name="ZoneTexte 10"/>
            <p:cNvSpPr txBox="1">
              <a:spLocks noChangeArrowheads="1"/>
            </p:cNvSpPr>
            <p:nvPr/>
          </p:nvSpPr>
          <p:spPr bwMode="auto">
            <a:xfrm>
              <a:off x="484259" y="1440034"/>
              <a:ext cx="211745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>
                  <a:latin typeface="Arial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195" name="ZoneTexte 11"/>
            <p:cNvSpPr txBox="1">
              <a:spLocks noChangeArrowheads="1"/>
            </p:cNvSpPr>
            <p:nvPr/>
          </p:nvSpPr>
          <p:spPr bwMode="auto">
            <a:xfrm>
              <a:off x="317181" y="2267113"/>
              <a:ext cx="403838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-0.8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96" name="组合 13"/>
          <p:cNvGrpSpPr/>
          <p:nvPr/>
        </p:nvGrpSpPr>
        <p:grpSpPr>
          <a:xfrm>
            <a:off x="487569" y="2313899"/>
            <a:ext cx="2991416" cy="256207"/>
            <a:chOff x="69979" y="2844267"/>
            <a:chExt cx="2991416" cy="256207"/>
          </a:xfrm>
        </p:grpSpPr>
        <p:sp>
          <p:nvSpPr>
            <p:cNvPr id="197" name="ZoneTexte 3"/>
            <p:cNvSpPr txBox="1">
              <a:spLocks noChangeArrowheads="1"/>
            </p:cNvSpPr>
            <p:nvPr/>
          </p:nvSpPr>
          <p:spPr bwMode="auto">
            <a:xfrm>
              <a:off x="1600757" y="2846558"/>
              <a:ext cx="158915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>
                  <a:latin typeface="Arial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198" name="ZoneTexte 12"/>
            <p:cNvSpPr txBox="1">
              <a:spLocks noChangeArrowheads="1"/>
            </p:cNvSpPr>
            <p:nvPr/>
          </p:nvSpPr>
          <p:spPr bwMode="auto">
            <a:xfrm>
              <a:off x="2523752" y="2846558"/>
              <a:ext cx="537643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0.8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9" name="ZoneTexte 198"/>
            <p:cNvSpPr txBox="1">
              <a:spLocks noChangeArrowheads="1"/>
            </p:cNvSpPr>
            <p:nvPr/>
          </p:nvSpPr>
          <p:spPr bwMode="auto">
            <a:xfrm>
              <a:off x="69979" y="2844267"/>
              <a:ext cx="43404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-1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00" name="ZoneTexte 19"/>
          <p:cNvSpPr txBox="1">
            <a:spLocks noChangeArrowheads="1"/>
          </p:cNvSpPr>
          <p:nvPr/>
        </p:nvSpPr>
        <p:spPr bwMode="auto">
          <a:xfrm>
            <a:off x="-3285" y="317951"/>
            <a:ext cx="32385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sz="2000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grpSp>
        <p:nvGrpSpPr>
          <p:cNvPr id="201" name="Groupe 200"/>
          <p:cNvGrpSpPr/>
          <p:nvPr/>
        </p:nvGrpSpPr>
        <p:grpSpPr>
          <a:xfrm>
            <a:off x="1141699" y="524862"/>
            <a:ext cx="5093965" cy="253536"/>
            <a:chOff x="1141699" y="386423"/>
            <a:chExt cx="5093965" cy="253536"/>
          </a:xfrm>
        </p:grpSpPr>
        <p:grpSp>
          <p:nvGrpSpPr>
            <p:cNvPr id="202" name="Groupe 201"/>
            <p:cNvGrpSpPr/>
            <p:nvPr/>
          </p:nvGrpSpPr>
          <p:grpSpPr>
            <a:xfrm>
              <a:off x="4417884" y="436247"/>
              <a:ext cx="1817780" cy="153888"/>
              <a:chOff x="4078001" y="414539"/>
              <a:chExt cx="1817780" cy="153888"/>
            </a:xfrm>
          </p:grpSpPr>
          <p:grpSp>
            <p:nvGrpSpPr>
              <p:cNvPr id="210" name="组合 40"/>
              <p:cNvGrpSpPr/>
              <p:nvPr/>
            </p:nvGrpSpPr>
            <p:grpSpPr>
              <a:xfrm>
                <a:off x="4078001" y="414539"/>
                <a:ext cx="889994" cy="153888"/>
                <a:chOff x="2782839" y="194450"/>
                <a:chExt cx="889994" cy="153888"/>
              </a:xfrm>
            </p:grpSpPr>
            <p:sp>
              <p:nvSpPr>
                <p:cNvPr id="214" name="Rectangle 9"/>
                <p:cNvSpPr>
                  <a:spLocks noChangeArrowheads="1"/>
                </p:cNvSpPr>
                <p:nvPr/>
              </p:nvSpPr>
              <p:spPr bwMode="auto">
                <a:xfrm>
                  <a:off x="3111782" y="194450"/>
                  <a:ext cx="561051" cy="1538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1000" b="1" dirty="0">
                      <a:solidFill>
                        <a:srgbClr val="000000"/>
                      </a:solidFill>
                      <a:latin typeface="Arial" pitchFamily="34" charset="0"/>
                      <a:cs typeface="Arial" pitchFamily="34" charset="0"/>
                    </a:rPr>
                    <a:t>Cirrhosis</a:t>
                  </a:r>
                  <a:endParaRPr lang="en-US" sz="14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15" name="Line 10"/>
                <p:cNvSpPr>
                  <a:spLocks noChangeShapeType="1"/>
                </p:cNvSpPr>
                <p:nvPr/>
              </p:nvSpPr>
              <p:spPr bwMode="auto">
                <a:xfrm>
                  <a:off x="2782839" y="271394"/>
                  <a:ext cx="274321" cy="0"/>
                </a:xfrm>
                <a:prstGeom prst="line">
                  <a:avLst/>
                </a:prstGeom>
                <a:noFill/>
                <a:ln w="19050">
                  <a:solidFill>
                    <a:srgbClr val="0000FF"/>
                  </a:solidFill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</p:grpSp>
          <p:grpSp>
            <p:nvGrpSpPr>
              <p:cNvPr id="211" name="组合 31"/>
              <p:cNvGrpSpPr/>
              <p:nvPr/>
            </p:nvGrpSpPr>
            <p:grpSpPr>
              <a:xfrm>
                <a:off x="5231185" y="414539"/>
                <a:ext cx="664596" cy="153888"/>
                <a:chOff x="2485964" y="354055"/>
                <a:chExt cx="664596" cy="153888"/>
              </a:xfrm>
            </p:grpSpPr>
            <p:sp>
              <p:nvSpPr>
                <p:cNvPr id="212" name="Rectangle 13"/>
                <p:cNvSpPr>
                  <a:spLocks noChangeArrowheads="1"/>
                </p:cNvSpPr>
                <p:nvPr/>
              </p:nvSpPr>
              <p:spPr bwMode="auto">
                <a:xfrm>
                  <a:off x="2814908" y="354055"/>
                  <a:ext cx="335652" cy="1538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 lIns="0" tIns="0" rIns="0" bIns="0">
                  <a:spAutoFit/>
                </a:bodyPr>
                <a:lstStyle/>
                <a:p>
                  <a:r>
                    <a:rPr lang="en-US" sz="1000" b="1" dirty="0" smtClean="0">
                      <a:latin typeface="Arial" pitchFamily="34" charset="0"/>
                      <a:cs typeface="Arial" pitchFamily="34" charset="0"/>
                    </a:rPr>
                    <a:t>HCC</a:t>
                  </a:r>
                  <a:endParaRPr lang="en-US" sz="10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13" name="Line 14"/>
                <p:cNvSpPr>
                  <a:spLocks noChangeShapeType="1"/>
                </p:cNvSpPr>
                <p:nvPr/>
              </p:nvSpPr>
              <p:spPr bwMode="auto">
                <a:xfrm>
                  <a:off x="2485964" y="430999"/>
                  <a:ext cx="274320" cy="0"/>
                </a:xfrm>
                <a:prstGeom prst="line">
                  <a:avLst/>
                </a:prstGeom>
                <a:noFill/>
                <a:ln w="19050" cmpd="sng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</p:grpSp>
        </p:grpSp>
        <p:grpSp>
          <p:nvGrpSpPr>
            <p:cNvPr id="203" name="Groupe 202"/>
            <p:cNvGrpSpPr/>
            <p:nvPr/>
          </p:nvGrpSpPr>
          <p:grpSpPr>
            <a:xfrm>
              <a:off x="1141699" y="386423"/>
              <a:ext cx="1799643" cy="253536"/>
              <a:chOff x="1093059" y="368373"/>
              <a:chExt cx="1799643" cy="253536"/>
            </a:xfrm>
          </p:grpSpPr>
          <p:grpSp>
            <p:nvGrpSpPr>
              <p:cNvPr id="204" name="组合 12"/>
              <p:cNvGrpSpPr/>
              <p:nvPr/>
            </p:nvGrpSpPr>
            <p:grpSpPr>
              <a:xfrm>
                <a:off x="1093059" y="368373"/>
                <a:ext cx="900748" cy="246221"/>
                <a:chOff x="770172" y="59947"/>
                <a:chExt cx="900748" cy="246221"/>
              </a:xfrm>
            </p:grpSpPr>
            <p:sp>
              <p:nvSpPr>
                <p:cNvPr id="208" name="ZoneTexte 10208"/>
                <p:cNvSpPr txBox="1">
                  <a:spLocks noChangeArrowheads="1"/>
                </p:cNvSpPr>
                <p:nvPr/>
              </p:nvSpPr>
              <p:spPr bwMode="auto">
                <a:xfrm>
                  <a:off x="843084" y="59947"/>
                  <a:ext cx="827836" cy="24622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sz="1000" b="1" dirty="0">
                      <a:latin typeface="Arial" pitchFamily="34" charset="0"/>
                      <a:cs typeface="Arial" pitchFamily="34" charset="0"/>
                    </a:rPr>
                    <a:t>Cirrhosis</a:t>
                  </a:r>
                </a:p>
              </p:txBody>
            </p:sp>
            <p:sp>
              <p:nvSpPr>
                <p:cNvPr id="209" name="Oval 12"/>
                <p:cNvSpPr>
                  <a:spLocks noChangeArrowheads="1"/>
                </p:cNvSpPr>
                <p:nvPr/>
              </p:nvSpPr>
              <p:spPr bwMode="auto">
                <a:xfrm>
                  <a:off x="770172" y="134980"/>
                  <a:ext cx="91440" cy="91440"/>
                </a:xfrm>
                <a:prstGeom prst="ellipse">
                  <a:avLst/>
                </a:prstGeom>
                <a:solidFill>
                  <a:srgbClr val="0000FF"/>
                </a:solidFill>
                <a:ln w="0">
                  <a:solidFill>
                    <a:srgbClr val="0000FF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>
                    <a:ln>
                      <a:solidFill>
                        <a:srgbClr val="0000FF"/>
                      </a:solidFill>
                    </a:ln>
                    <a:solidFill>
                      <a:srgbClr val="0000FF"/>
                    </a:solidFill>
                    <a:latin typeface="Calibri" pitchFamily="34" charset="0"/>
                  </a:endParaRPr>
                </a:p>
              </p:txBody>
            </p:sp>
          </p:grpSp>
          <p:grpSp>
            <p:nvGrpSpPr>
              <p:cNvPr id="205" name="组合 21"/>
              <p:cNvGrpSpPr/>
              <p:nvPr/>
            </p:nvGrpSpPr>
            <p:grpSpPr>
              <a:xfrm>
                <a:off x="2260527" y="375688"/>
                <a:ext cx="632175" cy="246221"/>
                <a:chOff x="847996" y="240093"/>
                <a:chExt cx="632175" cy="246221"/>
              </a:xfrm>
            </p:grpSpPr>
            <p:sp>
              <p:nvSpPr>
                <p:cNvPr id="206" name="ZoneTexte 10210"/>
                <p:cNvSpPr txBox="1">
                  <a:spLocks noChangeArrowheads="1"/>
                </p:cNvSpPr>
                <p:nvPr/>
              </p:nvSpPr>
              <p:spPr bwMode="auto">
                <a:xfrm>
                  <a:off x="920907" y="240093"/>
                  <a:ext cx="559264" cy="24622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fontAlgn="ctr"/>
                  <a:r>
                    <a:rPr lang="en-US" sz="1000" b="1" dirty="0" smtClean="0">
                      <a:latin typeface="Arial" pitchFamily="34" charset="0"/>
                      <a:cs typeface="Arial" pitchFamily="34" charset="0"/>
                    </a:rPr>
                    <a:t>HCC</a:t>
                  </a:r>
                  <a:endParaRPr lang="en-US" sz="10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07" name="Oval 12"/>
                <p:cNvSpPr>
                  <a:spLocks noChangeArrowheads="1"/>
                </p:cNvSpPr>
                <p:nvPr/>
              </p:nvSpPr>
              <p:spPr bwMode="auto">
                <a:xfrm>
                  <a:off x="847996" y="310168"/>
                  <a:ext cx="91440" cy="91440"/>
                </a:xfrm>
                <a:prstGeom prst="ellipse">
                  <a:avLst/>
                </a:prstGeom>
                <a:solidFill>
                  <a:srgbClr val="FF0000"/>
                </a:solidFill>
                <a:ln w="0">
                  <a:solidFill>
                    <a:srgbClr val="C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>
                    <a:latin typeface="Calibri" pitchFamily="34" charset="0"/>
                  </a:endParaRPr>
                </a:p>
              </p:txBody>
            </p:sp>
          </p:grpSp>
        </p:grpSp>
      </p:grpSp>
      <p:grpSp>
        <p:nvGrpSpPr>
          <p:cNvPr id="216" name="组合 17"/>
          <p:cNvGrpSpPr/>
          <p:nvPr/>
        </p:nvGrpSpPr>
        <p:grpSpPr>
          <a:xfrm>
            <a:off x="296401" y="2915135"/>
            <a:ext cx="462603" cy="1725627"/>
            <a:chOff x="423394" y="3527147"/>
            <a:chExt cx="462603" cy="1725627"/>
          </a:xfrm>
        </p:grpSpPr>
        <p:sp>
          <p:nvSpPr>
            <p:cNvPr id="217" name="ZoneTexte 9"/>
            <p:cNvSpPr txBox="1">
              <a:spLocks noChangeArrowheads="1"/>
            </p:cNvSpPr>
            <p:nvPr/>
          </p:nvSpPr>
          <p:spPr bwMode="auto">
            <a:xfrm>
              <a:off x="435317" y="3527147"/>
              <a:ext cx="45068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0.3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8" name="ZoneTexte 10"/>
            <p:cNvSpPr txBox="1">
              <a:spLocks noChangeArrowheads="1"/>
            </p:cNvSpPr>
            <p:nvPr/>
          </p:nvSpPr>
          <p:spPr bwMode="auto">
            <a:xfrm>
              <a:off x="607205" y="4286008"/>
              <a:ext cx="211745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>
                  <a:latin typeface="Arial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219" name="ZoneTexte 11"/>
            <p:cNvSpPr txBox="1">
              <a:spLocks noChangeArrowheads="1"/>
            </p:cNvSpPr>
            <p:nvPr/>
          </p:nvSpPr>
          <p:spPr bwMode="auto">
            <a:xfrm>
              <a:off x="423394" y="5006553"/>
              <a:ext cx="43404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-0.3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20" name="Groupe 219"/>
          <p:cNvGrpSpPr/>
          <p:nvPr/>
        </p:nvGrpSpPr>
        <p:grpSpPr>
          <a:xfrm>
            <a:off x="4081885" y="1019723"/>
            <a:ext cx="2496312" cy="1280160"/>
            <a:chOff x="4229100" y="985838"/>
            <a:chExt cx="1966912" cy="1381125"/>
          </a:xfrm>
        </p:grpSpPr>
        <p:sp>
          <p:nvSpPr>
            <p:cNvPr id="221" name="Freeform 26"/>
            <p:cNvSpPr>
              <a:spLocks/>
            </p:cNvSpPr>
            <p:nvPr/>
          </p:nvSpPr>
          <p:spPr bwMode="auto">
            <a:xfrm>
              <a:off x="4229100" y="1150938"/>
              <a:ext cx="1966912" cy="1216025"/>
            </a:xfrm>
            <a:custGeom>
              <a:avLst/>
              <a:gdLst/>
              <a:ahLst/>
              <a:cxnLst>
                <a:cxn ang="0">
                  <a:pos x="0" y="766"/>
                </a:cxn>
                <a:cxn ang="0">
                  <a:pos x="20" y="729"/>
                </a:cxn>
                <a:cxn ang="0">
                  <a:pos x="40" y="672"/>
                </a:cxn>
                <a:cxn ang="0">
                  <a:pos x="60" y="580"/>
                </a:cxn>
                <a:cxn ang="0">
                  <a:pos x="80" y="451"/>
                </a:cxn>
                <a:cxn ang="0">
                  <a:pos x="100" y="317"/>
                </a:cxn>
                <a:cxn ang="0">
                  <a:pos x="120" y="225"/>
                </a:cxn>
                <a:cxn ang="0">
                  <a:pos x="140" y="185"/>
                </a:cxn>
                <a:cxn ang="0">
                  <a:pos x="160" y="164"/>
                </a:cxn>
                <a:cxn ang="0">
                  <a:pos x="180" y="138"/>
                </a:cxn>
                <a:cxn ang="0">
                  <a:pos x="200" y="97"/>
                </a:cxn>
                <a:cxn ang="0">
                  <a:pos x="220" y="55"/>
                </a:cxn>
                <a:cxn ang="0">
                  <a:pos x="240" y="14"/>
                </a:cxn>
                <a:cxn ang="0">
                  <a:pos x="260" y="0"/>
                </a:cxn>
                <a:cxn ang="0">
                  <a:pos x="280" y="24"/>
                </a:cxn>
                <a:cxn ang="0">
                  <a:pos x="300" y="61"/>
                </a:cxn>
                <a:cxn ang="0">
                  <a:pos x="320" y="97"/>
                </a:cxn>
                <a:cxn ang="0">
                  <a:pos x="340" y="121"/>
                </a:cxn>
                <a:cxn ang="0">
                  <a:pos x="359" y="146"/>
                </a:cxn>
                <a:cxn ang="0">
                  <a:pos x="380" y="185"/>
                </a:cxn>
                <a:cxn ang="0">
                  <a:pos x="400" y="231"/>
                </a:cxn>
                <a:cxn ang="0">
                  <a:pos x="420" y="277"/>
                </a:cxn>
                <a:cxn ang="0">
                  <a:pos x="440" y="329"/>
                </a:cxn>
                <a:cxn ang="0">
                  <a:pos x="460" y="378"/>
                </a:cxn>
                <a:cxn ang="0">
                  <a:pos x="480" y="423"/>
                </a:cxn>
                <a:cxn ang="0">
                  <a:pos x="499" y="464"/>
                </a:cxn>
                <a:cxn ang="0">
                  <a:pos x="520" y="488"/>
                </a:cxn>
                <a:cxn ang="0">
                  <a:pos x="540" y="488"/>
                </a:cxn>
                <a:cxn ang="0">
                  <a:pos x="560" y="469"/>
                </a:cxn>
                <a:cxn ang="0">
                  <a:pos x="580" y="436"/>
                </a:cxn>
                <a:cxn ang="0">
                  <a:pos x="600" y="399"/>
                </a:cxn>
                <a:cxn ang="0">
                  <a:pos x="619" y="364"/>
                </a:cxn>
                <a:cxn ang="0">
                  <a:pos x="639" y="330"/>
                </a:cxn>
                <a:cxn ang="0">
                  <a:pos x="660" y="295"/>
                </a:cxn>
                <a:cxn ang="0">
                  <a:pos x="680" y="274"/>
                </a:cxn>
                <a:cxn ang="0">
                  <a:pos x="699" y="260"/>
                </a:cxn>
                <a:cxn ang="0">
                  <a:pos x="720" y="228"/>
                </a:cxn>
                <a:cxn ang="0">
                  <a:pos x="740" y="187"/>
                </a:cxn>
                <a:cxn ang="0">
                  <a:pos x="759" y="148"/>
                </a:cxn>
                <a:cxn ang="0">
                  <a:pos x="779" y="111"/>
                </a:cxn>
                <a:cxn ang="0">
                  <a:pos x="800" y="80"/>
                </a:cxn>
                <a:cxn ang="0">
                  <a:pos x="820" y="61"/>
                </a:cxn>
                <a:cxn ang="0">
                  <a:pos x="839" y="48"/>
                </a:cxn>
                <a:cxn ang="0">
                  <a:pos x="860" y="43"/>
                </a:cxn>
                <a:cxn ang="0">
                  <a:pos x="880" y="54"/>
                </a:cxn>
                <a:cxn ang="0">
                  <a:pos x="899" y="69"/>
                </a:cxn>
                <a:cxn ang="0">
                  <a:pos x="919" y="79"/>
                </a:cxn>
                <a:cxn ang="0">
                  <a:pos x="940" y="105"/>
                </a:cxn>
                <a:cxn ang="0">
                  <a:pos x="960" y="145"/>
                </a:cxn>
                <a:cxn ang="0">
                  <a:pos x="979" y="190"/>
                </a:cxn>
                <a:cxn ang="0">
                  <a:pos x="999" y="245"/>
                </a:cxn>
                <a:cxn ang="0">
                  <a:pos x="1019" y="298"/>
                </a:cxn>
                <a:cxn ang="0">
                  <a:pos x="1039" y="350"/>
                </a:cxn>
                <a:cxn ang="0">
                  <a:pos x="1059" y="405"/>
                </a:cxn>
                <a:cxn ang="0">
                  <a:pos x="1080" y="465"/>
                </a:cxn>
                <a:cxn ang="0">
                  <a:pos x="1099" y="505"/>
                </a:cxn>
                <a:cxn ang="0">
                  <a:pos x="1119" y="529"/>
                </a:cxn>
                <a:cxn ang="0">
                  <a:pos x="1139" y="557"/>
                </a:cxn>
                <a:cxn ang="0">
                  <a:pos x="1159" y="597"/>
                </a:cxn>
                <a:cxn ang="0">
                  <a:pos x="1179" y="643"/>
                </a:cxn>
                <a:cxn ang="0">
                  <a:pos x="1199" y="692"/>
                </a:cxn>
                <a:cxn ang="0">
                  <a:pos x="1220" y="722"/>
                </a:cxn>
                <a:cxn ang="0">
                  <a:pos x="1239" y="744"/>
                </a:cxn>
              </a:cxnLst>
              <a:rect l="0" t="0" r="r" b="b"/>
              <a:pathLst>
                <a:path w="1239" h="766">
                  <a:moveTo>
                    <a:pt x="0" y="766"/>
                  </a:moveTo>
                  <a:lnTo>
                    <a:pt x="20" y="729"/>
                  </a:lnTo>
                  <a:lnTo>
                    <a:pt x="40" y="672"/>
                  </a:lnTo>
                  <a:lnTo>
                    <a:pt x="60" y="580"/>
                  </a:lnTo>
                  <a:lnTo>
                    <a:pt x="80" y="451"/>
                  </a:lnTo>
                  <a:lnTo>
                    <a:pt x="100" y="317"/>
                  </a:lnTo>
                  <a:lnTo>
                    <a:pt x="120" y="225"/>
                  </a:lnTo>
                  <a:lnTo>
                    <a:pt x="140" y="185"/>
                  </a:lnTo>
                  <a:lnTo>
                    <a:pt x="160" y="164"/>
                  </a:lnTo>
                  <a:lnTo>
                    <a:pt x="180" y="138"/>
                  </a:lnTo>
                  <a:lnTo>
                    <a:pt x="200" y="97"/>
                  </a:lnTo>
                  <a:lnTo>
                    <a:pt x="220" y="55"/>
                  </a:lnTo>
                  <a:lnTo>
                    <a:pt x="240" y="14"/>
                  </a:lnTo>
                  <a:lnTo>
                    <a:pt x="260" y="0"/>
                  </a:lnTo>
                  <a:lnTo>
                    <a:pt x="280" y="24"/>
                  </a:lnTo>
                  <a:lnTo>
                    <a:pt x="300" y="61"/>
                  </a:lnTo>
                  <a:lnTo>
                    <a:pt x="320" y="97"/>
                  </a:lnTo>
                  <a:lnTo>
                    <a:pt x="340" y="121"/>
                  </a:lnTo>
                  <a:lnTo>
                    <a:pt x="359" y="146"/>
                  </a:lnTo>
                  <a:lnTo>
                    <a:pt x="380" y="185"/>
                  </a:lnTo>
                  <a:lnTo>
                    <a:pt x="400" y="231"/>
                  </a:lnTo>
                  <a:lnTo>
                    <a:pt x="420" y="277"/>
                  </a:lnTo>
                  <a:lnTo>
                    <a:pt x="440" y="329"/>
                  </a:lnTo>
                  <a:lnTo>
                    <a:pt x="460" y="378"/>
                  </a:lnTo>
                  <a:lnTo>
                    <a:pt x="480" y="423"/>
                  </a:lnTo>
                  <a:lnTo>
                    <a:pt x="499" y="464"/>
                  </a:lnTo>
                  <a:lnTo>
                    <a:pt x="520" y="488"/>
                  </a:lnTo>
                  <a:lnTo>
                    <a:pt x="540" y="488"/>
                  </a:lnTo>
                  <a:lnTo>
                    <a:pt x="560" y="469"/>
                  </a:lnTo>
                  <a:lnTo>
                    <a:pt x="580" y="436"/>
                  </a:lnTo>
                  <a:lnTo>
                    <a:pt x="600" y="399"/>
                  </a:lnTo>
                  <a:lnTo>
                    <a:pt x="619" y="364"/>
                  </a:lnTo>
                  <a:lnTo>
                    <a:pt x="639" y="330"/>
                  </a:lnTo>
                  <a:lnTo>
                    <a:pt x="660" y="295"/>
                  </a:lnTo>
                  <a:lnTo>
                    <a:pt x="680" y="274"/>
                  </a:lnTo>
                  <a:lnTo>
                    <a:pt x="699" y="260"/>
                  </a:lnTo>
                  <a:lnTo>
                    <a:pt x="720" y="228"/>
                  </a:lnTo>
                  <a:lnTo>
                    <a:pt x="740" y="187"/>
                  </a:lnTo>
                  <a:lnTo>
                    <a:pt x="759" y="148"/>
                  </a:lnTo>
                  <a:lnTo>
                    <a:pt x="779" y="111"/>
                  </a:lnTo>
                  <a:lnTo>
                    <a:pt x="800" y="80"/>
                  </a:lnTo>
                  <a:lnTo>
                    <a:pt x="820" y="61"/>
                  </a:lnTo>
                  <a:lnTo>
                    <a:pt x="839" y="48"/>
                  </a:lnTo>
                  <a:lnTo>
                    <a:pt x="860" y="43"/>
                  </a:lnTo>
                  <a:lnTo>
                    <a:pt x="880" y="54"/>
                  </a:lnTo>
                  <a:lnTo>
                    <a:pt x="899" y="69"/>
                  </a:lnTo>
                  <a:lnTo>
                    <a:pt x="919" y="79"/>
                  </a:lnTo>
                  <a:lnTo>
                    <a:pt x="940" y="105"/>
                  </a:lnTo>
                  <a:lnTo>
                    <a:pt x="960" y="145"/>
                  </a:lnTo>
                  <a:lnTo>
                    <a:pt x="979" y="190"/>
                  </a:lnTo>
                  <a:lnTo>
                    <a:pt x="999" y="245"/>
                  </a:lnTo>
                  <a:lnTo>
                    <a:pt x="1019" y="298"/>
                  </a:lnTo>
                  <a:lnTo>
                    <a:pt x="1039" y="350"/>
                  </a:lnTo>
                  <a:lnTo>
                    <a:pt x="1059" y="405"/>
                  </a:lnTo>
                  <a:lnTo>
                    <a:pt x="1080" y="465"/>
                  </a:lnTo>
                  <a:lnTo>
                    <a:pt x="1099" y="505"/>
                  </a:lnTo>
                  <a:lnTo>
                    <a:pt x="1119" y="529"/>
                  </a:lnTo>
                  <a:lnTo>
                    <a:pt x="1139" y="557"/>
                  </a:lnTo>
                  <a:lnTo>
                    <a:pt x="1159" y="597"/>
                  </a:lnTo>
                  <a:lnTo>
                    <a:pt x="1179" y="643"/>
                  </a:lnTo>
                  <a:lnTo>
                    <a:pt x="1199" y="692"/>
                  </a:lnTo>
                  <a:lnTo>
                    <a:pt x="1220" y="722"/>
                  </a:lnTo>
                  <a:lnTo>
                    <a:pt x="1239" y="744"/>
                  </a:lnTo>
                </a:path>
              </a:pathLst>
            </a:custGeom>
            <a:noFill/>
            <a:ln w="19050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2" name="Freeform 27"/>
            <p:cNvSpPr>
              <a:spLocks/>
            </p:cNvSpPr>
            <p:nvPr/>
          </p:nvSpPr>
          <p:spPr bwMode="auto">
            <a:xfrm>
              <a:off x="4229100" y="985838"/>
              <a:ext cx="1966912" cy="1381125"/>
            </a:xfrm>
            <a:custGeom>
              <a:avLst/>
              <a:gdLst/>
              <a:ahLst/>
              <a:cxnLst>
                <a:cxn ang="0">
                  <a:pos x="0" y="870"/>
                </a:cxn>
                <a:cxn ang="0">
                  <a:pos x="20" y="836"/>
                </a:cxn>
                <a:cxn ang="0">
                  <a:pos x="40" y="770"/>
                </a:cxn>
                <a:cxn ang="0">
                  <a:pos x="60" y="676"/>
                </a:cxn>
                <a:cxn ang="0">
                  <a:pos x="80" y="562"/>
                </a:cxn>
                <a:cxn ang="0">
                  <a:pos x="100" y="454"/>
                </a:cxn>
                <a:cxn ang="0">
                  <a:pos x="120" y="387"/>
                </a:cxn>
                <a:cxn ang="0">
                  <a:pos x="140" y="366"/>
                </a:cxn>
                <a:cxn ang="0">
                  <a:pos x="160" y="353"/>
                </a:cxn>
                <a:cxn ang="0">
                  <a:pos x="180" y="327"/>
                </a:cxn>
                <a:cxn ang="0">
                  <a:pos x="200" y="279"/>
                </a:cxn>
                <a:cxn ang="0">
                  <a:pos x="220" y="214"/>
                </a:cxn>
                <a:cxn ang="0">
                  <a:pos x="240" y="170"/>
                </a:cxn>
                <a:cxn ang="0">
                  <a:pos x="260" y="171"/>
                </a:cxn>
                <a:cxn ang="0">
                  <a:pos x="280" y="198"/>
                </a:cxn>
                <a:cxn ang="0">
                  <a:pos x="300" y="229"/>
                </a:cxn>
                <a:cxn ang="0">
                  <a:pos x="320" y="258"/>
                </a:cxn>
                <a:cxn ang="0">
                  <a:pos x="340" y="289"/>
                </a:cxn>
                <a:cxn ang="0">
                  <a:pos x="359" y="320"/>
                </a:cxn>
                <a:cxn ang="0">
                  <a:pos x="380" y="358"/>
                </a:cxn>
                <a:cxn ang="0">
                  <a:pos x="400" y="403"/>
                </a:cxn>
                <a:cxn ang="0">
                  <a:pos x="420" y="451"/>
                </a:cxn>
                <a:cxn ang="0">
                  <a:pos x="440" y="510"/>
                </a:cxn>
                <a:cxn ang="0">
                  <a:pos x="460" y="582"/>
                </a:cxn>
                <a:cxn ang="0">
                  <a:pos x="480" y="647"/>
                </a:cxn>
                <a:cxn ang="0">
                  <a:pos x="499" y="695"/>
                </a:cxn>
                <a:cxn ang="0">
                  <a:pos x="520" y="721"/>
                </a:cxn>
                <a:cxn ang="0">
                  <a:pos x="540" y="722"/>
                </a:cxn>
                <a:cxn ang="0">
                  <a:pos x="560" y="707"/>
                </a:cxn>
                <a:cxn ang="0">
                  <a:pos x="580" y="677"/>
                </a:cxn>
                <a:cxn ang="0">
                  <a:pos x="600" y="632"/>
                </a:cxn>
                <a:cxn ang="0">
                  <a:pos x="619" y="582"/>
                </a:cxn>
                <a:cxn ang="0">
                  <a:pos x="639" y="542"/>
                </a:cxn>
                <a:cxn ang="0">
                  <a:pos x="660" y="509"/>
                </a:cxn>
                <a:cxn ang="0">
                  <a:pos x="680" y="475"/>
                </a:cxn>
                <a:cxn ang="0">
                  <a:pos x="699" y="431"/>
                </a:cxn>
                <a:cxn ang="0">
                  <a:pos x="720" y="378"/>
                </a:cxn>
                <a:cxn ang="0">
                  <a:pos x="740" y="315"/>
                </a:cxn>
                <a:cxn ang="0">
                  <a:pos x="759" y="248"/>
                </a:cxn>
                <a:cxn ang="0">
                  <a:pos x="779" y="179"/>
                </a:cxn>
                <a:cxn ang="0">
                  <a:pos x="800" y="119"/>
                </a:cxn>
                <a:cxn ang="0">
                  <a:pos x="820" y="70"/>
                </a:cxn>
                <a:cxn ang="0">
                  <a:pos x="839" y="33"/>
                </a:cxn>
                <a:cxn ang="0">
                  <a:pos x="860" y="8"/>
                </a:cxn>
                <a:cxn ang="0">
                  <a:pos x="880" y="0"/>
                </a:cxn>
                <a:cxn ang="0">
                  <a:pos x="899" y="5"/>
                </a:cxn>
                <a:cxn ang="0">
                  <a:pos x="919" y="21"/>
                </a:cxn>
                <a:cxn ang="0">
                  <a:pos x="940" y="47"/>
                </a:cxn>
                <a:cxn ang="0">
                  <a:pos x="960" y="89"/>
                </a:cxn>
                <a:cxn ang="0">
                  <a:pos x="979" y="158"/>
                </a:cxn>
                <a:cxn ang="0">
                  <a:pos x="999" y="244"/>
                </a:cxn>
                <a:cxn ang="0">
                  <a:pos x="1019" y="325"/>
                </a:cxn>
                <a:cxn ang="0">
                  <a:pos x="1039" y="395"/>
                </a:cxn>
                <a:cxn ang="0">
                  <a:pos x="1059" y="467"/>
                </a:cxn>
                <a:cxn ang="0">
                  <a:pos x="1080" y="541"/>
                </a:cxn>
                <a:cxn ang="0">
                  <a:pos x="1099" y="599"/>
                </a:cxn>
                <a:cxn ang="0">
                  <a:pos x="1119" y="636"/>
                </a:cxn>
                <a:cxn ang="0">
                  <a:pos x="1139" y="660"/>
                </a:cxn>
                <a:cxn ang="0">
                  <a:pos x="1159" y="703"/>
                </a:cxn>
                <a:cxn ang="0">
                  <a:pos x="1179" y="759"/>
                </a:cxn>
                <a:cxn ang="0">
                  <a:pos x="1199" y="812"/>
                </a:cxn>
                <a:cxn ang="0">
                  <a:pos x="1220" y="849"/>
                </a:cxn>
                <a:cxn ang="0">
                  <a:pos x="1239" y="864"/>
                </a:cxn>
              </a:cxnLst>
              <a:rect l="0" t="0" r="r" b="b"/>
              <a:pathLst>
                <a:path w="1239" h="870">
                  <a:moveTo>
                    <a:pt x="0" y="870"/>
                  </a:moveTo>
                  <a:lnTo>
                    <a:pt x="20" y="836"/>
                  </a:lnTo>
                  <a:lnTo>
                    <a:pt x="40" y="770"/>
                  </a:lnTo>
                  <a:lnTo>
                    <a:pt x="60" y="676"/>
                  </a:lnTo>
                  <a:lnTo>
                    <a:pt x="80" y="562"/>
                  </a:lnTo>
                  <a:lnTo>
                    <a:pt x="100" y="454"/>
                  </a:lnTo>
                  <a:lnTo>
                    <a:pt x="120" y="387"/>
                  </a:lnTo>
                  <a:lnTo>
                    <a:pt x="140" y="366"/>
                  </a:lnTo>
                  <a:lnTo>
                    <a:pt x="160" y="353"/>
                  </a:lnTo>
                  <a:lnTo>
                    <a:pt x="180" y="327"/>
                  </a:lnTo>
                  <a:lnTo>
                    <a:pt x="200" y="279"/>
                  </a:lnTo>
                  <a:lnTo>
                    <a:pt x="220" y="214"/>
                  </a:lnTo>
                  <a:lnTo>
                    <a:pt x="240" y="170"/>
                  </a:lnTo>
                  <a:lnTo>
                    <a:pt x="260" y="171"/>
                  </a:lnTo>
                  <a:lnTo>
                    <a:pt x="280" y="198"/>
                  </a:lnTo>
                  <a:lnTo>
                    <a:pt x="300" y="229"/>
                  </a:lnTo>
                  <a:lnTo>
                    <a:pt x="320" y="258"/>
                  </a:lnTo>
                  <a:lnTo>
                    <a:pt x="340" y="289"/>
                  </a:lnTo>
                  <a:lnTo>
                    <a:pt x="359" y="320"/>
                  </a:lnTo>
                  <a:lnTo>
                    <a:pt x="380" y="358"/>
                  </a:lnTo>
                  <a:lnTo>
                    <a:pt x="400" y="403"/>
                  </a:lnTo>
                  <a:lnTo>
                    <a:pt x="420" y="451"/>
                  </a:lnTo>
                  <a:lnTo>
                    <a:pt x="440" y="510"/>
                  </a:lnTo>
                  <a:lnTo>
                    <a:pt x="460" y="582"/>
                  </a:lnTo>
                  <a:lnTo>
                    <a:pt x="480" y="647"/>
                  </a:lnTo>
                  <a:lnTo>
                    <a:pt x="499" y="695"/>
                  </a:lnTo>
                  <a:lnTo>
                    <a:pt x="520" y="721"/>
                  </a:lnTo>
                  <a:lnTo>
                    <a:pt x="540" y="722"/>
                  </a:lnTo>
                  <a:lnTo>
                    <a:pt x="560" y="707"/>
                  </a:lnTo>
                  <a:lnTo>
                    <a:pt x="580" y="677"/>
                  </a:lnTo>
                  <a:lnTo>
                    <a:pt x="600" y="632"/>
                  </a:lnTo>
                  <a:lnTo>
                    <a:pt x="619" y="582"/>
                  </a:lnTo>
                  <a:lnTo>
                    <a:pt x="639" y="542"/>
                  </a:lnTo>
                  <a:lnTo>
                    <a:pt x="660" y="509"/>
                  </a:lnTo>
                  <a:lnTo>
                    <a:pt x="680" y="475"/>
                  </a:lnTo>
                  <a:lnTo>
                    <a:pt x="699" y="431"/>
                  </a:lnTo>
                  <a:lnTo>
                    <a:pt x="720" y="378"/>
                  </a:lnTo>
                  <a:lnTo>
                    <a:pt x="740" y="315"/>
                  </a:lnTo>
                  <a:lnTo>
                    <a:pt x="759" y="248"/>
                  </a:lnTo>
                  <a:lnTo>
                    <a:pt x="779" y="179"/>
                  </a:lnTo>
                  <a:lnTo>
                    <a:pt x="800" y="119"/>
                  </a:lnTo>
                  <a:lnTo>
                    <a:pt x="820" y="70"/>
                  </a:lnTo>
                  <a:lnTo>
                    <a:pt x="839" y="33"/>
                  </a:lnTo>
                  <a:lnTo>
                    <a:pt x="860" y="8"/>
                  </a:lnTo>
                  <a:lnTo>
                    <a:pt x="880" y="0"/>
                  </a:lnTo>
                  <a:lnTo>
                    <a:pt x="899" y="5"/>
                  </a:lnTo>
                  <a:lnTo>
                    <a:pt x="919" y="21"/>
                  </a:lnTo>
                  <a:lnTo>
                    <a:pt x="940" y="47"/>
                  </a:lnTo>
                  <a:lnTo>
                    <a:pt x="960" y="89"/>
                  </a:lnTo>
                  <a:lnTo>
                    <a:pt x="979" y="158"/>
                  </a:lnTo>
                  <a:lnTo>
                    <a:pt x="999" y="244"/>
                  </a:lnTo>
                  <a:lnTo>
                    <a:pt x="1019" y="325"/>
                  </a:lnTo>
                  <a:lnTo>
                    <a:pt x="1039" y="395"/>
                  </a:lnTo>
                  <a:lnTo>
                    <a:pt x="1059" y="467"/>
                  </a:lnTo>
                  <a:lnTo>
                    <a:pt x="1080" y="541"/>
                  </a:lnTo>
                  <a:lnTo>
                    <a:pt x="1099" y="599"/>
                  </a:lnTo>
                  <a:lnTo>
                    <a:pt x="1119" y="636"/>
                  </a:lnTo>
                  <a:lnTo>
                    <a:pt x="1139" y="660"/>
                  </a:lnTo>
                  <a:lnTo>
                    <a:pt x="1159" y="703"/>
                  </a:lnTo>
                  <a:lnTo>
                    <a:pt x="1179" y="759"/>
                  </a:lnTo>
                  <a:lnTo>
                    <a:pt x="1199" y="812"/>
                  </a:lnTo>
                  <a:lnTo>
                    <a:pt x="1220" y="849"/>
                  </a:lnTo>
                  <a:lnTo>
                    <a:pt x="1239" y="864"/>
                  </a:lnTo>
                </a:path>
              </a:pathLst>
            </a:custGeom>
            <a:noFill/>
            <a:ln w="19050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</p:grpSp>
      <p:grpSp>
        <p:nvGrpSpPr>
          <p:cNvPr id="226" name="Groupe 225"/>
          <p:cNvGrpSpPr/>
          <p:nvPr/>
        </p:nvGrpSpPr>
        <p:grpSpPr>
          <a:xfrm>
            <a:off x="4076293" y="3072963"/>
            <a:ext cx="2578727" cy="1463040"/>
            <a:chOff x="830263" y="1368425"/>
            <a:chExt cx="2030413" cy="1574800"/>
          </a:xfrm>
        </p:grpSpPr>
        <p:sp>
          <p:nvSpPr>
            <p:cNvPr id="227" name="Freeform 82"/>
            <p:cNvSpPr>
              <a:spLocks/>
            </p:cNvSpPr>
            <p:nvPr/>
          </p:nvSpPr>
          <p:spPr bwMode="auto">
            <a:xfrm>
              <a:off x="830263" y="1473200"/>
              <a:ext cx="2030413" cy="1470025"/>
            </a:xfrm>
            <a:custGeom>
              <a:avLst/>
              <a:gdLst/>
              <a:ahLst/>
              <a:cxnLst>
                <a:cxn ang="0">
                  <a:pos x="0" y="926"/>
                </a:cxn>
                <a:cxn ang="0">
                  <a:pos x="79" y="657"/>
                </a:cxn>
                <a:cxn ang="0">
                  <a:pos x="159" y="281"/>
                </a:cxn>
                <a:cxn ang="0">
                  <a:pos x="240" y="100"/>
                </a:cxn>
                <a:cxn ang="0">
                  <a:pos x="320" y="95"/>
                </a:cxn>
                <a:cxn ang="0">
                  <a:pos x="400" y="227"/>
                </a:cxn>
                <a:cxn ang="0">
                  <a:pos x="479" y="390"/>
                </a:cxn>
                <a:cxn ang="0">
                  <a:pos x="559" y="472"/>
                </a:cxn>
                <a:cxn ang="0">
                  <a:pos x="639" y="366"/>
                </a:cxn>
                <a:cxn ang="0">
                  <a:pos x="719" y="207"/>
                </a:cxn>
                <a:cxn ang="0">
                  <a:pos x="799" y="56"/>
                </a:cxn>
                <a:cxn ang="0">
                  <a:pos x="879" y="0"/>
                </a:cxn>
                <a:cxn ang="0">
                  <a:pos x="959" y="134"/>
                </a:cxn>
                <a:cxn ang="0">
                  <a:pos x="1039" y="372"/>
                </a:cxn>
                <a:cxn ang="0">
                  <a:pos x="1119" y="596"/>
                </a:cxn>
                <a:cxn ang="0">
                  <a:pos x="1199" y="777"/>
                </a:cxn>
                <a:cxn ang="0">
                  <a:pos x="1279" y="890"/>
                </a:cxn>
              </a:cxnLst>
              <a:rect l="0" t="0" r="r" b="b"/>
              <a:pathLst>
                <a:path w="1279" h="926">
                  <a:moveTo>
                    <a:pt x="0" y="926"/>
                  </a:moveTo>
                  <a:lnTo>
                    <a:pt x="79" y="657"/>
                  </a:lnTo>
                  <a:lnTo>
                    <a:pt x="159" y="281"/>
                  </a:lnTo>
                  <a:lnTo>
                    <a:pt x="240" y="100"/>
                  </a:lnTo>
                  <a:lnTo>
                    <a:pt x="320" y="95"/>
                  </a:lnTo>
                  <a:lnTo>
                    <a:pt x="400" y="227"/>
                  </a:lnTo>
                  <a:lnTo>
                    <a:pt x="479" y="390"/>
                  </a:lnTo>
                  <a:lnTo>
                    <a:pt x="559" y="472"/>
                  </a:lnTo>
                  <a:lnTo>
                    <a:pt x="639" y="366"/>
                  </a:lnTo>
                  <a:lnTo>
                    <a:pt x="719" y="207"/>
                  </a:lnTo>
                  <a:lnTo>
                    <a:pt x="799" y="56"/>
                  </a:lnTo>
                  <a:lnTo>
                    <a:pt x="879" y="0"/>
                  </a:lnTo>
                  <a:lnTo>
                    <a:pt x="959" y="134"/>
                  </a:lnTo>
                  <a:lnTo>
                    <a:pt x="1039" y="372"/>
                  </a:lnTo>
                  <a:lnTo>
                    <a:pt x="1119" y="596"/>
                  </a:lnTo>
                  <a:lnTo>
                    <a:pt x="1199" y="777"/>
                  </a:lnTo>
                  <a:lnTo>
                    <a:pt x="1279" y="890"/>
                  </a:lnTo>
                </a:path>
              </a:pathLst>
            </a:custGeom>
            <a:noFill/>
            <a:ln w="19050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8" name="Freeform 83"/>
            <p:cNvSpPr>
              <a:spLocks/>
            </p:cNvSpPr>
            <p:nvPr/>
          </p:nvSpPr>
          <p:spPr bwMode="auto">
            <a:xfrm>
              <a:off x="830263" y="1368425"/>
              <a:ext cx="2030413" cy="1574800"/>
            </a:xfrm>
            <a:custGeom>
              <a:avLst/>
              <a:gdLst/>
              <a:ahLst/>
              <a:cxnLst>
                <a:cxn ang="0">
                  <a:pos x="0" y="992"/>
                </a:cxn>
                <a:cxn ang="0">
                  <a:pos x="79" y="733"/>
                </a:cxn>
                <a:cxn ang="0">
                  <a:pos x="159" y="376"/>
                </a:cxn>
                <a:cxn ang="0">
                  <a:pos x="240" y="226"/>
                </a:cxn>
                <a:cxn ang="0">
                  <a:pos x="320" y="205"/>
                </a:cxn>
                <a:cxn ang="0">
                  <a:pos x="400" y="328"/>
                </a:cxn>
                <a:cxn ang="0">
                  <a:pos x="479" y="513"/>
                </a:cxn>
                <a:cxn ang="0">
                  <a:pos x="559" y="590"/>
                </a:cxn>
                <a:cxn ang="0">
                  <a:pos x="639" y="437"/>
                </a:cxn>
                <a:cxn ang="0">
                  <a:pos x="719" y="215"/>
                </a:cxn>
                <a:cxn ang="0">
                  <a:pos x="799" y="38"/>
                </a:cxn>
                <a:cxn ang="0">
                  <a:pos x="879" y="0"/>
                </a:cxn>
                <a:cxn ang="0">
                  <a:pos x="959" y="167"/>
                </a:cxn>
                <a:cxn ang="0">
                  <a:pos x="1039" y="449"/>
                </a:cxn>
                <a:cxn ang="0">
                  <a:pos x="1119" y="708"/>
                </a:cxn>
                <a:cxn ang="0">
                  <a:pos x="1199" y="893"/>
                </a:cxn>
                <a:cxn ang="0">
                  <a:pos x="1279" y="988"/>
                </a:cxn>
              </a:cxnLst>
              <a:rect l="0" t="0" r="r" b="b"/>
              <a:pathLst>
                <a:path w="1279" h="992">
                  <a:moveTo>
                    <a:pt x="0" y="992"/>
                  </a:moveTo>
                  <a:lnTo>
                    <a:pt x="79" y="733"/>
                  </a:lnTo>
                  <a:lnTo>
                    <a:pt x="159" y="376"/>
                  </a:lnTo>
                  <a:lnTo>
                    <a:pt x="240" y="226"/>
                  </a:lnTo>
                  <a:lnTo>
                    <a:pt x="320" y="205"/>
                  </a:lnTo>
                  <a:lnTo>
                    <a:pt x="400" y="328"/>
                  </a:lnTo>
                  <a:lnTo>
                    <a:pt x="479" y="513"/>
                  </a:lnTo>
                  <a:lnTo>
                    <a:pt x="559" y="590"/>
                  </a:lnTo>
                  <a:lnTo>
                    <a:pt x="639" y="437"/>
                  </a:lnTo>
                  <a:lnTo>
                    <a:pt x="719" y="215"/>
                  </a:lnTo>
                  <a:lnTo>
                    <a:pt x="799" y="38"/>
                  </a:lnTo>
                  <a:lnTo>
                    <a:pt x="879" y="0"/>
                  </a:lnTo>
                  <a:lnTo>
                    <a:pt x="959" y="167"/>
                  </a:lnTo>
                  <a:lnTo>
                    <a:pt x="1039" y="449"/>
                  </a:lnTo>
                  <a:lnTo>
                    <a:pt x="1119" y="708"/>
                  </a:lnTo>
                  <a:lnTo>
                    <a:pt x="1199" y="893"/>
                  </a:lnTo>
                  <a:lnTo>
                    <a:pt x="1279" y="988"/>
                  </a:lnTo>
                </a:path>
              </a:pathLst>
            </a:custGeom>
            <a:noFill/>
            <a:ln w="19050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</p:grpSp>
      <p:sp>
        <p:nvSpPr>
          <p:cNvPr id="2" name="ZoneTexte 1"/>
          <p:cNvSpPr txBox="1"/>
          <p:nvPr/>
        </p:nvSpPr>
        <p:spPr>
          <a:xfrm>
            <a:off x="337103" y="5940152"/>
            <a:ext cx="6192688" cy="1615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1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iscrimination between cirrhosis, dysplastic lesions and hepatocellular carcinoma using synchrotron radiation or a laboratory-based infrared source. Spectra were acquired on frozen tissue sections from the patient #37 using SR-FTIR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A, B, E, F, I, J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or using a FTIR microscope equipped with a laboratory-based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lobar</a:t>
            </a:r>
            <a:r>
              <a:rPr lang="en-US" sz="1100" smtClean="0">
                <a:latin typeface="Arial" panose="020B0604020202020204" pitchFamily="34" charset="0"/>
                <a:cs typeface="Arial" panose="020B0604020202020204" pitchFamily="34" charset="0"/>
              </a:rPr>
              <a:t>) infrared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ource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C, D, G, H, K, L)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rincipal component analysis (PCA) was performed on the frequency domain 1480-1360 cm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The score plot based on PC1 and PC2 is shown where each point represents one spectrum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, C, E, G, I, K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nd the average spectra corresponding to cirrhotic, dysplastic nodules (DN) or hepatocellular carcinoma (HCC) were extracted and superimposed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B, D, F, H, J, L).</a:t>
            </a:r>
            <a:endParaRPr lang="fr-FR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fr-FR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ZoneTexte 19"/>
          <p:cNvSpPr txBox="1">
            <a:spLocks noChangeArrowheads="1"/>
          </p:cNvSpPr>
          <p:nvPr/>
        </p:nvSpPr>
        <p:spPr bwMode="auto">
          <a:xfrm>
            <a:off x="638135" y="845757"/>
            <a:ext cx="1062673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SR-FTIR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3" name="ZoneTexte 19"/>
          <p:cNvSpPr txBox="1">
            <a:spLocks noChangeArrowheads="1"/>
          </p:cNvSpPr>
          <p:nvPr/>
        </p:nvSpPr>
        <p:spPr bwMode="auto">
          <a:xfrm>
            <a:off x="638135" y="3044708"/>
            <a:ext cx="1062673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000" b="1" dirty="0" err="1" smtClean="0">
                <a:latin typeface="Arial" pitchFamily="34" charset="0"/>
                <a:cs typeface="Arial" pitchFamily="34" charset="0"/>
              </a:rPr>
              <a:t>Globar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-FTIR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4" name="ZoneTexte 19"/>
          <p:cNvSpPr txBox="1">
            <a:spLocks noChangeArrowheads="1"/>
          </p:cNvSpPr>
          <p:nvPr/>
        </p:nvSpPr>
        <p:spPr bwMode="auto">
          <a:xfrm>
            <a:off x="4022511" y="845757"/>
            <a:ext cx="1062673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SR-FTIR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5" name="ZoneTexte 19"/>
          <p:cNvSpPr txBox="1">
            <a:spLocks noChangeArrowheads="1"/>
          </p:cNvSpPr>
          <p:nvPr/>
        </p:nvSpPr>
        <p:spPr bwMode="auto">
          <a:xfrm>
            <a:off x="4022511" y="3044708"/>
            <a:ext cx="1062673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000" b="1" dirty="0" err="1" smtClean="0">
                <a:latin typeface="Arial" pitchFamily="34" charset="0"/>
                <a:cs typeface="Arial" pitchFamily="34" charset="0"/>
              </a:rPr>
              <a:t>Globar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-FTIR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6" name="ZoneTexte 19"/>
          <p:cNvSpPr txBox="1">
            <a:spLocks noChangeArrowheads="1"/>
          </p:cNvSpPr>
          <p:nvPr/>
        </p:nvSpPr>
        <p:spPr bwMode="auto">
          <a:xfrm>
            <a:off x="3433447" y="2699792"/>
            <a:ext cx="32385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sz="2000" dirty="0" smtClean="0">
                <a:latin typeface="Arial" pitchFamily="34" charset="0"/>
                <a:cs typeface="Arial" pitchFamily="34" charset="0"/>
              </a:rPr>
              <a:t>D</a:t>
            </a:r>
            <a:endParaRPr lang="en-US" sz="2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7" name="ZoneTexte 19"/>
          <p:cNvSpPr txBox="1">
            <a:spLocks noChangeArrowheads="1"/>
          </p:cNvSpPr>
          <p:nvPr/>
        </p:nvSpPr>
        <p:spPr bwMode="auto">
          <a:xfrm>
            <a:off x="3433447" y="317951"/>
            <a:ext cx="32385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sz="2000" dirty="0" smtClean="0">
                <a:latin typeface="Arial" pitchFamily="34" charset="0"/>
                <a:cs typeface="Arial" pitchFamily="34" charset="0"/>
              </a:rPr>
              <a:t>B</a:t>
            </a:r>
            <a:endParaRPr lang="en-US" sz="2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8" name="ZoneTexte 19"/>
          <p:cNvSpPr txBox="1">
            <a:spLocks noChangeArrowheads="1"/>
          </p:cNvSpPr>
          <p:nvPr/>
        </p:nvSpPr>
        <p:spPr bwMode="auto">
          <a:xfrm>
            <a:off x="25041" y="2699792"/>
            <a:ext cx="32385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sz="2000" dirty="0" smtClean="0">
                <a:latin typeface="Arial" pitchFamily="34" charset="0"/>
                <a:cs typeface="Arial" pitchFamily="34" charset="0"/>
              </a:rPr>
              <a:t>C</a:t>
            </a:r>
            <a:endParaRPr lang="en-US" sz="20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167012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/>
          <p:cNvPicPr preferRelativeResize="0">
            <a:picLocks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1672" y="2489856"/>
            <a:ext cx="2761488" cy="167335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29" name="ZoneTexte 9"/>
          <p:cNvSpPr txBox="1">
            <a:spLocks noChangeArrowheads="1"/>
          </p:cNvSpPr>
          <p:nvPr/>
        </p:nvSpPr>
        <p:spPr bwMode="auto">
          <a:xfrm>
            <a:off x="685562" y="4251476"/>
            <a:ext cx="2518064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1000" b="1" dirty="0">
                <a:latin typeface="Arial" pitchFamily="34" charset="0"/>
                <a:cs typeface="Arial" pitchFamily="34" charset="0"/>
              </a:rPr>
              <a:t>PC-1 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(73%)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0" name="ZoneTexte 129"/>
          <p:cNvSpPr txBox="1"/>
          <p:nvPr/>
        </p:nvSpPr>
        <p:spPr bwMode="auto">
          <a:xfrm>
            <a:off x="158911" y="2611678"/>
            <a:ext cx="338554" cy="1463293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000" b="1" dirty="0">
                <a:latin typeface="Arial" pitchFamily="34" charset="0"/>
                <a:cs typeface="Arial" pitchFamily="34" charset="0"/>
              </a:rPr>
              <a:t>PC-2 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(11%)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35" name="组合 18"/>
          <p:cNvGrpSpPr/>
          <p:nvPr/>
        </p:nvGrpSpPr>
        <p:grpSpPr>
          <a:xfrm>
            <a:off x="468900" y="4095239"/>
            <a:ext cx="3010136" cy="256736"/>
            <a:chOff x="81618" y="4806468"/>
            <a:chExt cx="3010136" cy="256736"/>
          </a:xfrm>
        </p:grpSpPr>
        <p:sp>
          <p:nvSpPr>
            <p:cNvPr id="136" name="ZoneTexte 3"/>
            <p:cNvSpPr txBox="1">
              <a:spLocks noChangeArrowheads="1"/>
            </p:cNvSpPr>
            <p:nvPr/>
          </p:nvSpPr>
          <p:spPr bwMode="auto">
            <a:xfrm>
              <a:off x="1293676" y="4809288"/>
              <a:ext cx="158915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>
                  <a:latin typeface="Arial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137" name="ZoneTexte 12"/>
            <p:cNvSpPr txBox="1">
              <a:spLocks noChangeArrowheads="1"/>
            </p:cNvSpPr>
            <p:nvPr/>
          </p:nvSpPr>
          <p:spPr bwMode="auto">
            <a:xfrm>
              <a:off x="2554111" y="4810840"/>
              <a:ext cx="537643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0.8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8" name="ZoneTexte 137"/>
            <p:cNvSpPr txBox="1">
              <a:spLocks noChangeArrowheads="1"/>
            </p:cNvSpPr>
            <p:nvPr/>
          </p:nvSpPr>
          <p:spPr bwMode="auto">
            <a:xfrm>
              <a:off x="81618" y="4806468"/>
              <a:ext cx="43404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-0.6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40" name="ZoneTexte 19"/>
          <p:cNvSpPr txBox="1">
            <a:spLocks noChangeArrowheads="1"/>
          </p:cNvSpPr>
          <p:nvPr/>
        </p:nvSpPr>
        <p:spPr bwMode="auto">
          <a:xfrm>
            <a:off x="4062866" y="4253771"/>
            <a:ext cx="251899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1000" b="1" dirty="0" err="1">
                <a:latin typeface="Arial" pitchFamily="34" charset="0"/>
                <a:cs typeface="Arial" pitchFamily="34" charset="0"/>
              </a:rPr>
              <a:t>Wavenumbers</a:t>
            </a:r>
            <a:r>
              <a:rPr lang="en-US" sz="1000" b="1" dirty="0">
                <a:latin typeface="Arial" pitchFamily="34" charset="0"/>
                <a:cs typeface="Arial" pitchFamily="34" charset="0"/>
              </a:rPr>
              <a:t> (cm</a:t>
            </a:r>
            <a:r>
              <a:rPr lang="en-US" sz="1000" b="1" baseline="30000" dirty="0">
                <a:latin typeface="Arial" pitchFamily="34" charset="0"/>
                <a:cs typeface="Arial" pitchFamily="34" charset="0"/>
              </a:rPr>
              <a:t>-1</a:t>
            </a:r>
            <a:r>
              <a:rPr lang="en-US" sz="1000" b="1" dirty="0">
                <a:latin typeface="Arial" pitchFamily="34" charset="0"/>
                <a:cs typeface="Arial" pitchFamily="34" charset="0"/>
              </a:rPr>
              <a:t>)</a:t>
            </a:r>
          </a:p>
        </p:txBody>
      </p:sp>
      <p:sp>
        <p:nvSpPr>
          <p:cNvPr id="141" name="TextBox 59"/>
          <p:cNvSpPr txBox="1">
            <a:spLocks noChangeArrowheads="1"/>
          </p:cNvSpPr>
          <p:nvPr/>
        </p:nvSpPr>
        <p:spPr bwMode="auto">
          <a:xfrm>
            <a:off x="3487278" y="2624204"/>
            <a:ext cx="338554" cy="148356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vert270"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Absorbance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42" name="组合 303"/>
          <p:cNvGrpSpPr/>
          <p:nvPr/>
        </p:nvGrpSpPr>
        <p:grpSpPr>
          <a:xfrm>
            <a:off x="4033472" y="2595498"/>
            <a:ext cx="2596896" cy="1517904"/>
            <a:chOff x="3179763" y="2298700"/>
            <a:chExt cx="2949575" cy="2144713"/>
          </a:xfrm>
        </p:grpSpPr>
        <p:sp>
          <p:nvSpPr>
            <p:cNvPr id="154" name="Line 14"/>
            <p:cNvSpPr>
              <a:spLocks noChangeShapeType="1"/>
            </p:cNvSpPr>
            <p:nvPr/>
          </p:nvSpPr>
          <p:spPr bwMode="auto">
            <a:xfrm flipV="1">
              <a:off x="3221038" y="4400550"/>
              <a:ext cx="0" cy="42863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55" name="Line 15"/>
            <p:cNvSpPr>
              <a:spLocks noChangeShapeType="1"/>
            </p:cNvSpPr>
            <p:nvPr/>
          </p:nvSpPr>
          <p:spPr bwMode="auto">
            <a:xfrm flipV="1">
              <a:off x="3697288" y="4400550"/>
              <a:ext cx="0" cy="22225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56" name="Line 16"/>
            <p:cNvSpPr>
              <a:spLocks noChangeShapeType="1"/>
            </p:cNvSpPr>
            <p:nvPr/>
          </p:nvSpPr>
          <p:spPr bwMode="auto">
            <a:xfrm flipV="1">
              <a:off x="4171950" y="4400550"/>
              <a:ext cx="0" cy="42863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57" name="Line 17"/>
            <p:cNvSpPr>
              <a:spLocks noChangeShapeType="1"/>
            </p:cNvSpPr>
            <p:nvPr/>
          </p:nvSpPr>
          <p:spPr bwMode="auto">
            <a:xfrm flipV="1">
              <a:off x="4648200" y="4400550"/>
              <a:ext cx="0" cy="22225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58" name="Line 18"/>
            <p:cNvSpPr>
              <a:spLocks noChangeShapeType="1"/>
            </p:cNvSpPr>
            <p:nvPr/>
          </p:nvSpPr>
          <p:spPr bwMode="auto">
            <a:xfrm flipV="1">
              <a:off x="5124450" y="4400550"/>
              <a:ext cx="0" cy="42863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59" name="Line 19"/>
            <p:cNvSpPr>
              <a:spLocks noChangeShapeType="1"/>
            </p:cNvSpPr>
            <p:nvPr/>
          </p:nvSpPr>
          <p:spPr bwMode="auto">
            <a:xfrm flipV="1">
              <a:off x="5599113" y="4400550"/>
              <a:ext cx="0" cy="22225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60" name="Line 20"/>
            <p:cNvSpPr>
              <a:spLocks noChangeShapeType="1"/>
            </p:cNvSpPr>
            <p:nvPr/>
          </p:nvSpPr>
          <p:spPr bwMode="auto">
            <a:xfrm flipV="1">
              <a:off x="6075363" y="4400550"/>
              <a:ext cx="0" cy="42863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61" name="Line 21"/>
            <p:cNvSpPr>
              <a:spLocks noChangeShapeType="1"/>
            </p:cNvSpPr>
            <p:nvPr/>
          </p:nvSpPr>
          <p:spPr bwMode="auto">
            <a:xfrm>
              <a:off x="3221038" y="4400550"/>
              <a:ext cx="285432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62" name="Line 22"/>
            <p:cNvSpPr>
              <a:spLocks noChangeShapeType="1"/>
            </p:cNvSpPr>
            <p:nvPr/>
          </p:nvSpPr>
          <p:spPr bwMode="auto">
            <a:xfrm>
              <a:off x="3179763" y="4400550"/>
              <a:ext cx="4127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63" name="Line 23"/>
            <p:cNvSpPr>
              <a:spLocks noChangeShapeType="1"/>
            </p:cNvSpPr>
            <p:nvPr/>
          </p:nvSpPr>
          <p:spPr bwMode="auto">
            <a:xfrm>
              <a:off x="3200400" y="4138613"/>
              <a:ext cx="2063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64" name="Line 24"/>
            <p:cNvSpPr>
              <a:spLocks noChangeShapeType="1"/>
            </p:cNvSpPr>
            <p:nvPr/>
          </p:nvSpPr>
          <p:spPr bwMode="auto">
            <a:xfrm>
              <a:off x="3179763" y="3875088"/>
              <a:ext cx="4127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65" name="Line 25"/>
            <p:cNvSpPr>
              <a:spLocks noChangeShapeType="1"/>
            </p:cNvSpPr>
            <p:nvPr/>
          </p:nvSpPr>
          <p:spPr bwMode="auto">
            <a:xfrm>
              <a:off x="3200400" y="3613150"/>
              <a:ext cx="2063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66" name="Line 26"/>
            <p:cNvSpPr>
              <a:spLocks noChangeShapeType="1"/>
            </p:cNvSpPr>
            <p:nvPr/>
          </p:nvSpPr>
          <p:spPr bwMode="auto">
            <a:xfrm>
              <a:off x="3179763" y="3349625"/>
              <a:ext cx="4127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67" name="Line 27"/>
            <p:cNvSpPr>
              <a:spLocks noChangeShapeType="1"/>
            </p:cNvSpPr>
            <p:nvPr/>
          </p:nvSpPr>
          <p:spPr bwMode="auto">
            <a:xfrm>
              <a:off x="3200400" y="3086100"/>
              <a:ext cx="2063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68" name="Line 28"/>
            <p:cNvSpPr>
              <a:spLocks noChangeShapeType="1"/>
            </p:cNvSpPr>
            <p:nvPr/>
          </p:nvSpPr>
          <p:spPr bwMode="auto">
            <a:xfrm>
              <a:off x="3179763" y="2824163"/>
              <a:ext cx="4127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69" name="Line 29"/>
            <p:cNvSpPr>
              <a:spLocks noChangeShapeType="1"/>
            </p:cNvSpPr>
            <p:nvPr/>
          </p:nvSpPr>
          <p:spPr bwMode="auto">
            <a:xfrm>
              <a:off x="3200400" y="2562225"/>
              <a:ext cx="2063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70" name="Line 30"/>
            <p:cNvSpPr>
              <a:spLocks noChangeShapeType="1"/>
            </p:cNvSpPr>
            <p:nvPr/>
          </p:nvSpPr>
          <p:spPr bwMode="auto">
            <a:xfrm>
              <a:off x="3179763" y="2298700"/>
              <a:ext cx="4127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71" name="Line 31"/>
            <p:cNvSpPr>
              <a:spLocks noChangeShapeType="1"/>
            </p:cNvSpPr>
            <p:nvPr/>
          </p:nvSpPr>
          <p:spPr bwMode="auto">
            <a:xfrm flipV="1">
              <a:off x="3221038" y="2298700"/>
              <a:ext cx="0" cy="210185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72" name="Freeform 32"/>
            <p:cNvSpPr>
              <a:spLocks/>
            </p:cNvSpPr>
            <p:nvPr/>
          </p:nvSpPr>
          <p:spPr bwMode="auto">
            <a:xfrm>
              <a:off x="3195638" y="2486025"/>
              <a:ext cx="2933700" cy="1914525"/>
            </a:xfrm>
            <a:custGeom>
              <a:avLst/>
              <a:gdLst>
                <a:gd name="T0" fmla="*/ 0 w 1848"/>
                <a:gd name="T1" fmla="*/ 1206 h 1206"/>
                <a:gd name="T2" fmla="*/ 115 w 1848"/>
                <a:gd name="T3" fmla="*/ 878 h 1206"/>
                <a:gd name="T4" fmla="*/ 230 w 1848"/>
                <a:gd name="T5" fmla="*/ 390 h 1206"/>
                <a:gd name="T6" fmla="*/ 346 w 1848"/>
                <a:gd name="T7" fmla="*/ 142 h 1206"/>
                <a:gd name="T8" fmla="*/ 461 w 1848"/>
                <a:gd name="T9" fmla="*/ 96 h 1206"/>
                <a:gd name="T10" fmla="*/ 577 w 1848"/>
                <a:gd name="T11" fmla="*/ 254 h 1206"/>
                <a:gd name="T12" fmla="*/ 693 w 1848"/>
                <a:gd name="T13" fmla="*/ 484 h 1206"/>
                <a:gd name="T14" fmla="*/ 808 w 1848"/>
                <a:gd name="T15" fmla="*/ 615 h 1206"/>
                <a:gd name="T16" fmla="*/ 924 w 1848"/>
                <a:gd name="T17" fmla="*/ 490 h 1206"/>
                <a:gd name="T18" fmla="*/ 1039 w 1848"/>
                <a:gd name="T19" fmla="*/ 282 h 1206"/>
                <a:gd name="T20" fmla="*/ 1155 w 1848"/>
                <a:gd name="T21" fmla="*/ 83 h 1206"/>
                <a:gd name="T22" fmla="*/ 1270 w 1848"/>
                <a:gd name="T23" fmla="*/ 0 h 1206"/>
                <a:gd name="T24" fmla="*/ 1386 w 1848"/>
                <a:gd name="T25" fmla="*/ 145 h 1206"/>
                <a:gd name="T26" fmla="*/ 1501 w 1848"/>
                <a:gd name="T27" fmla="*/ 446 h 1206"/>
                <a:gd name="T28" fmla="*/ 1617 w 1848"/>
                <a:gd name="T29" fmla="*/ 748 h 1206"/>
                <a:gd name="T30" fmla="*/ 1732 w 1848"/>
                <a:gd name="T31" fmla="*/ 1000 h 1206"/>
                <a:gd name="T32" fmla="*/ 1848 w 1848"/>
                <a:gd name="T33" fmla="*/ 1156 h 12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1848" h="1206">
                  <a:moveTo>
                    <a:pt x="0" y="1206"/>
                  </a:moveTo>
                  <a:lnTo>
                    <a:pt x="115" y="878"/>
                  </a:lnTo>
                  <a:lnTo>
                    <a:pt x="230" y="390"/>
                  </a:lnTo>
                  <a:lnTo>
                    <a:pt x="346" y="142"/>
                  </a:lnTo>
                  <a:lnTo>
                    <a:pt x="461" y="96"/>
                  </a:lnTo>
                  <a:lnTo>
                    <a:pt x="577" y="254"/>
                  </a:lnTo>
                  <a:lnTo>
                    <a:pt x="693" y="484"/>
                  </a:lnTo>
                  <a:lnTo>
                    <a:pt x="808" y="615"/>
                  </a:lnTo>
                  <a:lnTo>
                    <a:pt x="924" y="490"/>
                  </a:lnTo>
                  <a:lnTo>
                    <a:pt x="1039" y="282"/>
                  </a:lnTo>
                  <a:lnTo>
                    <a:pt x="1155" y="83"/>
                  </a:lnTo>
                  <a:lnTo>
                    <a:pt x="1270" y="0"/>
                  </a:lnTo>
                  <a:lnTo>
                    <a:pt x="1386" y="145"/>
                  </a:lnTo>
                  <a:lnTo>
                    <a:pt x="1501" y="446"/>
                  </a:lnTo>
                  <a:lnTo>
                    <a:pt x="1617" y="748"/>
                  </a:lnTo>
                  <a:lnTo>
                    <a:pt x="1732" y="1000"/>
                  </a:lnTo>
                  <a:lnTo>
                    <a:pt x="1848" y="1156"/>
                  </a:lnTo>
                </a:path>
              </a:pathLst>
            </a:custGeom>
            <a:noFill/>
            <a:ln w="1270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73" name="Freeform 33"/>
            <p:cNvSpPr>
              <a:spLocks/>
            </p:cNvSpPr>
            <p:nvPr/>
          </p:nvSpPr>
          <p:spPr bwMode="auto">
            <a:xfrm>
              <a:off x="3195638" y="2360613"/>
              <a:ext cx="2933700" cy="2039938"/>
            </a:xfrm>
            <a:custGeom>
              <a:avLst/>
              <a:gdLst>
                <a:gd name="T0" fmla="*/ 0 w 1848"/>
                <a:gd name="T1" fmla="*/ 1285 h 1285"/>
                <a:gd name="T2" fmla="*/ 115 w 1848"/>
                <a:gd name="T3" fmla="*/ 992 h 1285"/>
                <a:gd name="T4" fmla="*/ 230 w 1848"/>
                <a:gd name="T5" fmla="*/ 504 h 1285"/>
                <a:gd name="T6" fmla="*/ 346 w 1848"/>
                <a:gd name="T7" fmla="*/ 232 h 1285"/>
                <a:gd name="T8" fmla="*/ 461 w 1848"/>
                <a:gd name="T9" fmla="*/ 159 h 1285"/>
                <a:gd name="T10" fmla="*/ 577 w 1848"/>
                <a:gd name="T11" fmla="*/ 334 h 1285"/>
                <a:gd name="T12" fmla="*/ 693 w 1848"/>
                <a:gd name="T13" fmla="*/ 631 h 1285"/>
                <a:gd name="T14" fmla="*/ 808 w 1848"/>
                <a:gd name="T15" fmla="*/ 823 h 1285"/>
                <a:gd name="T16" fmla="*/ 924 w 1848"/>
                <a:gd name="T17" fmla="*/ 701 h 1285"/>
                <a:gd name="T18" fmla="*/ 1039 w 1848"/>
                <a:gd name="T19" fmla="*/ 454 h 1285"/>
                <a:gd name="T20" fmla="*/ 1155 w 1848"/>
                <a:gd name="T21" fmla="*/ 182 h 1285"/>
                <a:gd name="T22" fmla="*/ 1270 w 1848"/>
                <a:gd name="T23" fmla="*/ 0 h 1285"/>
                <a:gd name="T24" fmla="*/ 1386 w 1848"/>
                <a:gd name="T25" fmla="*/ 94 h 1285"/>
                <a:gd name="T26" fmla="*/ 1501 w 1848"/>
                <a:gd name="T27" fmla="*/ 425 h 1285"/>
                <a:gd name="T28" fmla="*/ 1617 w 1848"/>
                <a:gd name="T29" fmla="*/ 792 h 1285"/>
                <a:gd name="T30" fmla="*/ 1732 w 1848"/>
                <a:gd name="T31" fmla="*/ 1098 h 1285"/>
                <a:gd name="T32" fmla="*/ 1848 w 1848"/>
                <a:gd name="T33" fmla="*/ 1261 h 12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1848" h="1285">
                  <a:moveTo>
                    <a:pt x="0" y="1285"/>
                  </a:moveTo>
                  <a:lnTo>
                    <a:pt x="115" y="992"/>
                  </a:lnTo>
                  <a:lnTo>
                    <a:pt x="230" y="504"/>
                  </a:lnTo>
                  <a:lnTo>
                    <a:pt x="346" y="232"/>
                  </a:lnTo>
                  <a:lnTo>
                    <a:pt x="461" y="159"/>
                  </a:lnTo>
                  <a:lnTo>
                    <a:pt x="577" y="334"/>
                  </a:lnTo>
                  <a:lnTo>
                    <a:pt x="693" y="631"/>
                  </a:lnTo>
                  <a:lnTo>
                    <a:pt x="808" y="823"/>
                  </a:lnTo>
                  <a:lnTo>
                    <a:pt x="924" y="701"/>
                  </a:lnTo>
                  <a:lnTo>
                    <a:pt x="1039" y="454"/>
                  </a:lnTo>
                  <a:lnTo>
                    <a:pt x="1155" y="182"/>
                  </a:lnTo>
                  <a:lnTo>
                    <a:pt x="1270" y="0"/>
                  </a:lnTo>
                  <a:lnTo>
                    <a:pt x="1386" y="94"/>
                  </a:lnTo>
                  <a:lnTo>
                    <a:pt x="1501" y="425"/>
                  </a:lnTo>
                  <a:lnTo>
                    <a:pt x="1617" y="792"/>
                  </a:lnTo>
                  <a:lnTo>
                    <a:pt x="1732" y="1098"/>
                  </a:lnTo>
                  <a:lnTo>
                    <a:pt x="1848" y="1261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</p:grpSp>
      <p:grpSp>
        <p:nvGrpSpPr>
          <p:cNvPr id="143" name="组合 324"/>
          <p:cNvGrpSpPr/>
          <p:nvPr/>
        </p:nvGrpSpPr>
        <p:grpSpPr>
          <a:xfrm>
            <a:off x="3818831" y="2531235"/>
            <a:ext cx="183172" cy="1633816"/>
            <a:chOff x="3918564" y="717941"/>
            <a:chExt cx="136539" cy="3720859"/>
          </a:xfrm>
        </p:grpSpPr>
        <p:sp>
          <p:nvSpPr>
            <p:cNvPr id="149" name="Rectangle 11"/>
            <p:cNvSpPr>
              <a:spLocks noChangeArrowheads="1"/>
            </p:cNvSpPr>
            <p:nvPr/>
          </p:nvSpPr>
          <p:spPr bwMode="auto">
            <a:xfrm>
              <a:off x="4000392" y="4088335"/>
              <a:ext cx="52575" cy="3504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0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Rectangle 15"/>
            <p:cNvSpPr>
              <a:spLocks noChangeArrowheads="1"/>
            </p:cNvSpPr>
            <p:nvPr/>
          </p:nvSpPr>
          <p:spPr bwMode="auto">
            <a:xfrm>
              <a:off x="3923177" y="1611089"/>
              <a:ext cx="131439" cy="3504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0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3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Rectangle 15"/>
            <p:cNvSpPr>
              <a:spLocks noChangeArrowheads="1"/>
            </p:cNvSpPr>
            <p:nvPr/>
          </p:nvSpPr>
          <p:spPr bwMode="auto">
            <a:xfrm>
              <a:off x="3918584" y="2368066"/>
              <a:ext cx="131438" cy="3504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0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Rectangle 15"/>
            <p:cNvSpPr>
              <a:spLocks noChangeArrowheads="1"/>
            </p:cNvSpPr>
            <p:nvPr/>
          </p:nvSpPr>
          <p:spPr bwMode="auto">
            <a:xfrm>
              <a:off x="3923664" y="717941"/>
              <a:ext cx="131439" cy="3504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0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Rectangle 15"/>
            <p:cNvSpPr>
              <a:spLocks noChangeArrowheads="1"/>
            </p:cNvSpPr>
            <p:nvPr/>
          </p:nvSpPr>
          <p:spPr bwMode="auto">
            <a:xfrm>
              <a:off x="3918564" y="3229906"/>
              <a:ext cx="131438" cy="3504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0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4" name="组合 331"/>
          <p:cNvGrpSpPr/>
          <p:nvPr/>
        </p:nvGrpSpPr>
        <p:grpSpPr>
          <a:xfrm>
            <a:off x="3924253" y="4145547"/>
            <a:ext cx="2797795" cy="163756"/>
            <a:chOff x="3611822" y="4999408"/>
            <a:chExt cx="2085502" cy="372936"/>
          </a:xfrm>
        </p:grpSpPr>
        <p:sp>
          <p:nvSpPr>
            <p:cNvPr id="145" name="Rectangle 5"/>
            <p:cNvSpPr>
              <a:spLocks noChangeArrowheads="1"/>
            </p:cNvSpPr>
            <p:nvPr/>
          </p:nvSpPr>
          <p:spPr bwMode="auto">
            <a:xfrm>
              <a:off x="3611822" y="4999659"/>
              <a:ext cx="210302" cy="3504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1480</a:t>
              </a:r>
              <a:endParaRPr kumimoji="0" lang="zh-CN" altLang="zh-CN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46" name="Rectangle 5"/>
            <p:cNvSpPr>
              <a:spLocks noChangeArrowheads="1"/>
            </p:cNvSpPr>
            <p:nvPr/>
          </p:nvSpPr>
          <p:spPr bwMode="auto">
            <a:xfrm>
              <a:off x="4241373" y="5005988"/>
              <a:ext cx="210302" cy="3504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1440</a:t>
              </a:r>
              <a:endParaRPr kumimoji="0" lang="zh-CN" altLang="zh-CN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47" name="Rectangle 5"/>
            <p:cNvSpPr>
              <a:spLocks noChangeArrowheads="1"/>
            </p:cNvSpPr>
            <p:nvPr/>
          </p:nvSpPr>
          <p:spPr bwMode="auto">
            <a:xfrm>
              <a:off x="4864198" y="4999408"/>
              <a:ext cx="210302" cy="3504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1400</a:t>
              </a:r>
              <a:endParaRPr kumimoji="0" lang="zh-CN" altLang="zh-CN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48" name="Rectangle 5"/>
            <p:cNvSpPr>
              <a:spLocks noChangeArrowheads="1"/>
            </p:cNvSpPr>
            <p:nvPr/>
          </p:nvSpPr>
          <p:spPr bwMode="auto">
            <a:xfrm>
              <a:off x="5487022" y="5021879"/>
              <a:ext cx="210302" cy="3504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1360</a:t>
              </a:r>
              <a:endParaRPr kumimoji="0" lang="zh-CN" altLang="zh-CN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pic>
        <p:nvPicPr>
          <p:cNvPr id="1026" name="Picture 2"/>
          <p:cNvPicPr preferRelativeResize="0">
            <a:picLocks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575220" y="503297"/>
            <a:ext cx="2770632" cy="16459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grpSp>
        <p:nvGrpSpPr>
          <p:cNvPr id="5" name="组合 41"/>
          <p:cNvGrpSpPr/>
          <p:nvPr/>
        </p:nvGrpSpPr>
        <p:grpSpPr>
          <a:xfrm>
            <a:off x="4033831" y="580316"/>
            <a:ext cx="2556584" cy="1527048"/>
            <a:chOff x="1123950" y="1244600"/>
            <a:chExt cx="2865438" cy="2120900"/>
          </a:xfrm>
        </p:grpSpPr>
        <p:sp>
          <p:nvSpPr>
            <p:cNvPr id="6" name="Line 15"/>
            <p:cNvSpPr>
              <a:spLocks noChangeShapeType="1"/>
            </p:cNvSpPr>
            <p:nvPr/>
          </p:nvSpPr>
          <p:spPr bwMode="auto">
            <a:xfrm flipV="1">
              <a:off x="1166813" y="3324225"/>
              <a:ext cx="0" cy="41275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" name="Line 16"/>
            <p:cNvSpPr>
              <a:spLocks noChangeShapeType="1"/>
            </p:cNvSpPr>
            <p:nvPr/>
          </p:nvSpPr>
          <p:spPr bwMode="auto">
            <a:xfrm flipV="1">
              <a:off x="1635125" y="3324225"/>
              <a:ext cx="0" cy="20638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" name="Line 17"/>
            <p:cNvSpPr>
              <a:spLocks noChangeShapeType="1"/>
            </p:cNvSpPr>
            <p:nvPr/>
          </p:nvSpPr>
          <p:spPr bwMode="auto">
            <a:xfrm flipV="1">
              <a:off x="2105025" y="3324225"/>
              <a:ext cx="0" cy="41275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" name="Line 18"/>
            <p:cNvSpPr>
              <a:spLocks noChangeShapeType="1"/>
            </p:cNvSpPr>
            <p:nvPr/>
          </p:nvSpPr>
          <p:spPr bwMode="auto">
            <a:xfrm flipV="1">
              <a:off x="2573338" y="3324225"/>
              <a:ext cx="0" cy="20638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" name="Line 19"/>
            <p:cNvSpPr>
              <a:spLocks noChangeShapeType="1"/>
            </p:cNvSpPr>
            <p:nvPr/>
          </p:nvSpPr>
          <p:spPr bwMode="auto">
            <a:xfrm flipV="1">
              <a:off x="3043238" y="3324225"/>
              <a:ext cx="0" cy="41275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1" name="Line 20"/>
            <p:cNvSpPr>
              <a:spLocks noChangeShapeType="1"/>
            </p:cNvSpPr>
            <p:nvPr/>
          </p:nvSpPr>
          <p:spPr bwMode="auto">
            <a:xfrm flipV="1">
              <a:off x="3513138" y="3324225"/>
              <a:ext cx="0" cy="20638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2" name="Line 21"/>
            <p:cNvSpPr>
              <a:spLocks noChangeShapeType="1"/>
            </p:cNvSpPr>
            <p:nvPr/>
          </p:nvSpPr>
          <p:spPr bwMode="auto">
            <a:xfrm flipV="1">
              <a:off x="3981450" y="3324225"/>
              <a:ext cx="0" cy="41275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3" name="Line 22"/>
            <p:cNvSpPr>
              <a:spLocks noChangeShapeType="1"/>
            </p:cNvSpPr>
            <p:nvPr/>
          </p:nvSpPr>
          <p:spPr bwMode="auto">
            <a:xfrm>
              <a:off x="1166813" y="3324225"/>
              <a:ext cx="281463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4" name="Line 23"/>
            <p:cNvSpPr>
              <a:spLocks noChangeShapeType="1"/>
            </p:cNvSpPr>
            <p:nvPr/>
          </p:nvSpPr>
          <p:spPr bwMode="auto">
            <a:xfrm>
              <a:off x="1123950" y="3324225"/>
              <a:ext cx="42863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5" name="Line 24"/>
            <p:cNvSpPr>
              <a:spLocks noChangeShapeType="1"/>
            </p:cNvSpPr>
            <p:nvPr/>
          </p:nvSpPr>
          <p:spPr bwMode="auto">
            <a:xfrm>
              <a:off x="1146175" y="3116263"/>
              <a:ext cx="2063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6" name="Line 25"/>
            <p:cNvSpPr>
              <a:spLocks noChangeShapeType="1"/>
            </p:cNvSpPr>
            <p:nvPr/>
          </p:nvSpPr>
          <p:spPr bwMode="auto">
            <a:xfrm>
              <a:off x="1123950" y="2908300"/>
              <a:ext cx="42863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7" name="Line 26"/>
            <p:cNvSpPr>
              <a:spLocks noChangeShapeType="1"/>
            </p:cNvSpPr>
            <p:nvPr/>
          </p:nvSpPr>
          <p:spPr bwMode="auto">
            <a:xfrm>
              <a:off x="1146175" y="2700338"/>
              <a:ext cx="2063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8" name="Line 27"/>
            <p:cNvSpPr>
              <a:spLocks noChangeShapeType="1"/>
            </p:cNvSpPr>
            <p:nvPr/>
          </p:nvSpPr>
          <p:spPr bwMode="auto">
            <a:xfrm>
              <a:off x="1123950" y="2492375"/>
              <a:ext cx="42863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9" name="Line 28"/>
            <p:cNvSpPr>
              <a:spLocks noChangeShapeType="1"/>
            </p:cNvSpPr>
            <p:nvPr/>
          </p:nvSpPr>
          <p:spPr bwMode="auto">
            <a:xfrm>
              <a:off x="1146175" y="2284413"/>
              <a:ext cx="2063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0" name="Line 29"/>
            <p:cNvSpPr>
              <a:spLocks noChangeShapeType="1"/>
            </p:cNvSpPr>
            <p:nvPr/>
          </p:nvSpPr>
          <p:spPr bwMode="auto">
            <a:xfrm>
              <a:off x="1123950" y="2076450"/>
              <a:ext cx="42863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1" name="Line 30"/>
            <p:cNvSpPr>
              <a:spLocks noChangeShapeType="1"/>
            </p:cNvSpPr>
            <p:nvPr/>
          </p:nvSpPr>
          <p:spPr bwMode="auto">
            <a:xfrm>
              <a:off x="1146175" y="1868488"/>
              <a:ext cx="2063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2" name="Line 31"/>
            <p:cNvSpPr>
              <a:spLocks noChangeShapeType="1"/>
            </p:cNvSpPr>
            <p:nvPr/>
          </p:nvSpPr>
          <p:spPr bwMode="auto">
            <a:xfrm>
              <a:off x="1123950" y="1660525"/>
              <a:ext cx="42863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3" name="Line 32"/>
            <p:cNvSpPr>
              <a:spLocks noChangeShapeType="1"/>
            </p:cNvSpPr>
            <p:nvPr/>
          </p:nvSpPr>
          <p:spPr bwMode="auto">
            <a:xfrm>
              <a:off x="1146175" y="1452563"/>
              <a:ext cx="2063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4" name="Line 33"/>
            <p:cNvSpPr>
              <a:spLocks noChangeShapeType="1"/>
            </p:cNvSpPr>
            <p:nvPr/>
          </p:nvSpPr>
          <p:spPr bwMode="auto">
            <a:xfrm>
              <a:off x="1123950" y="1244600"/>
              <a:ext cx="42863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5" name="Line 34"/>
            <p:cNvSpPr>
              <a:spLocks noChangeShapeType="1"/>
            </p:cNvSpPr>
            <p:nvPr/>
          </p:nvSpPr>
          <p:spPr bwMode="auto">
            <a:xfrm flipV="1">
              <a:off x="1166813" y="1244600"/>
              <a:ext cx="0" cy="2079625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6" name="Freeform 35"/>
            <p:cNvSpPr>
              <a:spLocks/>
            </p:cNvSpPr>
            <p:nvPr/>
          </p:nvSpPr>
          <p:spPr bwMode="auto">
            <a:xfrm>
              <a:off x="1185863" y="1744663"/>
              <a:ext cx="2803525" cy="1579563"/>
            </a:xfrm>
            <a:custGeom>
              <a:avLst/>
              <a:gdLst>
                <a:gd name="T0" fmla="*/ 0 w 1766"/>
                <a:gd name="T1" fmla="*/ 995 h 995"/>
                <a:gd name="T2" fmla="*/ 28 w 1766"/>
                <a:gd name="T3" fmla="*/ 947 h 995"/>
                <a:gd name="T4" fmla="*/ 57 w 1766"/>
                <a:gd name="T5" fmla="*/ 873 h 995"/>
                <a:gd name="T6" fmla="*/ 85 w 1766"/>
                <a:gd name="T7" fmla="*/ 754 h 995"/>
                <a:gd name="T8" fmla="*/ 114 w 1766"/>
                <a:gd name="T9" fmla="*/ 586 h 995"/>
                <a:gd name="T10" fmla="*/ 142 w 1766"/>
                <a:gd name="T11" fmla="*/ 412 h 995"/>
                <a:gd name="T12" fmla="*/ 171 w 1766"/>
                <a:gd name="T13" fmla="*/ 292 h 995"/>
                <a:gd name="T14" fmla="*/ 199 w 1766"/>
                <a:gd name="T15" fmla="*/ 240 h 995"/>
                <a:gd name="T16" fmla="*/ 228 w 1766"/>
                <a:gd name="T17" fmla="*/ 213 h 995"/>
                <a:gd name="T18" fmla="*/ 256 w 1766"/>
                <a:gd name="T19" fmla="*/ 178 h 995"/>
                <a:gd name="T20" fmla="*/ 284 w 1766"/>
                <a:gd name="T21" fmla="*/ 125 h 995"/>
                <a:gd name="T22" fmla="*/ 313 w 1766"/>
                <a:gd name="T23" fmla="*/ 71 h 995"/>
                <a:gd name="T24" fmla="*/ 342 w 1766"/>
                <a:gd name="T25" fmla="*/ 18 h 995"/>
                <a:gd name="T26" fmla="*/ 370 w 1766"/>
                <a:gd name="T27" fmla="*/ 0 h 995"/>
                <a:gd name="T28" fmla="*/ 399 w 1766"/>
                <a:gd name="T29" fmla="*/ 31 h 995"/>
                <a:gd name="T30" fmla="*/ 427 w 1766"/>
                <a:gd name="T31" fmla="*/ 79 h 995"/>
                <a:gd name="T32" fmla="*/ 456 w 1766"/>
                <a:gd name="T33" fmla="*/ 126 h 995"/>
                <a:gd name="T34" fmla="*/ 484 w 1766"/>
                <a:gd name="T35" fmla="*/ 157 h 995"/>
                <a:gd name="T36" fmla="*/ 513 w 1766"/>
                <a:gd name="T37" fmla="*/ 189 h 995"/>
                <a:gd name="T38" fmla="*/ 541 w 1766"/>
                <a:gd name="T39" fmla="*/ 240 h 995"/>
                <a:gd name="T40" fmla="*/ 569 w 1766"/>
                <a:gd name="T41" fmla="*/ 300 h 995"/>
                <a:gd name="T42" fmla="*/ 598 w 1766"/>
                <a:gd name="T43" fmla="*/ 359 h 995"/>
                <a:gd name="T44" fmla="*/ 627 w 1766"/>
                <a:gd name="T45" fmla="*/ 427 h 995"/>
                <a:gd name="T46" fmla="*/ 655 w 1766"/>
                <a:gd name="T47" fmla="*/ 491 h 995"/>
                <a:gd name="T48" fmla="*/ 683 w 1766"/>
                <a:gd name="T49" fmla="*/ 549 h 995"/>
                <a:gd name="T50" fmla="*/ 712 w 1766"/>
                <a:gd name="T51" fmla="*/ 603 h 995"/>
                <a:gd name="T52" fmla="*/ 741 w 1766"/>
                <a:gd name="T53" fmla="*/ 634 h 995"/>
                <a:gd name="T54" fmla="*/ 769 w 1766"/>
                <a:gd name="T55" fmla="*/ 634 h 995"/>
                <a:gd name="T56" fmla="*/ 798 w 1766"/>
                <a:gd name="T57" fmla="*/ 609 h 995"/>
                <a:gd name="T58" fmla="*/ 826 w 1766"/>
                <a:gd name="T59" fmla="*/ 566 h 995"/>
                <a:gd name="T60" fmla="*/ 854 w 1766"/>
                <a:gd name="T61" fmla="*/ 519 h 995"/>
                <a:gd name="T62" fmla="*/ 883 w 1766"/>
                <a:gd name="T63" fmla="*/ 473 h 995"/>
                <a:gd name="T64" fmla="*/ 912 w 1766"/>
                <a:gd name="T65" fmla="*/ 428 h 995"/>
                <a:gd name="T66" fmla="*/ 940 w 1766"/>
                <a:gd name="T67" fmla="*/ 383 h 995"/>
                <a:gd name="T68" fmla="*/ 968 w 1766"/>
                <a:gd name="T69" fmla="*/ 356 h 995"/>
                <a:gd name="T70" fmla="*/ 997 w 1766"/>
                <a:gd name="T71" fmla="*/ 337 h 995"/>
                <a:gd name="T72" fmla="*/ 1026 w 1766"/>
                <a:gd name="T73" fmla="*/ 297 h 995"/>
                <a:gd name="T74" fmla="*/ 1054 w 1766"/>
                <a:gd name="T75" fmla="*/ 243 h 995"/>
                <a:gd name="T76" fmla="*/ 1082 w 1766"/>
                <a:gd name="T77" fmla="*/ 191 h 995"/>
                <a:gd name="T78" fmla="*/ 1111 w 1766"/>
                <a:gd name="T79" fmla="*/ 144 h 995"/>
                <a:gd name="T80" fmla="*/ 1140 w 1766"/>
                <a:gd name="T81" fmla="*/ 103 h 995"/>
                <a:gd name="T82" fmla="*/ 1168 w 1766"/>
                <a:gd name="T83" fmla="*/ 79 h 995"/>
                <a:gd name="T84" fmla="*/ 1197 w 1766"/>
                <a:gd name="T85" fmla="*/ 61 h 995"/>
                <a:gd name="T86" fmla="*/ 1225 w 1766"/>
                <a:gd name="T87" fmla="*/ 55 h 995"/>
                <a:gd name="T88" fmla="*/ 1253 w 1766"/>
                <a:gd name="T89" fmla="*/ 70 h 995"/>
                <a:gd name="T90" fmla="*/ 1282 w 1766"/>
                <a:gd name="T91" fmla="*/ 90 h 995"/>
                <a:gd name="T92" fmla="*/ 1311 w 1766"/>
                <a:gd name="T93" fmla="*/ 103 h 995"/>
                <a:gd name="T94" fmla="*/ 1339 w 1766"/>
                <a:gd name="T95" fmla="*/ 135 h 995"/>
                <a:gd name="T96" fmla="*/ 1367 w 1766"/>
                <a:gd name="T97" fmla="*/ 188 h 995"/>
                <a:gd name="T98" fmla="*/ 1396 w 1766"/>
                <a:gd name="T99" fmla="*/ 246 h 995"/>
                <a:gd name="T100" fmla="*/ 1425 w 1766"/>
                <a:gd name="T101" fmla="*/ 318 h 995"/>
                <a:gd name="T102" fmla="*/ 1453 w 1766"/>
                <a:gd name="T103" fmla="*/ 387 h 995"/>
                <a:gd name="T104" fmla="*/ 1481 w 1766"/>
                <a:gd name="T105" fmla="*/ 454 h 995"/>
                <a:gd name="T106" fmla="*/ 1510 w 1766"/>
                <a:gd name="T107" fmla="*/ 526 h 995"/>
                <a:gd name="T108" fmla="*/ 1538 w 1766"/>
                <a:gd name="T109" fmla="*/ 603 h 995"/>
                <a:gd name="T110" fmla="*/ 1567 w 1766"/>
                <a:gd name="T111" fmla="*/ 656 h 995"/>
                <a:gd name="T112" fmla="*/ 1595 w 1766"/>
                <a:gd name="T113" fmla="*/ 687 h 995"/>
                <a:gd name="T114" fmla="*/ 1624 w 1766"/>
                <a:gd name="T115" fmla="*/ 724 h 995"/>
                <a:gd name="T116" fmla="*/ 1652 w 1766"/>
                <a:gd name="T117" fmla="*/ 776 h 995"/>
                <a:gd name="T118" fmla="*/ 1681 w 1766"/>
                <a:gd name="T119" fmla="*/ 836 h 995"/>
                <a:gd name="T120" fmla="*/ 1710 w 1766"/>
                <a:gd name="T121" fmla="*/ 899 h 995"/>
                <a:gd name="T122" fmla="*/ 1738 w 1766"/>
                <a:gd name="T123" fmla="*/ 939 h 995"/>
                <a:gd name="T124" fmla="*/ 1766 w 1766"/>
                <a:gd name="T125" fmla="*/ 967 h 9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1766" h="995">
                  <a:moveTo>
                    <a:pt x="0" y="995"/>
                  </a:moveTo>
                  <a:lnTo>
                    <a:pt x="28" y="947"/>
                  </a:lnTo>
                  <a:lnTo>
                    <a:pt x="57" y="873"/>
                  </a:lnTo>
                  <a:lnTo>
                    <a:pt x="85" y="754"/>
                  </a:lnTo>
                  <a:lnTo>
                    <a:pt x="114" y="586"/>
                  </a:lnTo>
                  <a:lnTo>
                    <a:pt x="142" y="412"/>
                  </a:lnTo>
                  <a:lnTo>
                    <a:pt x="171" y="292"/>
                  </a:lnTo>
                  <a:lnTo>
                    <a:pt x="199" y="240"/>
                  </a:lnTo>
                  <a:lnTo>
                    <a:pt x="228" y="213"/>
                  </a:lnTo>
                  <a:lnTo>
                    <a:pt x="256" y="178"/>
                  </a:lnTo>
                  <a:lnTo>
                    <a:pt x="284" y="125"/>
                  </a:lnTo>
                  <a:lnTo>
                    <a:pt x="313" y="71"/>
                  </a:lnTo>
                  <a:lnTo>
                    <a:pt x="342" y="18"/>
                  </a:lnTo>
                  <a:lnTo>
                    <a:pt x="370" y="0"/>
                  </a:lnTo>
                  <a:lnTo>
                    <a:pt x="399" y="31"/>
                  </a:lnTo>
                  <a:lnTo>
                    <a:pt x="427" y="79"/>
                  </a:lnTo>
                  <a:lnTo>
                    <a:pt x="456" y="126"/>
                  </a:lnTo>
                  <a:lnTo>
                    <a:pt x="484" y="157"/>
                  </a:lnTo>
                  <a:lnTo>
                    <a:pt x="513" y="189"/>
                  </a:lnTo>
                  <a:lnTo>
                    <a:pt x="541" y="240"/>
                  </a:lnTo>
                  <a:lnTo>
                    <a:pt x="569" y="300"/>
                  </a:lnTo>
                  <a:lnTo>
                    <a:pt x="598" y="359"/>
                  </a:lnTo>
                  <a:lnTo>
                    <a:pt x="627" y="427"/>
                  </a:lnTo>
                  <a:lnTo>
                    <a:pt x="655" y="491"/>
                  </a:lnTo>
                  <a:lnTo>
                    <a:pt x="683" y="549"/>
                  </a:lnTo>
                  <a:lnTo>
                    <a:pt x="712" y="603"/>
                  </a:lnTo>
                  <a:lnTo>
                    <a:pt x="741" y="634"/>
                  </a:lnTo>
                  <a:lnTo>
                    <a:pt x="769" y="634"/>
                  </a:lnTo>
                  <a:lnTo>
                    <a:pt x="798" y="609"/>
                  </a:lnTo>
                  <a:lnTo>
                    <a:pt x="826" y="566"/>
                  </a:lnTo>
                  <a:lnTo>
                    <a:pt x="854" y="519"/>
                  </a:lnTo>
                  <a:lnTo>
                    <a:pt x="883" y="473"/>
                  </a:lnTo>
                  <a:lnTo>
                    <a:pt x="912" y="428"/>
                  </a:lnTo>
                  <a:lnTo>
                    <a:pt x="940" y="383"/>
                  </a:lnTo>
                  <a:lnTo>
                    <a:pt x="968" y="356"/>
                  </a:lnTo>
                  <a:lnTo>
                    <a:pt x="997" y="337"/>
                  </a:lnTo>
                  <a:lnTo>
                    <a:pt x="1026" y="297"/>
                  </a:lnTo>
                  <a:lnTo>
                    <a:pt x="1054" y="243"/>
                  </a:lnTo>
                  <a:lnTo>
                    <a:pt x="1082" y="191"/>
                  </a:lnTo>
                  <a:lnTo>
                    <a:pt x="1111" y="144"/>
                  </a:lnTo>
                  <a:lnTo>
                    <a:pt x="1140" y="103"/>
                  </a:lnTo>
                  <a:lnTo>
                    <a:pt x="1168" y="79"/>
                  </a:lnTo>
                  <a:lnTo>
                    <a:pt x="1197" y="61"/>
                  </a:lnTo>
                  <a:lnTo>
                    <a:pt x="1225" y="55"/>
                  </a:lnTo>
                  <a:lnTo>
                    <a:pt x="1253" y="70"/>
                  </a:lnTo>
                  <a:lnTo>
                    <a:pt x="1282" y="90"/>
                  </a:lnTo>
                  <a:lnTo>
                    <a:pt x="1311" y="103"/>
                  </a:lnTo>
                  <a:lnTo>
                    <a:pt x="1339" y="135"/>
                  </a:lnTo>
                  <a:lnTo>
                    <a:pt x="1367" y="188"/>
                  </a:lnTo>
                  <a:lnTo>
                    <a:pt x="1396" y="246"/>
                  </a:lnTo>
                  <a:lnTo>
                    <a:pt x="1425" y="318"/>
                  </a:lnTo>
                  <a:lnTo>
                    <a:pt x="1453" y="387"/>
                  </a:lnTo>
                  <a:lnTo>
                    <a:pt x="1481" y="454"/>
                  </a:lnTo>
                  <a:lnTo>
                    <a:pt x="1510" y="526"/>
                  </a:lnTo>
                  <a:lnTo>
                    <a:pt x="1538" y="603"/>
                  </a:lnTo>
                  <a:lnTo>
                    <a:pt x="1567" y="656"/>
                  </a:lnTo>
                  <a:lnTo>
                    <a:pt x="1595" y="687"/>
                  </a:lnTo>
                  <a:lnTo>
                    <a:pt x="1624" y="724"/>
                  </a:lnTo>
                  <a:lnTo>
                    <a:pt x="1652" y="776"/>
                  </a:lnTo>
                  <a:lnTo>
                    <a:pt x="1681" y="836"/>
                  </a:lnTo>
                  <a:lnTo>
                    <a:pt x="1710" y="899"/>
                  </a:lnTo>
                  <a:lnTo>
                    <a:pt x="1738" y="939"/>
                  </a:lnTo>
                  <a:lnTo>
                    <a:pt x="1766" y="967"/>
                  </a:lnTo>
                </a:path>
              </a:pathLst>
            </a:custGeom>
            <a:noFill/>
            <a:ln w="1270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7" name="Freeform 36"/>
            <p:cNvSpPr>
              <a:spLocks/>
            </p:cNvSpPr>
            <p:nvPr/>
          </p:nvSpPr>
          <p:spPr bwMode="auto">
            <a:xfrm>
              <a:off x="1185863" y="1673225"/>
              <a:ext cx="2803525" cy="1651000"/>
            </a:xfrm>
            <a:custGeom>
              <a:avLst/>
              <a:gdLst>
                <a:gd name="T0" fmla="*/ 0 w 1766"/>
                <a:gd name="T1" fmla="*/ 1040 h 1040"/>
                <a:gd name="T2" fmla="*/ 28 w 1766"/>
                <a:gd name="T3" fmla="*/ 981 h 1040"/>
                <a:gd name="T4" fmla="*/ 57 w 1766"/>
                <a:gd name="T5" fmla="*/ 888 h 1040"/>
                <a:gd name="T6" fmla="*/ 85 w 1766"/>
                <a:gd name="T7" fmla="*/ 757 h 1040"/>
                <a:gd name="T8" fmla="*/ 114 w 1766"/>
                <a:gd name="T9" fmla="*/ 602 h 1040"/>
                <a:gd name="T10" fmla="*/ 142 w 1766"/>
                <a:gd name="T11" fmla="*/ 459 h 1040"/>
                <a:gd name="T12" fmla="*/ 171 w 1766"/>
                <a:gd name="T13" fmla="*/ 367 h 1040"/>
                <a:gd name="T14" fmla="*/ 199 w 1766"/>
                <a:gd name="T15" fmla="*/ 336 h 1040"/>
                <a:gd name="T16" fmla="*/ 228 w 1766"/>
                <a:gd name="T17" fmla="*/ 322 h 1040"/>
                <a:gd name="T18" fmla="*/ 256 w 1766"/>
                <a:gd name="T19" fmla="*/ 287 h 1040"/>
                <a:gd name="T20" fmla="*/ 284 w 1766"/>
                <a:gd name="T21" fmla="*/ 226 h 1040"/>
                <a:gd name="T22" fmla="*/ 313 w 1766"/>
                <a:gd name="T23" fmla="*/ 150 h 1040"/>
                <a:gd name="T24" fmla="*/ 342 w 1766"/>
                <a:gd name="T25" fmla="*/ 100 h 1040"/>
                <a:gd name="T26" fmla="*/ 370 w 1766"/>
                <a:gd name="T27" fmla="*/ 111 h 1040"/>
                <a:gd name="T28" fmla="*/ 399 w 1766"/>
                <a:gd name="T29" fmla="*/ 150 h 1040"/>
                <a:gd name="T30" fmla="*/ 427 w 1766"/>
                <a:gd name="T31" fmla="*/ 190 h 1040"/>
                <a:gd name="T32" fmla="*/ 456 w 1766"/>
                <a:gd name="T33" fmla="*/ 218 h 1040"/>
                <a:gd name="T34" fmla="*/ 484 w 1766"/>
                <a:gd name="T35" fmla="*/ 253 h 1040"/>
                <a:gd name="T36" fmla="*/ 513 w 1766"/>
                <a:gd name="T37" fmla="*/ 296 h 1040"/>
                <a:gd name="T38" fmla="*/ 541 w 1766"/>
                <a:gd name="T39" fmla="*/ 337 h 1040"/>
                <a:gd name="T40" fmla="*/ 569 w 1766"/>
                <a:gd name="T41" fmla="*/ 386 h 1040"/>
                <a:gd name="T42" fmla="*/ 598 w 1766"/>
                <a:gd name="T43" fmla="*/ 443 h 1040"/>
                <a:gd name="T44" fmla="*/ 627 w 1766"/>
                <a:gd name="T45" fmla="*/ 513 h 1040"/>
                <a:gd name="T46" fmla="*/ 655 w 1766"/>
                <a:gd name="T47" fmla="*/ 595 h 1040"/>
                <a:gd name="T48" fmla="*/ 683 w 1766"/>
                <a:gd name="T49" fmla="*/ 668 h 1040"/>
                <a:gd name="T50" fmla="*/ 712 w 1766"/>
                <a:gd name="T51" fmla="*/ 720 h 1040"/>
                <a:gd name="T52" fmla="*/ 741 w 1766"/>
                <a:gd name="T53" fmla="*/ 748 h 1040"/>
                <a:gd name="T54" fmla="*/ 769 w 1766"/>
                <a:gd name="T55" fmla="*/ 745 h 1040"/>
                <a:gd name="T56" fmla="*/ 798 w 1766"/>
                <a:gd name="T57" fmla="*/ 717 h 1040"/>
                <a:gd name="T58" fmla="*/ 826 w 1766"/>
                <a:gd name="T59" fmla="*/ 677 h 1040"/>
                <a:gd name="T60" fmla="*/ 854 w 1766"/>
                <a:gd name="T61" fmla="*/ 625 h 1040"/>
                <a:gd name="T62" fmla="*/ 883 w 1766"/>
                <a:gd name="T63" fmla="*/ 564 h 1040"/>
                <a:gd name="T64" fmla="*/ 912 w 1766"/>
                <a:gd name="T65" fmla="*/ 517 h 1040"/>
                <a:gd name="T66" fmla="*/ 940 w 1766"/>
                <a:gd name="T67" fmla="*/ 479 h 1040"/>
                <a:gd name="T68" fmla="*/ 968 w 1766"/>
                <a:gd name="T69" fmla="*/ 437 h 1040"/>
                <a:gd name="T70" fmla="*/ 997 w 1766"/>
                <a:gd name="T71" fmla="*/ 400 h 1040"/>
                <a:gd name="T72" fmla="*/ 1026 w 1766"/>
                <a:gd name="T73" fmla="*/ 354 h 1040"/>
                <a:gd name="T74" fmla="*/ 1054 w 1766"/>
                <a:gd name="T75" fmla="*/ 289 h 1040"/>
                <a:gd name="T76" fmla="*/ 1082 w 1766"/>
                <a:gd name="T77" fmla="*/ 216 h 1040"/>
                <a:gd name="T78" fmla="*/ 1111 w 1766"/>
                <a:gd name="T79" fmla="*/ 150 h 1040"/>
                <a:gd name="T80" fmla="*/ 1140 w 1766"/>
                <a:gd name="T81" fmla="*/ 95 h 1040"/>
                <a:gd name="T82" fmla="*/ 1168 w 1766"/>
                <a:gd name="T83" fmla="*/ 50 h 1040"/>
                <a:gd name="T84" fmla="*/ 1197 w 1766"/>
                <a:gd name="T85" fmla="*/ 17 h 1040"/>
                <a:gd name="T86" fmla="*/ 1225 w 1766"/>
                <a:gd name="T87" fmla="*/ 2 h 1040"/>
                <a:gd name="T88" fmla="*/ 1253 w 1766"/>
                <a:gd name="T89" fmla="*/ 0 h 1040"/>
                <a:gd name="T90" fmla="*/ 1282 w 1766"/>
                <a:gd name="T91" fmla="*/ 16 h 1040"/>
                <a:gd name="T92" fmla="*/ 1311 w 1766"/>
                <a:gd name="T93" fmla="*/ 44 h 1040"/>
                <a:gd name="T94" fmla="*/ 1339 w 1766"/>
                <a:gd name="T95" fmla="*/ 76 h 1040"/>
                <a:gd name="T96" fmla="*/ 1367 w 1766"/>
                <a:gd name="T97" fmla="*/ 130 h 1040"/>
                <a:gd name="T98" fmla="*/ 1396 w 1766"/>
                <a:gd name="T99" fmla="*/ 211 h 1040"/>
                <a:gd name="T100" fmla="*/ 1425 w 1766"/>
                <a:gd name="T101" fmla="*/ 309 h 1040"/>
                <a:gd name="T102" fmla="*/ 1453 w 1766"/>
                <a:gd name="T103" fmla="*/ 401 h 1040"/>
                <a:gd name="T104" fmla="*/ 1481 w 1766"/>
                <a:gd name="T105" fmla="*/ 477 h 1040"/>
                <a:gd name="T106" fmla="*/ 1510 w 1766"/>
                <a:gd name="T107" fmla="*/ 558 h 1040"/>
                <a:gd name="T108" fmla="*/ 1538 w 1766"/>
                <a:gd name="T109" fmla="*/ 635 h 1040"/>
                <a:gd name="T110" fmla="*/ 1567 w 1766"/>
                <a:gd name="T111" fmla="*/ 695 h 1040"/>
                <a:gd name="T112" fmla="*/ 1595 w 1766"/>
                <a:gd name="T113" fmla="*/ 736 h 1040"/>
                <a:gd name="T114" fmla="*/ 1624 w 1766"/>
                <a:gd name="T115" fmla="*/ 775 h 1040"/>
                <a:gd name="T116" fmla="*/ 1652 w 1766"/>
                <a:gd name="T117" fmla="*/ 827 h 1040"/>
                <a:gd name="T118" fmla="*/ 1681 w 1766"/>
                <a:gd name="T119" fmla="*/ 895 h 1040"/>
                <a:gd name="T120" fmla="*/ 1710 w 1766"/>
                <a:gd name="T121" fmla="*/ 957 h 1040"/>
                <a:gd name="T122" fmla="*/ 1738 w 1766"/>
                <a:gd name="T123" fmla="*/ 1000 h 1040"/>
                <a:gd name="T124" fmla="*/ 1766 w 1766"/>
                <a:gd name="T125" fmla="*/ 1028 h 10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1766" h="1040">
                  <a:moveTo>
                    <a:pt x="0" y="1040"/>
                  </a:moveTo>
                  <a:lnTo>
                    <a:pt x="28" y="981"/>
                  </a:lnTo>
                  <a:lnTo>
                    <a:pt x="57" y="888"/>
                  </a:lnTo>
                  <a:lnTo>
                    <a:pt x="85" y="757"/>
                  </a:lnTo>
                  <a:lnTo>
                    <a:pt x="114" y="602"/>
                  </a:lnTo>
                  <a:lnTo>
                    <a:pt x="142" y="459"/>
                  </a:lnTo>
                  <a:lnTo>
                    <a:pt x="171" y="367"/>
                  </a:lnTo>
                  <a:lnTo>
                    <a:pt x="199" y="336"/>
                  </a:lnTo>
                  <a:lnTo>
                    <a:pt x="228" y="322"/>
                  </a:lnTo>
                  <a:lnTo>
                    <a:pt x="256" y="287"/>
                  </a:lnTo>
                  <a:lnTo>
                    <a:pt x="284" y="226"/>
                  </a:lnTo>
                  <a:lnTo>
                    <a:pt x="313" y="150"/>
                  </a:lnTo>
                  <a:lnTo>
                    <a:pt x="342" y="100"/>
                  </a:lnTo>
                  <a:lnTo>
                    <a:pt x="370" y="111"/>
                  </a:lnTo>
                  <a:lnTo>
                    <a:pt x="399" y="150"/>
                  </a:lnTo>
                  <a:lnTo>
                    <a:pt x="427" y="190"/>
                  </a:lnTo>
                  <a:lnTo>
                    <a:pt x="456" y="218"/>
                  </a:lnTo>
                  <a:lnTo>
                    <a:pt x="484" y="253"/>
                  </a:lnTo>
                  <a:lnTo>
                    <a:pt x="513" y="296"/>
                  </a:lnTo>
                  <a:lnTo>
                    <a:pt x="541" y="337"/>
                  </a:lnTo>
                  <a:lnTo>
                    <a:pt x="569" y="386"/>
                  </a:lnTo>
                  <a:lnTo>
                    <a:pt x="598" y="443"/>
                  </a:lnTo>
                  <a:lnTo>
                    <a:pt x="627" y="513"/>
                  </a:lnTo>
                  <a:lnTo>
                    <a:pt x="655" y="595"/>
                  </a:lnTo>
                  <a:lnTo>
                    <a:pt x="683" y="668"/>
                  </a:lnTo>
                  <a:lnTo>
                    <a:pt x="712" y="720"/>
                  </a:lnTo>
                  <a:lnTo>
                    <a:pt x="741" y="748"/>
                  </a:lnTo>
                  <a:lnTo>
                    <a:pt x="769" y="745"/>
                  </a:lnTo>
                  <a:lnTo>
                    <a:pt x="798" y="717"/>
                  </a:lnTo>
                  <a:lnTo>
                    <a:pt x="826" y="677"/>
                  </a:lnTo>
                  <a:lnTo>
                    <a:pt x="854" y="625"/>
                  </a:lnTo>
                  <a:lnTo>
                    <a:pt x="883" y="564"/>
                  </a:lnTo>
                  <a:lnTo>
                    <a:pt x="912" y="517"/>
                  </a:lnTo>
                  <a:lnTo>
                    <a:pt x="940" y="479"/>
                  </a:lnTo>
                  <a:lnTo>
                    <a:pt x="968" y="437"/>
                  </a:lnTo>
                  <a:lnTo>
                    <a:pt x="997" y="400"/>
                  </a:lnTo>
                  <a:lnTo>
                    <a:pt x="1026" y="354"/>
                  </a:lnTo>
                  <a:lnTo>
                    <a:pt x="1054" y="289"/>
                  </a:lnTo>
                  <a:lnTo>
                    <a:pt x="1082" y="216"/>
                  </a:lnTo>
                  <a:lnTo>
                    <a:pt x="1111" y="150"/>
                  </a:lnTo>
                  <a:lnTo>
                    <a:pt x="1140" y="95"/>
                  </a:lnTo>
                  <a:lnTo>
                    <a:pt x="1168" y="50"/>
                  </a:lnTo>
                  <a:lnTo>
                    <a:pt x="1197" y="17"/>
                  </a:lnTo>
                  <a:lnTo>
                    <a:pt x="1225" y="2"/>
                  </a:lnTo>
                  <a:lnTo>
                    <a:pt x="1253" y="0"/>
                  </a:lnTo>
                  <a:lnTo>
                    <a:pt x="1282" y="16"/>
                  </a:lnTo>
                  <a:lnTo>
                    <a:pt x="1311" y="44"/>
                  </a:lnTo>
                  <a:lnTo>
                    <a:pt x="1339" y="76"/>
                  </a:lnTo>
                  <a:lnTo>
                    <a:pt x="1367" y="130"/>
                  </a:lnTo>
                  <a:lnTo>
                    <a:pt x="1396" y="211"/>
                  </a:lnTo>
                  <a:lnTo>
                    <a:pt x="1425" y="309"/>
                  </a:lnTo>
                  <a:lnTo>
                    <a:pt x="1453" y="401"/>
                  </a:lnTo>
                  <a:lnTo>
                    <a:pt x="1481" y="477"/>
                  </a:lnTo>
                  <a:lnTo>
                    <a:pt x="1510" y="558"/>
                  </a:lnTo>
                  <a:lnTo>
                    <a:pt x="1538" y="635"/>
                  </a:lnTo>
                  <a:lnTo>
                    <a:pt x="1567" y="695"/>
                  </a:lnTo>
                  <a:lnTo>
                    <a:pt x="1595" y="736"/>
                  </a:lnTo>
                  <a:lnTo>
                    <a:pt x="1624" y="775"/>
                  </a:lnTo>
                  <a:lnTo>
                    <a:pt x="1652" y="827"/>
                  </a:lnTo>
                  <a:lnTo>
                    <a:pt x="1681" y="895"/>
                  </a:lnTo>
                  <a:lnTo>
                    <a:pt x="1710" y="957"/>
                  </a:lnTo>
                  <a:lnTo>
                    <a:pt x="1738" y="1000"/>
                  </a:lnTo>
                  <a:lnTo>
                    <a:pt x="1766" y="1028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</p:grpSp>
      <p:sp>
        <p:nvSpPr>
          <p:cNvPr id="28" name="ZoneTexte 19"/>
          <p:cNvSpPr txBox="1">
            <a:spLocks noChangeArrowheads="1"/>
          </p:cNvSpPr>
          <p:nvPr/>
        </p:nvSpPr>
        <p:spPr bwMode="auto">
          <a:xfrm>
            <a:off x="4076545" y="2250073"/>
            <a:ext cx="250637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1000" b="1" dirty="0" err="1">
                <a:latin typeface="Arial" pitchFamily="34" charset="0"/>
                <a:cs typeface="Arial" pitchFamily="34" charset="0"/>
              </a:rPr>
              <a:t>Wavenumbers</a:t>
            </a:r>
            <a:r>
              <a:rPr lang="en-US" sz="1000" b="1" dirty="0">
                <a:latin typeface="Arial" pitchFamily="34" charset="0"/>
                <a:cs typeface="Arial" pitchFamily="34" charset="0"/>
              </a:rPr>
              <a:t> (cm</a:t>
            </a:r>
            <a:r>
              <a:rPr lang="en-US" sz="1000" b="1" baseline="30000" dirty="0">
                <a:latin typeface="Arial" pitchFamily="34" charset="0"/>
                <a:cs typeface="Arial" pitchFamily="34" charset="0"/>
              </a:rPr>
              <a:t>-1</a:t>
            </a:r>
            <a:r>
              <a:rPr lang="en-US" sz="1000" b="1" dirty="0">
                <a:latin typeface="Arial" pitchFamily="34" charset="0"/>
                <a:cs typeface="Arial" pitchFamily="34" charset="0"/>
              </a:rPr>
              <a:t>)</a:t>
            </a:r>
          </a:p>
        </p:txBody>
      </p:sp>
      <p:sp>
        <p:nvSpPr>
          <p:cNvPr id="29" name="TextBox 59"/>
          <p:cNvSpPr txBox="1">
            <a:spLocks noChangeArrowheads="1"/>
          </p:cNvSpPr>
          <p:nvPr/>
        </p:nvSpPr>
        <p:spPr bwMode="auto">
          <a:xfrm>
            <a:off x="3477255" y="592843"/>
            <a:ext cx="338554" cy="15032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vert270"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Absorbance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0" name="组合 245"/>
          <p:cNvGrpSpPr/>
          <p:nvPr/>
        </p:nvGrpSpPr>
        <p:grpSpPr>
          <a:xfrm>
            <a:off x="3939479" y="2136217"/>
            <a:ext cx="2785232" cy="156898"/>
            <a:chOff x="3279148" y="5191705"/>
            <a:chExt cx="2785232" cy="156898"/>
          </a:xfrm>
        </p:grpSpPr>
        <p:sp>
          <p:nvSpPr>
            <p:cNvPr id="31" name="Rectangle 5"/>
            <p:cNvSpPr>
              <a:spLocks noChangeArrowheads="1"/>
            </p:cNvSpPr>
            <p:nvPr/>
          </p:nvSpPr>
          <p:spPr bwMode="auto">
            <a:xfrm>
              <a:off x="3279148" y="5194684"/>
              <a:ext cx="28212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1480</a:t>
              </a:r>
              <a:endParaRPr kumimoji="0" lang="zh-CN" altLang="zh-CN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2" name="Rectangle 5"/>
            <p:cNvSpPr>
              <a:spLocks noChangeArrowheads="1"/>
            </p:cNvSpPr>
            <p:nvPr/>
          </p:nvSpPr>
          <p:spPr bwMode="auto">
            <a:xfrm>
              <a:off x="4112515" y="5192379"/>
              <a:ext cx="28212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1440</a:t>
              </a:r>
              <a:endParaRPr kumimoji="0" lang="zh-CN" altLang="zh-CN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3" name="Rectangle 5"/>
            <p:cNvSpPr>
              <a:spLocks noChangeArrowheads="1"/>
            </p:cNvSpPr>
            <p:nvPr/>
          </p:nvSpPr>
          <p:spPr bwMode="auto">
            <a:xfrm>
              <a:off x="4947383" y="5194715"/>
              <a:ext cx="28212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1400</a:t>
              </a:r>
              <a:endParaRPr kumimoji="0" lang="zh-CN" altLang="zh-CN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4" name="Rectangle 5"/>
            <p:cNvSpPr>
              <a:spLocks noChangeArrowheads="1"/>
            </p:cNvSpPr>
            <p:nvPr/>
          </p:nvSpPr>
          <p:spPr bwMode="auto">
            <a:xfrm>
              <a:off x="5782251" y="5191705"/>
              <a:ext cx="28212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1360</a:t>
              </a:r>
              <a:endParaRPr kumimoji="0" lang="zh-CN" altLang="zh-CN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35" name="组合 250"/>
          <p:cNvGrpSpPr/>
          <p:nvPr/>
        </p:nvGrpSpPr>
        <p:grpSpPr>
          <a:xfrm>
            <a:off x="3759977" y="503373"/>
            <a:ext cx="248340" cy="1641384"/>
            <a:chOff x="3936131" y="2156825"/>
            <a:chExt cx="248340" cy="1641384"/>
          </a:xfrm>
        </p:grpSpPr>
        <p:sp>
          <p:nvSpPr>
            <p:cNvPr id="36" name="Rectangle 11"/>
            <p:cNvSpPr>
              <a:spLocks noChangeArrowheads="1"/>
            </p:cNvSpPr>
            <p:nvPr/>
          </p:nvSpPr>
          <p:spPr bwMode="auto">
            <a:xfrm>
              <a:off x="4113842" y="3644321"/>
              <a:ext cx="7053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0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Rectangle 15"/>
            <p:cNvSpPr>
              <a:spLocks noChangeArrowheads="1"/>
            </p:cNvSpPr>
            <p:nvPr/>
          </p:nvSpPr>
          <p:spPr bwMode="auto">
            <a:xfrm>
              <a:off x="3936131" y="2771477"/>
              <a:ext cx="24686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0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15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Rectangle 15"/>
            <p:cNvSpPr>
              <a:spLocks noChangeArrowheads="1"/>
            </p:cNvSpPr>
            <p:nvPr/>
          </p:nvSpPr>
          <p:spPr bwMode="auto">
            <a:xfrm>
              <a:off x="3937088" y="3068157"/>
              <a:ext cx="24686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0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10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Rectangle 15"/>
            <p:cNvSpPr>
              <a:spLocks noChangeArrowheads="1"/>
            </p:cNvSpPr>
            <p:nvPr/>
          </p:nvSpPr>
          <p:spPr bwMode="auto">
            <a:xfrm>
              <a:off x="3936131" y="2156825"/>
              <a:ext cx="24686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0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25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Rectangle 15"/>
            <p:cNvSpPr>
              <a:spLocks noChangeArrowheads="1"/>
            </p:cNvSpPr>
            <p:nvPr/>
          </p:nvSpPr>
          <p:spPr bwMode="auto">
            <a:xfrm>
              <a:off x="3936131" y="2467055"/>
              <a:ext cx="24686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0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20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Rectangle 15"/>
            <p:cNvSpPr>
              <a:spLocks noChangeArrowheads="1"/>
            </p:cNvSpPr>
            <p:nvPr/>
          </p:nvSpPr>
          <p:spPr bwMode="auto">
            <a:xfrm>
              <a:off x="3937609" y="3360167"/>
              <a:ext cx="24686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0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05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9" name="ZoneTexte 9"/>
          <p:cNvSpPr txBox="1">
            <a:spLocks noChangeArrowheads="1"/>
          </p:cNvSpPr>
          <p:nvPr/>
        </p:nvSpPr>
        <p:spPr bwMode="auto">
          <a:xfrm>
            <a:off x="687641" y="2237547"/>
            <a:ext cx="251806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1000" b="1" dirty="0">
                <a:latin typeface="Arial" pitchFamily="34" charset="0"/>
                <a:cs typeface="Arial" pitchFamily="34" charset="0"/>
              </a:rPr>
              <a:t>PC-1 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(36%)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ZoneTexte 49"/>
          <p:cNvSpPr txBox="1"/>
          <p:nvPr/>
        </p:nvSpPr>
        <p:spPr bwMode="auto">
          <a:xfrm>
            <a:off x="158640" y="577827"/>
            <a:ext cx="338554" cy="1505282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000" b="1" dirty="0">
                <a:latin typeface="Arial" pitchFamily="34" charset="0"/>
                <a:cs typeface="Arial" pitchFamily="34" charset="0"/>
              </a:rPr>
              <a:t>PC-2 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(23%)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1" name="组合 3"/>
          <p:cNvGrpSpPr/>
          <p:nvPr/>
        </p:nvGrpSpPr>
        <p:grpSpPr>
          <a:xfrm>
            <a:off x="316929" y="453677"/>
            <a:ext cx="424039" cy="1727002"/>
            <a:chOff x="317181" y="786332"/>
            <a:chExt cx="424039" cy="1727002"/>
          </a:xfrm>
        </p:grpSpPr>
        <p:sp>
          <p:nvSpPr>
            <p:cNvPr id="52" name="ZoneTexte 9"/>
            <p:cNvSpPr txBox="1">
              <a:spLocks noChangeArrowheads="1"/>
            </p:cNvSpPr>
            <p:nvPr/>
          </p:nvSpPr>
          <p:spPr bwMode="auto">
            <a:xfrm>
              <a:off x="337355" y="786332"/>
              <a:ext cx="403865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0.7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3" name="ZoneTexte 10"/>
            <p:cNvSpPr txBox="1">
              <a:spLocks noChangeArrowheads="1"/>
            </p:cNvSpPr>
            <p:nvPr/>
          </p:nvSpPr>
          <p:spPr bwMode="auto">
            <a:xfrm>
              <a:off x="484259" y="1579516"/>
              <a:ext cx="211745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>
                  <a:latin typeface="Arial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54" name="ZoneTexte 11"/>
            <p:cNvSpPr txBox="1">
              <a:spLocks noChangeArrowheads="1"/>
            </p:cNvSpPr>
            <p:nvPr/>
          </p:nvSpPr>
          <p:spPr bwMode="auto">
            <a:xfrm>
              <a:off x="317181" y="2267113"/>
              <a:ext cx="403838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-0.6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55" name="组合 13"/>
          <p:cNvGrpSpPr/>
          <p:nvPr/>
        </p:nvGrpSpPr>
        <p:grpSpPr>
          <a:xfrm>
            <a:off x="466905" y="2079702"/>
            <a:ext cx="3027578" cy="256207"/>
            <a:chOff x="49315" y="2844267"/>
            <a:chExt cx="3027578" cy="256207"/>
          </a:xfrm>
        </p:grpSpPr>
        <p:sp>
          <p:nvSpPr>
            <p:cNvPr id="56" name="ZoneTexte 3"/>
            <p:cNvSpPr txBox="1">
              <a:spLocks noChangeArrowheads="1"/>
            </p:cNvSpPr>
            <p:nvPr/>
          </p:nvSpPr>
          <p:spPr bwMode="auto">
            <a:xfrm>
              <a:off x="1880798" y="2846558"/>
              <a:ext cx="158915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>
                  <a:latin typeface="Arial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57" name="ZoneTexte 12"/>
            <p:cNvSpPr txBox="1">
              <a:spLocks noChangeArrowheads="1"/>
            </p:cNvSpPr>
            <p:nvPr/>
          </p:nvSpPr>
          <p:spPr bwMode="auto">
            <a:xfrm>
              <a:off x="2539250" y="2846558"/>
              <a:ext cx="537643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0.5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8" name="ZoneTexte 57"/>
            <p:cNvSpPr txBox="1">
              <a:spLocks noChangeArrowheads="1"/>
            </p:cNvSpPr>
            <p:nvPr/>
          </p:nvSpPr>
          <p:spPr bwMode="auto">
            <a:xfrm>
              <a:off x="49315" y="2844267"/>
              <a:ext cx="43404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-1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33" name="Groupe 232"/>
          <p:cNvGrpSpPr/>
          <p:nvPr/>
        </p:nvGrpSpPr>
        <p:grpSpPr>
          <a:xfrm>
            <a:off x="1141699" y="290665"/>
            <a:ext cx="5093965" cy="253536"/>
            <a:chOff x="1141699" y="386423"/>
            <a:chExt cx="5093965" cy="253536"/>
          </a:xfrm>
        </p:grpSpPr>
        <p:grpSp>
          <p:nvGrpSpPr>
            <p:cNvPr id="249" name="Groupe 248"/>
            <p:cNvGrpSpPr/>
            <p:nvPr/>
          </p:nvGrpSpPr>
          <p:grpSpPr>
            <a:xfrm>
              <a:off x="4417884" y="436247"/>
              <a:ext cx="1817780" cy="153888"/>
              <a:chOff x="4078001" y="414539"/>
              <a:chExt cx="1817780" cy="153888"/>
            </a:xfrm>
          </p:grpSpPr>
          <p:grpSp>
            <p:nvGrpSpPr>
              <p:cNvPr id="43" name="组合 40"/>
              <p:cNvGrpSpPr/>
              <p:nvPr/>
            </p:nvGrpSpPr>
            <p:grpSpPr>
              <a:xfrm>
                <a:off x="4078001" y="414539"/>
                <a:ext cx="889994" cy="153888"/>
                <a:chOff x="2782839" y="194450"/>
                <a:chExt cx="889994" cy="153888"/>
              </a:xfrm>
            </p:grpSpPr>
            <p:sp>
              <p:nvSpPr>
                <p:cNvPr id="47" name="Rectangle 9"/>
                <p:cNvSpPr>
                  <a:spLocks noChangeArrowheads="1"/>
                </p:cNvSpPr>
                <p:nvPr/>
              </p:nvSpPr>
              <p:spPr bwMode="auto">
                <a:xfrm>
                  <a:off x="3111782" y="194450"/>
                  <a:ext cx="561051" cy="1538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1000" b="1" dirty="0">
                      <a:solidFill>
                        <a:srgbClr val="000000"/>
                      </a:solidFill>
                      <a:latin typeface="Arial" pitchFamily="34" charset="0"/>
                      <a:cs typeface="Arial" pitchFamily="34" charset="0"/>
                    </a:rPr>
                    <a:t>Cirrhosis</a:t>
                  </a:r>
                  <a:endParaRPr lang="en-US" sz="14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8" name="Line 10"/>
                <p:cNvSpPr>
                  <a:spLocks noChangeShapeType="1"/>
                </p:cNvSpPr>
                <p:nvPr/>
              </p:nvSpPr>
              <p:spPr bwMode="auto">
                <a:xfrm>
                  <a:off x="2782839" y="271394"/>
                  <a:ext cx="274321" cy="0"/>
                </a:xfrm>
                <a:prstGeom prst="line">
                  <a:avLst/>
                </a:prstGeom>
                <a:noFill/>
                <a:ln w="15875">
                  <a:solidFill>
                    <a:srgbClr val="0000FF"/>
                  </a:solidFill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</p:grpSp>
          <p:grpSp>
            <p:nvGrpSpPr>
              <p:cNvPr id="44" name="组合 31"/>
              <p:cNvGrpSpPr/>
              <p:nvPr/>
            </p:nvGrpSpPr>
            <p:grpSpPr>
              <a:xfrm>
                <a:off x="5231185" y="414539"/>
                <a:ext cx="664596" cy="153888"/>
                <a:chOff x="2485964" y="354055"/>
                <a:chExt cx="664596" cy="153888"/>
              </a:xfrm>
            </p:grpSpPr>
            <p:sp>
              <p:nvSpPr>
                <p:cNvPr id="45" name="Rectangle 13"/>
                <p:cNvSpPr>
                  <a:spLocks noChangeArrowheads="1"/>
                </p:cNvSpPr>
                <p:nvPr/>
              </p:nvSpPr>
              <p:spPr bwMode="auto">
                <a:xfrm>
                  <a:off x="2814908" y="354055"/>
                  <a:ext cx="335652" cy="1538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 lIns="0" tIns="0" rIns="0" bIns="0">
                  <a:spAutoFit/>
                </a:bodyPr>
                <a:lstStyle/>
                <a:p>
                  <a:r>
                    <a:rPr lang="en-US" sz="1000" b="1" dirty="0" smtClean="0">
                      <a:latin typeface="Arial" pitchFamily="34" charset="0"/>
                      <a:cs typeface="Arial" pitchFamily="34" charset="0"/>
                    </a:rPr>
                    <a:t>DN</a:t>
                  </a:r>
                  <a:endParaRPr lang="en-US" sz="10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6" name="Line 14"/>
                <p:cNvSpPr>
                  <a:spLocks noChangeShapeType="1"/>
                </p:cNvSpPr>
                <p:nvPr/>
              </p:nvSpPr>
              <p:spPr bwMode="auto">
                <a:xfrm>
                  <a:off x="2485964" y="430999"/>
                  <a:ext cx="274320" cy="0"/>
                </a:xfrm>
                <a:prstGeom prst="line">
                  <a:avLst/>
                </a:prstGeom>
                <a:noFill/>
                <a:ln w="15875" cmpd="sng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</p:grpSp>
        </p:grpSp>
        <p:grpSp>
          <p:nvGrpSpPr>
            <p:cNvPr id="248" name="Groupe 247"/>
            <p:cNvGrpSpPr/>
            <p:nvPr/>
          </p:nvGrpSpPr>
          <p:grpSpPr>
            <a:xfrm>
              <a:off x="1141699" y="386423"/>
              <a:ext cx="1646948" cy="253536"/>
              <a:chOff x="1093059" y="368373"/>
              <a:chExt cx="1646948" cy="253536"/>
            </a:xfrm>
          </p:grpSpPr>
          <p:grpSp>
            <p:nvGrpSpPr>
              <p:cNvPr id="64" name="组合 12"/>
              <p:cNvGrpSpPr/>
              <p:nvPr/>
            </p:nvGrpSpPr>
            <p:grpSpPr>
              <a:xfrm>
                <a:off x="1093059" y="368373"/>
                <a:ext cx="900748" cy="246221"/>
                <a:chOff x="770172" y="59947"/>
                <a:chExt cx="900748" cy="246221"/>
              </a:xfrm>
            </p:grpSpPr>
            <p:sp>
              <p:nvSpPr>
                <p:cNvPr id="68" name="ZoneTexte 10208"/>
                <p:cNvSpPr txBox="1">
                  <a:spLocks noChangeArrowheads="1"/>
                </p:cNvSpPr>
                <p:nvPr/>
              </p:nvSpPr>
              <p:spPr bwMode="auto">
                <a:xfrm>
                  <a:off x="843084" y="59947"/>
                  <a:ext cx="827836" cy="24622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sz="1000" b="1" dirty="0">
                      <a:latin typeface="Arial" pitchFamily="34" charset="0"/>
                      <a:cs typeface="Arial" pitchFamily="34" charset="0"/>
                    </a:rPr>
                    <a:t>Cirrhosis</a:t>
                  </a:r>
                </a:p>
              </p:txBody>
            </p:sp>
            <p:sp>
              <p:nvSpPr>
                <p:cNvPr id="69" name="Oval 12"/>
                <p:cNvSpPr>
                  <a:spLocks noChangeArrowheads="1"/>
                </p:cNvSpPr>
                <p:nvPr/>
              </p:nvSpPr>
              <p:spPr bwMode="auto">
                <a:xfrm>
                  <a:off x="770172" y="134980"/>
                  <a:ext cx="91440" cy="91440"/>
                </a:xfrm>
                <a:prstGeom prst="ellipse">
                  <a:avLst/>
                </a:prstGeom>
                <a:solidFill>
                  <a:srgbClr val="3333FF"/>
                </a:solidFill>
                <a:ln w="0">
                  <a:solidFill>
                    <a:srgbClr val="0070C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>
                    <a:latin typeface="Calibri" pitchFamily="34" charset="0"/>
                  </a:endParaRPr>
                </a:p>
              </p:txBody>
            </p:sp>
          </p:grpSp>
          <p:grpSp>
            <p:nvGrpSpPr>
              <p:cNvPr id="65" name="组合 21"/>
              <p:cNvGrpSpPr/>
              <p:nvPr/>
            </p:nvGrpSpPr>
            <p:grpSpPr>
              <a:xfrm>
                <a:off x="2260527" y="375688"/>
                <a:ext cx="479480" cy="246221"/>
                <a:chOff x="847996" y="240093"/>
                <a:chExt cx="479480" cy="246221"/>
              </a:xfrm>
            </p:grpSpPr>
            <p:sp>
              <p:nvSpPr>
                <p:cNvPr id="66" name="ZoneTexte 10210"/>
                <p:cNvSpPr txBox="1">
                  <a:spLocks noChangeArrowheads="1"/>
                </p:cNvSpPr>
                <p:nvPr/>
              </p:nvSpPr>
              <p:spPr bwMode="auto">
                <a:xfrm>
                  <a:off x="920907" y="240093"/>
                  <a:ext cx="406569" cy="24622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fontAlgn="ctr"/>
                  <a:r>
                    <a:rPr lang="en-US" sz="1000" b="1" dirty="0" smtClean="0">
                      <a:latin typeface="Arial" pitchFamily="34" charset="0"/>
                      <a:cs typeface="Arial" pitchFamily="34" charset="0"/>
                    </a:rPr>
                    <a:t>DN</a:t>
                  </a:r>
                  <a:endParaRPr lang="en-US" sz="10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7" name="Oval 12"/>
                <p:cNvSpPr>
                  <a:spLocks noChangeArrowheads="1"/>
                </p:cNvSpPr>
                <p:nvPr/>
              </p:nvSpPr>
              <p:spPr bwMode="auto">
                <a:xfrm>
                  <a:off x="847996" y="310168"/>
                  <a:ext cx="91440" cy="91440"/>
                </a:xfrm>
                <a:prstGeom prst="ellipse">
                  <a:avLst/>
                </a:prstGeom>
                <a:solidFill>
                  <a:schemeClr val="tx1"/>
                </a:solidFill>
                <a:ln w="0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>
                    <a:latin typeface="Calibri" pitchFamily="34" charset="0"/>
                  </a:endParaRPr>
                </a:p>
              </p:txBody>
            </p:sp>
          </p:grpSp>
        </p:grpSp>
      </p:grpSp>
      <p:grpSp>
        <p:nvGrpSpPr>
          <p:cNvPr id="131" name="组合 17"/>
          <p:cNvGrpSpPr/>
          <p:nvPr/>
        </p:nvGrpSpPr>
        <p:grpSpPr>
          <a:xfrm>
            <a:off x="296401" y="2472630"/>
            <a:ext cx="462603" cy="1725627"/>
            <a:chOff x="423394" y="3527147"/>
            <a:chExt cx="462603" cy="1725627"/>
          </a:xfrm>
        </p:grpSpPr>
        <p:sp>
          <p:nvSpPr>
            <p:cNvPr id="132" name="ZoneTexte 9"/>
            <p:cNvSpPr txBox="1">
              <a:spLocks noChangeArrowheads="1"/>
            </p:cNvSpPr>
            <p:nvPr/>
          </p:nvSpPr>
          <p:spPr bwMode="auto">
            <a:xfrm>
              <a:off x="435317" y="3527147"/>
              <a:ext cx="45068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0.4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3" name="ZoneTexte 10"/>
            <p:cNvSpPr txBox="1">
              <a:spLocks noChangeArrowheads="1"/>
            </p:cNvSpPr>
            <p:nvPr/>
          </p:nvSpPr>
          <p:spPr bwMode="auto">
            <a:xfrm>
              <a:off x="607205" y="4255561"/>
              <a:ext cx="211745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>
                  <a:latin typeface="Arial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134" name="ZoneTexte 11"/>
            <p:cNvSpPr txBox="1">
              <a:spLocks noChangeArrowheads="1"/>
            </p:cNvSpPr>
            <p:nvPr/>
          </p:nvSpPr>
          <p:spPr bwMode="auto">
            <a:xfrm>
              <a:off x="423394" y="5006553"/>
              <a:ext cx="43404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-0.4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34" name="ZoneTexte 19"/>
          <p:cNvSpPr txBox="1">
            <a:spLocks noChangeArrowheads="1"/>
          </p:cNvSpPr>
          <p:nvPr/>
        </p:nvSpPr>
        <p:spPr bwMode="auto">
          <a:xfrm>
            <a:off x="80814" y="4531930"/>
            <a:ext cx="32385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sz="2000" dirty="0" smtClean="0">
                <a:latin typeface="Arial" pitchFamily="34" charset="0"/>
                <a:cs typeface="Arial" pitchFamily="34" charset="0"/>
              </a:rPr>
              <a:t>I</a:t>
            </a:r>
            <a:endParaRPr lang="en-US" sz="2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5" name="ZoneTexte 19"/>
          <p:cNvSpPr txBox="1">
            <a:spLocks noChangeArrowheads="1"/>
          </p:cNvSpPr>
          <p:nvPr/>
        </p:nvSpPr>
        <p:spPr bwMode="auto">
          <a:xfrm>
            <a:off x="80814" y="78609"/>
            <a:ext cx="32385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sz="2000" dirty="0" smtClean="0">
                <a:latin typeface="Arial" pitchFamily="34" charset="0"/>
                <a:cs typeface="Arial" pitchFamily="34" charset="0"/>
              </a:rPr>
              <a:t>E</a:t>
            </a:r>
            <a:endParaRPr lang="en-US" sz="20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36" name="Picture 6"/>
          <p:cNvPicPr preferRelativeResize="0">
            <a:picLocks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550980" y="4968259"/>
            <a:ext cx="2743200" cy="16459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37" name="Picture 3"/>
          <p:cNvPicPr preferRelativeResize="0">
            <a:picLocks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545814" y="6980023"/>
            <a:ext cx="2743200" cy="16459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39" name="ZoneTexte 9"/>
          <p:cNvSpPr txBox="1">
            <a:spLocks noChangeArrowheads="1"/>
          </p:cNvSpPr>
          <p:nvPr/>
        </p:nvSpPr>
        <p:spPr bwMode="auto">
          <a:xfrm>
            <a:off x="661463" y="8715972"/>
            <a:ext cx="2518064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1000" b="1" dirty="0">
                <a:latin typeface="Arial" pitchFamily="34" charset="0"/>
                <a:cs typeface="Arial" pitchFamily="34" charset="0"/>
              </a:rPr>
              <a:t>PC-1 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(78%)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1" name="ZoneTexte 240"/>
          <p:cNvSpPr txBox="1"/>
          <p:nvPr/>
        </p:nvSpPr>
        <p:spPr bwMode="auto">
          <a:xfrm>
            <a:off x="134812" y="7076174"/>
            <a:ext cx="338554" cy="1463293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000" b="1" dirty="0">
                <a:latin typeface="Arial" pitchFamily="34" charset="0"/>
                <a:cs typeface="Arial" pitchFamily="34" charset="0"/>
              </a:rPr>
              <a:t>PC-2 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(19%)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42" name="组合 18"/>
          <p:cNvGrpSpPr/>
          <p:nvPr/>
        </p:nvGrpSpPr>
        <p:grpSpPr>
          <a:xfrm>
            <a:off x="444801" y="8559735"/>
            <a:ext cx="3010136" cy="256736"/>
            <a:chOff x="81618" y="4806468"/>
            <a:chExt cx="3010136" cy="256736"/>
          </a:xfrm>
        </p:grpSpPr>
        <p:sp>
          <p:nvSpPr>
            <p:cNvPr id="243" name="ZoneTexte 3"/>
            <p:cNvSpPr txBox="1">
              <a:spLocks noChangeArrowheads="1"/>
            </p:cNvSpPr>
            <p:nvPr/>
          </p:nvSpPr>
          <p:spPr bwMode="auto">
            <a:xfrm>
              <a:off x="1241988" y="4809288"/>
              <a:ext cx="158915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>
                  <a:latin typeface="Arial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244" name="ZoneTexte 243"/>
            <p:cNvSpPr txBox="1">
              <a:spLocks noChangeArrowheads="1"/>
            </p:cNvSpPr>
            <p:nvPr/>
          </p:nvSpPr>
          <p:spPr bwMode="auto">
            <a:xfrm>
              <a:off x="2554111" y="4810840"/>
              <a:ext cx="537643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0.6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5" name="ZoneTexte 244"/>
            <p:cNvSpPr txBox="1">
              <a:spLocks noChangeArrowheads="1"/>
            </p:cNvSpPr>
            <p:nvPr/>
          </p:nvSpPr>
          <p:spPr bwMode="auto">
            <a:xfrm>
              <a:off x="81618" y="4806468"/>
              <a:ext cx="43404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-0.4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46" name="ZoneTexte 19"/>
          <p:cNvSpPr txBox="1">
            <a:spLocks noChangeArrowheads="1"/>
          </p:cNvSpPr>
          <p:nvPr/>
        </p:nvSpPr>
        <p:spPr bwMode="auto">
          <a:xfrm>
            <a:off x="4038767" y="8718267"/>
            <a:ext cx="251899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1000" b="1" dirty="0" err="1">
                <a:latin typeface="Arial" pitchFamily="34" charset="0"/>
                <a:cs typeface="Arial" pitchFamily="34" charset="0"/>
              </a:rPr>
              <a:t>Wavenumbers</a:t>
            </a:r>
            <a:r>
              <a:rPr lang="en-US" sz="1000" b="1" dirty="0">
                <a:latin typeface="Arial" pitchFamily="34" charset="0"/>
                <a:cs typeface="Arial" pitchFamily="34" charset="0"/>
              </a:rPr>
              <a:t> (cm</a:t>
            </a:r>
            <a:r>
              <a:rPr lang="en-US" sz="1000" b="1" baseline="30000" dirty="0">
                <a:latin typeface="Arial" pitchFamily="34" charset="0"/>
                <a:cs typeface="Arial" pitchFamily="34" charset="0"/>
              </a:rPr>
              <a:t>-1</a:t>
            </a:r>
            <a:r>
              <a:rPr lang="en-US" sz="1000" b="1" dirty="0">
                <a:latin typeface="Arial" pitchFamily="34" charset="0"/>
                <a:cs typeface="Arial" pitchFamily="34" charset="0"/>
              </a:rPr>
              <a:t>)</a:t>
            </a:r>
          </a:p>
        </p:txBody>
      </p:sp>
      <p:sp>
        <p:nvSpPr>
          <p:cNvPr id="247" name="TextBox 59"/>
          <p:cNvSpPr txBox="1">
            <a:spLocks noChangeArrowheads="1"/>
          </p:cNvSpPr>
          <p:nvPr/>
        </p:nvSpPr>
        <p:spPr bwMode="auto">
          <a:xfrm>
            <a:off x="3463179" y="7088700"/>
            <a:ext cx="338554" cy="148356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vert270"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Absorbance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0" name="Line 14"/>
          <p:cNvSpPr>
            <a:spLocks noChangeShapeType="1"/>
          </p:cNvSpPr>
          <p:nvPr/>
        </p:nvSpPr>
        <p:spPr bwMode="auto">
          <a:xfrm flipV="1">
            <a:off x="4045713" y="8547562"/>
            <a:ext cx="0" cy="30336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251" name="Line 15"/>
          <p:cNvSpPr>
            <a:spLocks noChangeShapeType="1"/>
          </p:cNvSpPr>
          <p:nvPr/>
        </p:nvSpPr>
        <p:spPr bwMode="auto">
          <a:xfrm flipV="1">
            <a:off x="4465018" y="8547562"/>
            <a:ext cx="0" cy="1573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252" name="Line 16"/>
          <p:cNvSpPr>
            <a:spLocks noChangeShapeType="1"/>
          </p:cNvSpPr>
          <p:nvPr/>
        </p:nvSpPr>
        <p:spPr bwMode="auto">
          <a:xfrm flipV="1">
            <a:off x="4882925" y="8547562"/>
            <a:ext cx="0" cy="30336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253" name="Line 17"/>
          <p:cNvSpPr>
            <a:spLocks noChangeShapeType="1"/>
          </p:cNvSpPr>
          <p:nvPr/>
        </p:nvSpPr>
        <p:spPr bwMode="auto">
          <a:xfrm flipV="1">
            <a:off x="5302230" y="8547562"/>
            <a:ext cx="0" cy="1573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254" name="Line 18"/>
          <p:cNvSpPr>
            <a:spLocks noChangeShapeType="1"/>
          </p:cNvSpPr>
          <p:nvPr/>
        </p:nvSpPr>
        <p:spPr bwMode="auto">
          <a:xfrm flipV="1">
            <a:off x="5721535" y="8547562"/>
            <a:ext cx="0" cy="30336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255" name="Line 19"/>
          <p:cNvSpPr>
            <a:spLocks noChangeShapeType="1"/>
          </p:cNvSpPr>
          <p:nvPr/>
        </p:nvSpPr>
        <p:spPr bwMode="auto">
          <a:xfrm flipV="1">
            <a:off x="6139443" y="8547562"/>
            <a:ext cx="0" cy="1573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256" name="Line 20"/>
          <p:cNvSpPr>
            <a:spLocks noChangeShapeType="1"/>
          </p:cNvSpPr>
          <p:nvPr/>
        </p:nvSpPr>
        <p:spPr bwMode="auto">
          <a:xfrm flipV="1">
            <a:off x="6558748" y="8547562"/>
            <a:ext cx="0" cy="30336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257" name="Line 21"/>
          <p:cNvSpPr>
            <a:spLocks noChangeShapeType="1"/>
          </p:cNvSpPr>
          <p:nvPr/>
        </p:nvSpPr>
        <p:spPr bwMode="auto">
          <a:xfrm>
            <a:off x="4045713" y="8547562"/>
            <a:ext cx="2513035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258" name="Line 22"/>
          <p:cNvSpPr>
            <a:spLocks noChangeShapeType="1"/>
          </p:cNvSpPr>
          <p:nvPr/>
        </p:nvSpPr>
        <p:spPr bwMode="auto">
          <a:xfrm>
            <a:off x="4009373" y="8547562"/>
            <a:ext cx="36340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259" name="Line 23"/>
          <p:cNvSpPr>
            <a:spLocks noChangeShapeType="1"/>
          </p:cNvSpPr>
          <p:nvPr/>
        </p:nvSpPr>
        <p:spPr bwMode="auto">
          <a:xfrm>
            <a:off x="4027542" y="8362178"/>
            <a:ext cx="18170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260" name="Line 24"/>
          <p:cNvSpPr>
            <a:spLocks noChangeShapeType="1"/>
          </p:cNvSpPr>
          <p:nvPr/>
        </p:nvSpPr>
        <p:spPr bwMode="auto">
          <a:xfrm>
            <a:off x="4009373" y="8175670"/>
            <a:ext cx="36340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261" name="Line 25"/>
          <p:cNvSpPr>
            <a:spLocks noChangeShapeType="1"/>
          </p:cNvSpPr>
          <p:nvPr/>
        </p:nvSpPr>
        <p:spPr bwMode="auto">
          <a:xfrm>
            <a:off x="4027542" y="7990286"/>
            <a:ext cx="18170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262" name="Line 26"/>
          <p:cNvSpPr>
            <a:spLocks noChangeShapeType="1"/>
          </p:cNvSpPr>
          <p:nvPr/>
        </p:nvSpPr>
        <p:spPr bwMode="auto">
          <a:xfrm>
            <a:off x="4009373" y="7803778"/>
            <a:ext cx="36340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263" name="Line 27"/>
          <p:cNvSpPr>
            <a:spLocks noChangeShapeType="1"/>
          </p:cNvSpPr>
          <p:nvPr/>
        </p:nvSpPr>
        <p:spPr bwMode="auto">
          <a:xfrm>
            <a:off x="4027542" y="7617270"/>
            <a:ext cx="18170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264" name="Line 28"/>
          <p:cNvSpPr>
            <a:spLocks noChangeShapeType="1"/>
          </p:cNvSpPr>
          <p:nvPr/>
        </p:nvSpPr>
        <p:spPr bwMode="auto">
          <a:xfrm>
            <a:off x="4009373" y="7431886"/>
            <a:ext cx="36340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265" name="Line 29"/>
          <p:cNvSpPr>
            <a:spLocks noChangeShapeType="1"/>
          </p:cNvSpPr>
          <p:nvPr/>
        </p:nvSpPr>
        <p:spPr bwMode="auto">
          <a:xfrm>
            <a:off x="4027542" y="7246502"/>
            <a:ext cx="18170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266" name="Line 30"/>
          <p:cNvSpPr>
            <a:spLocks noChangeShapeType="1"/>
          </p:cNvSpPr>
          <p:nvPr/>
        </p:nvSpPr>
        <p:spPr bwMode="auto">
          <a:xfrm>
            <a:off x="4009373" y="7059994"/>
            <a:ext cx="36340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267" name="Line 31"/>
          <p:cNvSpPr>
            <a:spLocks noChangeShapeType="1"/>
          </p:cNvSpPr>
          <p:nvPr/>
        </p:nvSpPr>
        <p:spPr bwMode="auto">
          <a:xfrm flipV="1">
            <a:off x="4045713" y="7059994"/>
            <a:ext cx="0" cy="1487568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grpSp>
        <p:nvGrpSpPr>
          <p:cNvPr id="268" name="组合 324"/>
          <p:cNvGrpSpPr/>
          <p:nvPr/>
        </p:nvGrpSpPr>
        <p:grpSpPr>
          <a:xfrm>
            <a:off x="3794732" y="6995731"/>
            <a:ext cx="183172" cy="1633816"/>
            <a:chOff x="3918564" y="717941"/>
            <a:chExt cx="136539" cy="3720859"/>
          </a:xfrm>
        </p:grpSpPr>
        <p:sp>
          <p:nvSpPr>
            <p:cNvPr id="269" name="Rectangle 11"/>
            <p:cNvSpPr>
              <a:spLocks noChangeArrowheads="1"/>
            </p:cNvSpPr>
            <p:nvPr/>
          </p:nvSpPr>
          <p:spPr bwMode="auto">
            <a:xfrm>
              <a:off x="4000392" y="4088335"/>
              <a:ext cx="52575" cy="3504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0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0" name="Rectangle 15"/>
            <p:cNvSpPr>
              <a:spLocks noChangeArrowheads="1"/>
            </p:cNvSpPr>
            <p:nvPr/>
          </p:nvSpPr>
          <p:spPr bwMode="auto">
            <a:xfrm>
              <a:off x="3923177" y="1611089"/>
              <a:ext cx="131439" cy="3504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0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3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1" name="Rectangle 15"/>
            <p:cNvSpPr>
              <a:spLocks noChangeArrowheads="1"/>
            </p:cNvSpPr>
            <p:nvPr/>
          </p:nvSpPr>
          <p:spPr bwMode="auto">
            <a:xfrm>
              <a:off x="3918584" y="2368066"/>
              <a:ext cx="131438" cy="3504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0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2" name="Rectangle 15"/>
            <p:cNvSpPr>
              <a:spLocks noChangeArrowheads="1"/>
            </p:cNvSpPr>
            <p:nvPr/>
          </p:nvSpPr>
          <p:spPr bwMode="auto">
            <a:xfrm>
              <a:off x="3923664" y="717941"/>
              <a:ext cx="131439" cy="3504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0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3" name="Rectangle 15"/>
            <p:cNvSpPr>
              <a:spLocks noChangeArrowheads="1"/>
            </p:cNvSpPr>
            <p:nvPr/>
          </p:nvSpPr>
          <p:spPr bwMode="auto">
            <a:xfrm>
              <a:off x="3918564" y="3229906"/>
              <a:ext cx="131438" cy="3504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0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74" name="组合 331"/>
          <p:cNvGrpSpPr/>
          <p:nvPr/>
        </p:nvGrpSpPr>
        <p:grpSpPr>
          <a:xfrm>
            <a:off x="3900154" y="8610043"/>
            <a:ext cx="2797795" cy="163756"/>
            <a:chOff x="3611822" y="4999408"/>
            <a:chExt cx="2085502" cy="372936"/>
          </a:xfrm>
        </p:grpSpPr>
        <p:sp>
          <p:nvSpPr>
            <p:cNvPr id="275" name="Rectangle 5"/>
            <p:cNvSpPr>
              <a:spLocks noChangeArrowheads="1"/>
            </p:cNvSpPr>
            <p:nvPr/>
          </p:nvSpPr>
          <p:spPr bwMode="auto">
            <a:xfrm>
              <a:off x="3611822" y="4999659"/>
              <a:ext cx="210302" cy="3504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1480</a:t>
              </a:r>
              <a:endParaRPr kumimoji="0" lang="zh-CN" altLang="zh-CN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76" name="Rectangle 5"/>
            <p:cNvSpPr>
              <a:spLocks noChangeArrowheads="1"/>
            </p:cNvSpPr>
            <p:nvPr/>
          </p:nvSpPr>
          <p:spPr bwMode="auto">
            <a:xfrm>
              <a:off x="4241373" y="5005988"/>
              <a:ext cx="210302" cy="3504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1440</a:t>
              </a:r>
              <a:endParaRPr kumimoji="0" lang="zh-CN" altLang="zh-CN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77" name="Rectangle 5"/>
            <p:cNvSpPr>
              <a:spLocks noChangeArrowheads="1"/>
            </p:cNvSpPr>
            <p:nvPr/>
          </p:nvSpPr>
          <p:spPr bwMode="auto">
            <a:xfrm>
              <a:off x="4864198" y="4999408"/>
              <a:ext cx="210302" cy="3504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1400</a:t>
              </a:r>
              <a:endParaRPr kumimoji="0" lang="zh-CN" altLang="zh-CN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78" name="Rectangle 5"/>
            <p:cNvSpPr>
              <a:spLocks noChangeArrowheads="1"/>
            </p:cNvSpPr>
            <p:nvPr/>
          </p:nvSpPr>
          <p:spPr bwMode="auto">
            <a:xfrm>
              <a:off x="5487022" y="5021879"/>
              <a:ext cx="210302" cy="3504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1360</a:t>
              </a:r>
              <a:endParaRPr kumimoji="0" lang="zh-CN" altLang="zh-CN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sp>
        <p:nvSpPr>
          <p:cNvPr id="279" name="Line 15"/>
          <p:cNvSpPr>
            <a:spLocks noChangeShapeType="1"/>
          </p:cNvSpPr>
          <p:nvPr/>
        </p:nvSpPr>
        <p:spPr bwMode="auto">
          <a:xfrm flipV="1">
            <a:off x="4047975" y="6542142"/>
            <a:ext cx="0" cy="29718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280" name="Line 16"/>
          <p:cNvSpPr>
            <a:spLocks noChangeShapeType="1"/>
          </p:cNvSpPr>
          <p:nvPr/>
        </p:nvSpPr>
        <p:spPr bwMode="auto">
          <a:xfrm flipV="1">
            <a:off x="4465810" y="6542142"/>
            <a:ext cx="0" cy="14859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281" name="Line 17"/>
          <p:cNvSpPr>
            <a:spLocks noChangeShapeType="1"/>
          </p:cNvSpPr>
          <p:nvPr/>
        </p:nvSpPr>
        <p:spPr bwMode="auto">
          <a:xfrm flipV="1">
            <a:off x="4885061" y="6542142"/>
            <a:ext cx="0" cy="29718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282" name="Line 18"/>
          <p:cNvSpPr>
            <a:spLocks noChangeShapeType="1"/>
          </p:cNvSpPr>
          <p:nvPr/>
        </p:nvSpPr>
        <p:spPr bwMode="auto">
          <a:xfrm flipV="1">
            <a:off x="5302896" y="6542142"/>
            <a:ext cx="0" cy="14859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283" name="Line 19"/>
          <p:cNvSpPr>
            <a:spLocks noChangeShapeType="1"/>
          </p:cNvSpPr>
          <p:nvPr/>
        </p:nvSpPr>
        <p:spPr bwMode="auto">
          <a:xfrm flipV="1">
            <a:off x="5722148" y="6542142"/>
            <a:ext cx="0" cy="29718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284" name="Line 20"/>
          <p:cNvSpPr>
            <a:spLocks noChangeShapeType="1"/>
          </p:cNvSpPr>
          <p:nvPr/>
        </p:nvSpPr>
        <p:spPr bwMode="auto">
          <a:xfrm flipV="1">
            <a:off x="6141399" y="6542142"/>
            <a:ext cx="0" cy="14859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285" name="Line 21"/>
          <p:cNvSpPr>
            <a:spLocks noChangeShapeType="1"/>
          </p:cNvSpPr>
          <p:nvPr/>
        </p:nvSpPr>
        <p:spPr bwMode="auto">
          <a:xfrm flipV="1">
            <a:off x="6559234" y="6542142"/>
            <a:ext cx="0" cy="29718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286" name="Line 22"/>
          <p:cNvSpPr>
            <a:spLocks noChangeShapeType="1"/>
          </p:cNvSpPr>
          <p:nvPr/>
        </p:nvSpPr>
        <p:spPr bwMode="auto">
          <a:xfrm>
            <a:off x="4047975" y="6542142"/>
            <a:ext cx="2511260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287" name="Line 23"/>
          <p:cNvSpPr>
            <a:spLocks noChangeShapeType="1"/>
          </p:cNvSpPr>
          <p:nvPr/>
        </p:nvSpPr>
        <p:spPr bwMode="auto">
          <a:xfrm>
            <a:off x="4009732" y="6542142"/>
            <a:ext cx="38243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288" name="Line 24"/>
          <p:cNvSpPr>
            <a:spLocks noChangeShapeType="1"/>
          </p:cNvSpPr>
          <p:nvPr/>
        </p:nvSpPr>
        <p:spPr bwMode="auto">
          <a:xfrm>
            <a:off x="4029561" y="6392409"/>
            <a:ext cx="18414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289" name="Line 25"/>
          <p:cNvSpPr>
            <a:spLocks noChangeShapeType="1"/>
          </p:cNvSpPr>
          <p:nvPr/>
        </p:nvSpPr>
        <p:spPr bwMode="auto">
          <a:xfrm>
            <a:off x="4009732" y="6242676"/>
            <a:ext cx="38243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290" name="Line 26"/>
          <p:cNvSpPr>
            <a:spLocks noChangeShapeType="1"/>
          </p:cNvSpPr>
          <p:nvPr/>
        </p:nvSpPr>
        <p:spPr bwMode="auto">
          <a:xfrm>
            <a:off x="4029561" y="6092943"/>
            <a:ext cx="18414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291" name="Line 27"/>
          <p:cNvSpPr>
            <a:spLocks noChangeShapeType="1"/>
          </p:cNvSpPr>
          <p:nvPr/>
        </p:nvSpPr>
        <p:spPr bwMode="auto">
          <a:xfrm>
            <a:off x="4009732" y="5943210"/>
            <a:ext cx="38243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292" name="Line 28"/>
          <p:cNvSpPr>
            <a:spLocks noChangeShapeType="1"/>
          </p:cNvSpPr>
          <p:nvPr/>
        </p:nvSpPr>
        <p:spPr bwMode="auto">
          <a:xfrm>
            <a:off x="4029561" y="5793477"/>
            <a:ext cx="18414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293" name="Line 29"/>
          <p:cNvSpPr>
            <a:spLocks noChangeShapeType="1"/>
          </p:cNvSpPr>
          <p:nvPr/>
        </p:nvSpPr>
        <p:spPr bwMode="auto">
          <a:xfrm>
            <a:off x="4009732" y="5643744"/>
            <a:ext cx="38243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294" name="Line 30"/>
          <p:cNvSpPr>
            <a:spLocks noChangeShapeType="1"/>
          </p:cNvSpPr>
          <p:nvPr/>
        </p:nvSpPr>
        <p:spPr bwMode="auto">
          <a:xfrm>
            <a:off x="4029561" y="5494011"/>
            <a:ext cx="18414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295" name="Line 31"/>
          <p:cNvSpPr>
            <a:spLocks noChangeShapeType="1"/>
          </p:cNvSpPr>
          <p:nvPr/>
        </p:nvSpPr>
        <p:spPr bwMode="auto">
          <a:xfrm>
            <a:off x="4009732" y="5344278"/>
            <a:ext cx="38243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296" name="Line 32"/>
          <p:cNvSpPr>
            <a:spLocks noChangeShapeType="1"/>
          </p:cNvSpPr>
          <p:nvPr/>
        </p:nvSpPr>
        <p:spPr bwMode="auto">
          <a:xfrm>
            <a:off x="4029561" y="5194545"/>
            <a:ext cx="18414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297" name="Line 33"/>
          <p:cNvSpPr>
            <a:spLocks noChangeShapeType="1"/>
          </p:cNvSpPr>
          <p:nvPr/>
        </p:nvSpPr>
        <p:spPr bwMode="auto">
          <a:xfrm>
            <a:off x="4009732" y="5044812"/>
            <a:ext cx="38243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298" name="Line 34"/>
          <p:cNvSpPr>
            <a:spLocks noChangeShapeType="1"/>
          </p:cNvSpPr>
          <p:nvPr/>
        </p:nvSpPr>
        <p:spPr bwMode="auto">
          <a:xfrm flipV="1">
            <a:off x="4047975" y="5044812"/>
            <a:ext cx="0" cy="149733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299" name="ZoneTexte 19"/>
          <p:cNvSpPr txBox="1">
            <a:spLocks noChangeArrowheads="1"/>
          </p:cNvSpPr>
          <p:nvPr/>
        </p:nvSpPr>
        <p:spPr bwMode="auto">
          <a:xfrm>
            <a:off x="4052446" y="6714569"/>
            <a:ext cx="250637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1000" b="1" dirty="0" err="1">
                <a:latin typeface="Arial" pitchFamily="34" charset="0"/>
                <a:cs typeface="Arial" pitchFamily="34" charset="0"/>
              </a:rPr>
              <a:t>Wavenumbers</a:t>
            </a:r>
            <a:r>
              <a:rPr lang="en-US" sz="1000" b="1" dirty="0">
                <a:latin typeface="Arial" pitchFamily="34" charset="0"/>
                <a:cs typeface="Arial" pitchFamily="34" charset="0"/>
              </a:rPr>
              <a:t> (cm</a:t>
            </a:r>
            <a:r>
              <a:rPr lang="en-US" sz="1000" b="1" baseline="30000" dirty="0">
                <a:latin typeface="Arial" pitchFamily="34" charset="0"/>
                <a:cs typeface="Arial" pitchFamily="34" charset="0"/>
              </a:rPr>
              <a:t>-1</a:t>
            </a:r>
            <a:r>
              <a:rPr lang="en-US" sz="1000" b="1" dirty="0">
                <a:latin typeface="Arial" pitchFamily="34" charset="0"/>
                <a:cs typeface="Arial" pitchFamily="34" charset="0"/>
              </a:rPr>
              <a:t>)</a:t>
            </a:r>
          </a:p>
        </p:txBody>
      </p:sp>
      <p:sp>
        <p:nvSpPr>
          <p:cNvPr id="300" name="TextBox 59"/>
          <p:cNvSpPr txBox="1">
            <a:spLocks noChangeArrowheads="1"/>
          </p:cNvSpPr>
          <p:nvPr/>
        </p:nvSpPr>
        <p:spPr bwMode="auto">
          <a:xfrm>
            <a:off x="3453156" y="5057339"/>
            <a:ext cx="338554" cy="15032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vert270"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Absorbance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01" name="组合 245"/>
          <p:cNvGrpSpPr/>
          <p:nvPr/>
        </p:nvGrpSpPr>
        <p:grpSpPr>
          <a:xfrm>
            <a:off x="3915380" y="6600713"/>
            <a:ext cx="2785232" cy="156898"/>
            <a:chOff x="3279148" y="5191705"/>
            <a:chExt cx="2785232" cy="156898"/>
          </a:xfrm>
        </p:grpSpPr>
        <p:sp>
          <p:nvSpPr>
            <p:cNvPr id="302" name="Rectangle 5"/>
            <p:cNvSpPr>
              <a:spLocks noChangeArrowheads="1"/>
            </p:cNvSpPr>
            <p:nvPr/>
          </p:nvSpPr>
          <p:spPr bwMode="auto">
            <a:xfrm>
              <a:off x="3279148" y="5194684"/>
              <a:ext cx="28212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1480</a:t>
              </a:r>
              <a:endParaRPr kumimoji="0" lang="zh-CN" altLang="zh-CN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03" name="Rectangle 5"/>
            <p:cNvSpPr>
              <a:spLocks noChangeArrowheads="1"/>
            </p:cNvSpPr>
            <p:nvPr/>
          </p:nvSpPr>
          <p:spPr bwMode="auto">
            <a:xfrm>
              <a:off x="4112515" y="5192379"/>
              <a:ext cx="28212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1440</a:t>
              </a:r>
              <a:endParaRPr kumimoji="0" lang="zh-CN" altLang="zh-CN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04" name="Rectangle 5"/>
            <p:cNvSpPr>
              <a:spLocks noChangeArrowheads="1"/>
            </p:cNvSpPr>
            <p:nvPr/>
          </p:nvSpPr>
          <p:spPr bwMode="auto">
            <a:xfrm>
              <a:off x="4947383" y="5194715"/>
              <a:ext cx="28212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1400</a:t>
              </a:r>
              <a:endParaRPr kumimoji="0" lang="zh-CN" altLang="zh-CN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05" name="Rectangle 5"/>
            <p:cNvSpPr>
              <a:spLocks noChangeArrowheads="1"/>
            </p:cNvSpPr>
            <p:nvPr/>
          </p:nvSpPr>
          <p:spPr bwMode="auto">
            <a:xfrm>
              <a:off x="5782251" y="5191705"/>
              <a:ext cx="28212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1360</a:t>
              </a:r>
              <a:endParaRPr kumimoji="0" lang="zh-CN" altLang="zh-CN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306" name="组合 250"/>
          <p:cNvGrpSpPr/>
          <p:nvPr/>
        </p:nvGrpSpPr>
        <p:grpSpPr>
          <a:xfrm>
            <a:off x="3735878" y="4967869"/>
            <a:ext cx="248340" cy="1641384"/>
            <a:chOff x="3936131" y="2156825"/>
            <a:chExt cx="248340" cy="1641384"/>
          </a:xfrm>
        </p:grpSpPr>
        <p:sp>
          <p:nvSpPr>
            <p:cNvPr id="307" name="Rectangle 11"/>
            <p:cNvSpPr>
              <a:spLocks noChangeArrowheads="1"/>
            </p:cNvSpPr>
            <p:nvPr/>
          </p:nvSpPr>
          <p:spPr bwMode="auto">
            <a:xfrm>
              <a:off x="4113842" y="3644321"/>
              <a:ext cx="7053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0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8" name="Rectangle 15"/>
            <p:cNvSpPr>
              <a:spLocks noChangeArrowheads="1"/>
            </p:cNvSpPr>
            <p:nvPr/>
          </p:nvSpPr>
          <p:spPr bwMode="auto">
            <a:xfrm>
              <a:off x="3936131" y="2771477"/>
              <a:ext cx="24686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0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15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9" name="Rectangle 15"/>
            <p:cNvSpPr>
              <a:spLocks noChangeArrowheads="1"/>
            </p:cNvSpPr>
            <p:nvPr/>
          </p:nvSpPr>
          <p:spPr bwMode="auto">
            <a:xfrm>
              <a:off x="3937088" y="3068157"/>
              <a:ext cx="24686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0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10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0" name="Rectangle 15"/>
            <p:cNvSpPr>
              <a:spLocks noChangeArrowheads="1"/>
            </p:cNvSpPr>
            <p:nvPr/>
          </p:nvSpPr>
          <p:spPr bwMode="auto">
            <a:xfrm>
              <a:off x="3936131" y="2156825"/>
              <a:ext cx="24686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0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25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1" name="Rectangle 15"/>
            <p:cNvSpPr>
              <a:spLocks noChangeArrowheads="1"/>
            </p:cNvSpPr>
            <p:nvPr/>
          </p:nvSpPr>
          <p:spPr bwMode="auto">
            <a:xfrm>
              <a:off x="3936131" y="2467055"/>
              <a:ext cx="24686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0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20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2" name="Rectangle 15"/>
            <p:cNvSpPr>
              <a:spLocks noChangeArrowheads="1"/>
            </p:cNvSpPr>
            <p:nvPr/>
          </p:nvSpPr>
          <p:spPr bwMode="auto">
            <a:xfrm>
              <a:off x="3937609" y="3360167"/>
              <a:ext cx="24686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0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05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13" name="ZoneTexte 9"/>
          <p:cNvSpPr txBox="1">
            <a:spLocks noChangeArrowheads="1"/>
          </p:cNvSpPr>
          <p:nvPr/>
        </p:nvSpPr>
        <p:spPr bwMode="auto">
          <a:xfrm>
            <a:off x="663542" y="6702043"/>
            <a:ext cx="251806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1000" b="1" dirty="0">
                <a:latin typeface="Arial" pitchFamily="34" charset="0"/>
                <a:cs typeface="Arial" pitchFamily="34" charset="0"/>
              </a:rPr>
              <a:t>PC-1 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(55%)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4" name="ZoneTexte 313"/>
          <p:cNvSpPr txBox="1"/>
          <p:nvPr/>
        </p:nvSpPr>
        <p:spPr bwMode="auto">
          <a:xfrm>
            <a:off x="134541" y="5042323"/>
            <a:ext cx="338554" cy="1505282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000" b="1" dirty="0">
                <a:latin typeface="Arial" pitchFamily="34" charset="0"/>
                <a:cs typeface="Arial" pitchFamily="34" charset="0"/>
              </a:rPr>
              <a:t>PC-2 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(14%)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15" name="组合 3"/>
          <p:cNvGrpSpPr/>
          <p:nvPr/>
        </p:nvGrpSpPr>
        <p:grpSpPr>
          <a:xfrm>
            <a:off x="292830" y="4918173"/>
            <a:ext cx="424039" cy="1727002"/>
            <a:chOff x="317181" y="786332"/>
            <a:chExt cx="424039" cy="1727002"/>
          </a:xfrm>
        </p:grpSpPr>
        <p:sp>
          <p:nvSpPr>
            <p:cNvPr id="316" name="ZoneTexte 9"/>
            <p:cNvSpPr txBox="1">
              <a:spLocks noChangeArrowheads="1"/>
            </p:cNvSpPr>
            <p:nvPr/>
          </p:nvSpPr>
          <p:spPr bwMode="auto">
            <a:xfrm>
              <a:off x="337355" y="786332"/>
              <a:ext cx="403865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0.5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7" name="ZoneTexte 10"/>
            <p:cNvSpPr txBox="1">
              <a:spLocks noChangeArrowheads="1"/>
            </p:cNvSpPr>
            <p:nvPr/>
          </p:nvSpPr>
          <p:spPr bwMode="auto">
            <a:xfrm>
              <a:off x="484259" y="1552718"/>
              <a:ext cx="211745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>
                  <a:latin typeface="Arial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318" name="ZoneTexte 11"/>
            <p:cNvSpPr txBox="1">
              <a:spLocks noChangeArrowheads="1"/>
            </p:cNvSpPr>
            <p:nvPr/>
          </p:nvSpPr>
          <p:spPr bwMode="auto">
            <a:xfrm>
              <a:off x="317181" y="2267113"/>
              <a:ext cx="403838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-0.5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19" name="组合 13"/>
          <p:cNvGrpSpPr/>
          <p:nvPr/>
        </p:nvGrpSpPr>
        <p:grpSpPr>
          <a:xfrm>
            <a:off x="463470" y="6544198"/>
            <a:ext cx="2991416" cy="256207"/>
            <a:chOff x="69979" y="2844267"/>
            <a:chExt cx="2991416" cy="256207"/>
          </a:xfrm>
        </p:grpSpPr>
        <p:sp>
          <p:nvSpPr>
            <p:cNvPr id="320" name="ZoneTexte 3"/>
            <p:cNvSpPr txBox="1">
              <a:spLocks noChangeArrowheads="1"/>
            </p:cNvSpPr>
            <p:nvPr/>
          </p:nvSpPr>
          <p:spPr bwMode="auto">
            <a:xfrm>
              <a:off x="1779147" y="2846558"/>
              <a:ext cx="158915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>
                  <a:latin typeface="Arial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321" name="ZoneTexte 12"/>
            <p:cNvSpPr txBox="1">
              <a:spLocks noChangeArrowheads="1"/>
            </p:cNvSpPr>
            <p:nvPr/>
          </p:nvSpPr>
          <p:spPr bwMode="auto">
            <a:xfrm>
              <a:off x="2523752" y="2846558"/>
              <a:ext cx="537643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0.6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2" name="ZoneTexte 321"/>
            <p:cNvSpPr txBox="1">
              <a:spLocks noChangeArrowheads="1"/>
            </p:cNvSpPr>
            <p:nvPr/>
          </p:nvSpPr>
          <p:spPr bwMode="auto">
            <a:xfrm>
              <a:off x="69979" y="2844267"/>
              <a:ext cx="43404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-1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23" name="Groupe 322"/>
          <p:cNvGrpSpPr/>
          <p:nvPr/>
        </p:nvGrpSpPr>
        <p:grpSpPr>
          <a:xfrm>
            <a:off x="1117600" y="4755161"/>
            <a:ext cx="5093965" cy="253536"/>
            <a:chOff x="1141699" y="386423"/>
            <a:chExt cx="5093965" cy="253536"/>
          </a:xfrm>
        </p:grpSpPr>
        <p:grpSp>
          <p:nvGrpSpPr>
            <p:cNvPr id="324" name="Groupe 323"/>
            <p:cNvGrpSpPr/>
            <p:nvPr/>
          </p:nvGrpSpPr>
          <p:grpSpPr>
            <a:xfrm>
              <a:off x="4417884" y="436247"/>
              <a:ext cx="1817780" cy="153888"/>
              <a:chOff x="4078001" y="414539"/>
              <a:chExt cx="1817780" cy="153888"/>
            </a:xfrm>
          </p:grpSpPr>
          <p:grpSp>
            <p:nvGrpSpPr>
              <p:cNvPr id="332" name="组合 40"/>
              <p:cNvGrpSpPr/>
              <p:nvPr/>
            </p:nvGrpSpPr>
            <p:grpSpPr>
              <a:xfrm>
                <a:off x="4078001" y="414539"/>
                <a:ext cx="514891" cy="153888"/>
                <a:chOff x="2782839" y="194450"/>
                <a:chExt cx="514891" cy="153888"/>
              </a:xfrm>
            </p:grpSpPr>
            <p:sp>
              <p:nvSpPr>
                <p:cNvPr id="336" name="Rectangle 9"/>
                <p:cNvSpPr>
                  <a:spLocks noChangeArrowheads="1"/>
                </p:cNvSpPr>
                <p:nvPr/>
              </p:nvSpPr>
              <p:spPr bwMode="auto">
                <a:xfrm>
                  <a:off x="3111782" y="194450"/>
                  <a:ext cx="185948" cy="1538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1000" b="1" dirty="0" smtClean="0">
                      <a:solidFill>
                        <a:srgbClr val="000000"/>
                      </a:solidFill>
                      <a:latin typeface="Arial" pitchFamily="34" charset="0"/>
                      <a:cs typeface="Arial" pitchFamily="34" charset="0"/>
                    </a:rPr>
                    <a:t>DN</a:t>
                  </a:r>
                  <a:endParaRPr lang="en-US" sz="14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37" name="Line 10"/>
                <p:cNvSpPr>
                  <a:spLocks noChangeShapeType="1"/>
                </p:cNvSpPr>
                <p:nvPr/>
              </p:nvSpPr>
              <p:spPr bwMode="auto">
                <a:xfrm>
                  <a:off x="2782839" y="271394"/>
                  <a:ext cx="274321" cy="0"/>
                </a:xfrm>
                <a:prstGeom prst="line">
                  <a:avLst/>
                </a:prstGeom>
                <a:noFill/>
                <a:ln w="19050">
                  <a:solidFill>
                    <a:schemeClr val="tx1">
                      <a:lumMod val="95000"/>
                      <a:lumOff val="5000"/>
                    </a:schemeClr>
                  </a:solidFill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</p:grpSp>
          <p:grpSp>
            <p:nvGrpSpPr>
              <p:cNvPr id="333" name="组合 31"/>
              <p:cNvGrpSpPr/>
              <p:nvPr/>
            </p:nvGrpSpPr>
            <p:grpSpPr>
              <a:xfrm>
                <a:off x="5231185" y="414539"/>
                <a:ext cx="664596" cy="153888"/>
                <a:chOff x="2485964" y="354055"/>
                <a:chExt cx="664596" cy="153888"/>
              </a:xfrm>
            </p:grpSpPr>
            <p:sp>
              <p:nvSpPr>
                <p:cNvPr id="334" name="Rectangle 13"/>
                <p:cNvSpPr>
                  <a:spLocks noChangeArrowheads="1"/>
                </p:cNvSpPr>
                <p:nvPr/>
              </p:nvSpPr>
              <p:spPr bwMode="auto">
                <a:xfrm>
                  <a:off x="2814908" y="354055"/>
                  <a:ext cx="335652" cy="1538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 lIns="0" tIns="0" rIns="0" bIns="0">
                  <a:spAutoFit/>
                </a:bodyPr>
                <a:lstStyle/>
                <a:p>
                  <a:r>
                    <a:rPr lang="en-US" sz="1000" b="1" dirty="0" smtClean="0">
                      <a:latin typeface="Arial" pitchFamily="34" charset="0"/>
                      <a:cs typeface="Arial" pitchFamily="34" charset="0"/>
                    </a:rPr>
                    <a:t>HCC</a:t>
                  </a:r>
                  <a:endParaRPr lang="en-US" sz="10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35" name="Line 14"/>
                <p:cNvSpPr>
                  <a:spLocks noChangeShapeType="1"/>
                </p:cNvSpPr>
                <p:nvPr/>
              </p:nvSpPr>
              <p:spPr bwMode="auto">
                <a:xfrm>
                  <a:off x="2485964" y="430999"/>
                  <a:ext cx="274320" cy="0"/>
                </a:xfrm>
                <a:prstGeom prst="line">
                  <a:avLst/>
                </a:prstGeom>
                <a:noFill/>
                <a:ln w="19050" cmpd="sng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/>
                </a:p>
              </p:txBody>
            </p:sp>
          </p:grpSp>
        </p:grpSp>
        <p:grpSp>
          <p:nvGrpSpPr>
            <p:cNvPr id="325" name="Groupe 324"/>
            <p:cNvGrpSpPr/>
            <p:nvPr/>
          </p:nvGrpSpPr>
          <p:grpSpPr>
            <a:xfrm>
              <a:off x="1141699" y="386423"/>
              <a:ext cx="1799643" cy="253536"/>
              <a:chOff x="1093059" y="368373"/>
              <a:chExt cx="1799643" cy="253536"/>
            </a:xfrm>
          </p:grpSpPr>
          <p:grpSp>
            <p:nvGrpSpPr>
              <p:cNvPr id="326" name="组合 12"/>
              <p:cNvGrpSpPr/>
              <p:nvPr/>
            </p:nvGrpSpPr>
            <p:grpSpPr>
              <a:xfrm>
                <a:off x="1093059" y="368373"/>
                <a:ext cx="900748" cy="246221"/>
                <a:chOff x="770172" y="59947"/>
                <a:chExt cx="900748" cy="246221"/>
              </a:xfrm>
            </p:grpSpPr>
            <p:sp>
              <p:nvSpPr>
                <p:cNvPr id="330" name="ZoneTexte 10208"/>
                <p:cNvSpPr txBox="1">
                  <a:spLocks noChangeArrowheads="1"/>
                </p:cNvSpPr>
                <p:nvPr/>
              </p:nvSpPr>
              <p:spPr bwMode="auto">
                <a:xfrm>
                  <a:off x="843084" y="59947"/>
                  <a:ext cx="827836" cy="24622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sz="1000" b="1" dirty="0" smtClean="0">
                      <a:latin typeface="Arial" pitchFamily="34" charset="0"/>
                      <a:cs typeface="Arial" pitchFamily="34" charset="0"/>
                    </a:rPr>
                    <a:t>DN</a:t>
                  </a:r>
                  <a:endParaRPr lang="en-US" sz="10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31" name="Oval 12"/>
                <p:cNvSpPr>
                  <a:spLocks noChangeArrowheads="1"/>
                </p:cNvSpPr>
                <p:nvPr/>
              </p:nvSpPr>
              <p:spPr bwMode="auto">
                <a:xfrm>
                  <a:off x="770172" y="134980"/>
                  <a:ext cx="91440" cy="91440"/>
                </a:xfrm>
                <a:prstGeom prst="ellipse">
                  <a:avLst/>
                </a:prstGeom>
                <a:solidFill>
                  <a:schemeClr val="tx1">
                    <a:lumMod val="95000"/>
                    <a:lumOff val="5000"/>
                  </a:schemeClr>
                </a:solidFill>
                <a:ln w="0">
                  <a:solidFill>
                    <a:schemeClr val="tx1">
                      <a:lumMod val="95000"/>
                      <a:lumOff val="5000"/>
                    </a:schemeClr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>
                    <a:latin typeface="Calibri" pitchFamily="34" charset="0"/>
                  </a:endParaRPr>
                </a:p>
              </p:txBody>
            </p:sp>
          </p:grpSp>
          <p:grpSp>
            <p:nvGrpSpPr>
              <p:cNvPr id="327" name="组合 21"/>
              <p:cNvGrpSpPr/>
              <p:nvPr/>
            </p:nvGrpSpPr>
            <p:grpSpPr>
              <a:xfrm>
                <a:off x="2260527" y="375688"/>
                <a:ext cx="632175" cy="246221"/>
                <a:chOff x="847996" y="240093"/>
                <a:chExt cx="632175" cy="246221"/>
              </a:xfrm>
            </p:grpSpPr>
            <p:sp>
              <p:nvSpPr>
                <p:cNvPr id="328" name="ZoneTexte 10210"/>
                <p:cNvSpPr txBox="1">
                  <a:spLocks noChangeArrowheads="1"/>
                </p:cNvSpPr>
                <p:nvPr/>
              </p:nvSpPr>
              <p:spPr bwMode="auto">
                <a:xfrm>
                  <a:off x="920907" y="240093"/>
                  <a:ext cx="559264" cy="24622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fontAlgn="ctr"/>
                  <a:r>
                    <a:rPr lang="en-US" sz="1000" b="1" dirty="0" smtClean="0">
                      <a:latin typeface="Arial" pitchFamily="34" charset="0"/>
                      <a:cs typeface="Arial" pitchFamily="34" charset="0"/>
                    </a:rPr>
                    <a:t>HCC</a:t>
                  </a:r>
                  <a:endParaRPr lang="en-US" sz="10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29" name="Oval 12"/>
                <p:cNvSpPr>
                  <a:spLocks noChangeArrowheads="1"/>
                </p:cNvSpPr>
                <p:nvPr/>
              </p:nvSpPr>
              <p:spPr bwMode="auto">
                <a:xfrm>
                  <a:off x="847996" y="310168"/>
                  <a:ext cx="91440" cy="91440"/>
                </a:xfrm>
                <a:prstGeom prst="ellipse">
                  <a:avLst/>
                </a:prstGeom>
                <a:solidFill>
                  <a:srgbClr val="FF0000"/>
                </a:solidFill>
                <a:ln w="0">
                  <a:solidFill>
                    <a:srgbClr val="C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>
                    <a:latin typeface="Calibri" pitchFamily="34" charset="0"/>
                  </a:endParaRPr>
                </a:p>
              </p:txBody>
            </p:sp>
          </p:grpSp>
        </p:grpSp>
      </p:grpSp>
      <p:grpSp>
        <p:nvGrpSpPr>
          <p:cNvPr id="338" name="组合 17"/>
          <p:cNvGrpSpPr/>
          <p:nvPr/>
        </p:nvGrpSpPr>
        <p:grpSpPr>
          <a:xfrm>
            <a:off x="272302" y="6937126"/>
            <a:ext cx="462603" cy="1725627"/>
            <a:chOff x="423394" y="3527147"/>
            <a:chExt cx="462603" cy="1725627"/>
          </a:xfrm>
        </p:grpSpPr>
        <p:sp>
          <p:nvSpPr>
            <p:cNvPr id="339" name="ZoneTexte 9"/>
            <p:cNvSpPr txBox="1">
              <a:spLocks noChangeArrowheads="1"/>
            </p:cNvSpPr>
            <p:nvPr/>
          </p:nvSpPr>
          <p:spPr bwMode="auto">
            <a:xfrm>
              <a:off x="435317" y="3527147"/>
              <a:ext cx="45068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0.4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0" name="ZoneTexte 10"/>
            <p:cNvSpPr txBox="1">
              <a:spLocks noChangeArrowheads="1"/>
            </p:cNvSpPr>
            <p:nvPr/>
          </p:nvSpPr>
          <p:spPr bwMode="auto">
            <a:xfrm>
              <a:off x="607205" y="4286008"/>
              <a:ext cx="211745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>
                  <a:latin typeface="Arial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341" name="ZoneTexte 11"/>
            <p:cNvSpPr txBox="1">
              <a:spLocks noChangeArrowheads="1"/>
            </p:cNvSpPr>
            <p:nvPr/>
          </p:nvSpPr>
          <p:spPr bwMode="auto">
            <a:xfrm>
              <a:off x="423394" y="5006553"/>
              <a:ext cx="43404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-0.4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42" name="Groupe 341"/>
          <p:cNvGrpSpPr/>
          <p:nvPr/>
        </p:nvGrpSpPr>
        <p:grpSpPr>
          <a:xfrm>
            <a:off x="4057786" y="5273561"/>
            <a:ext cx="2491282" cy="1280160"/>
            <a:chOff x="4378326" y="1966913"/>
            <a:chExt cx="1968500" cy="1381125"/>
          </a:xfrm>
        </p:grpSpPr>
        <p:sp>
          <p:nvSpPr>
            <p:cNvPr id="343" name="Freeform 27"/>
            <p:cNvSpPr>
              <a:spLocks/>
            </p:cNvSpPr>
            <p:nvPr/>
          </p:nvSpPr>
          <p:spPr bwMode="auto">
            <a:xfrm>
              <a:off x="4378326" y="2078038"/>
              <a:ext cx="1968500" cy="1270000"/>
            </a:xfrm>
            <a:custGeom>
              <a:avLst/>
              <a:gdLst/>
              <a:ahLst/>
              <a:cxnLst>
                <a:cxn ang="0">
                  <a:pos x="0" y="800"/>
                </a:cxn>
                <a:cxn ang="0">
                  <a:pos x="20" y="755"/>
                </a:cxn>
                <a:cxn ang="0">
                  <a:pos x="40" y="683"/>
                </a:cxn>
                <a:cxn ang="0">
                  <a:pos x="60" y="582"/>
                </a:cxn>
                <a:cxn ang="0">
                  <a:pos x="80" y="463"/>
                </a:cxn>
                <a:cxn ang="0">
                  <a:pos x="100" y="352"/>
                </a:cxn>
                <a:cxn ang="0">
                  <a:pos x="120" y="282"/>
                </a:cxn>
                <a:cxn ang="0">
                  <a:pos x="140" y="258"/>
                </a:cxn>
                <a:cxn ang="0">
                  <a:pos x="160" y="248"/>
                </a:cxn>
                <a:cxn ang="0">
                  <a:pos x="180" y="221"/>
                </a:cxn>
                <a:cxn ang="0">
                  <a:pos x="200" y="174"/>
                </a:cxn>
                <a:cxn ang="0">
                  <a:pos x="220" y="115"/>
                </a:cxn>
                <a:cxn ang="0">
                  <a:pos x="240" y="77"/>
                </a:cxn>
                <a:cxn ang="0">
                  <a:pos x="260" y="85"/>
                </a:cxn>
                <a:cxn ang="0">
                  <a:pos x="280" y="115"/>
                </a:cxn>
                <a:cxn ang="0">
                  <a:pos x="300" y="146"/>
                </a:cxn>
                <a:cxn ang="0">
                  <a:pos x="320" y="168"/>
                </a:cxn>
                <a:cxn ang="0">
                  <a:pos x="340" y="194"/>
                </a:cxn>
                <a:cxn ang="0">
                  <a:pos x="360" y="228"/>
                </a:cxn>
                <a:cxn ang="0">
                  <a:pos x="380" y="259"/>
                </a:cxn>
                <a:cxn ang="0">
                  <a:pos x="400" y="297"/>
                </a:cxn>
                <a:cxn ang="0">
                  <a:pos x="420" y="341"/>
                </a:cxn>
                <a:cxn ang="0">
                  <a:pos x="440" y="394"/>
                </a:cxn>
                <a:cxn ang="0">
                  <a:pos x="460" y="458"/>
                </a:cxn>
                <a:cxn ang="0">
                  <a:pos x="480" y="514"/>
                </a:cxn>
                <a:cxn ang="0">
                  <a:pos x="500" y="554"/>
                </a:cxn>
                <a:cxn ang="0">
                  <a:pos x="520" y="575"/>
                </a:cxn>
                <a:cxn ang="0">
                  <a:pos x="540" y="573"/>
                </a:cxn>
                <a:cxn ang="0">
                  <a:pos x="560" y="551"/>
                </a:cxn>
                <a:cxn ang="0">
                  <a:pos x="580" y="521"/>
                </a:cxn>
                <a:cxn ang="0">
                  <a:pos x="600" y="481"/>
                </a:cxn>
                <a:cxn ang="0">
                  <a:pos x="620" y="434"/>
                </a:cxn>
                <a:cxn ang="0">
                  <a:pos x="640" y="398"/>
                </a:cxn>
                <a:cxn ang="0">
                  <a:pos x="660" y="368"/>
                </a:cxn>
                <a:cxn ang="0">
                  <a:pos x="680" y="336"/>
                </a:cxn>
                <a:cxn ang="0">
                  <a:pos x="700" y="307"/>
                </a:cxn>
                <a:cxn ang="0">
                  <a:pos x="720" y="272"/>
                </a:cxn>
                <a:cxn ang="0">
                  <a:pos x="740" y="222"/>
                </a:cxn>
                <a:cxn ang="0">
                  <a:pos x="760" y="166"/>
                </a:cxn>
                <a:cxn ang="0">
                  <a:pos x="780" y="115"/>
                </a:cxn>
                <a:cxn ang="0">
                  <a:pos x="800" y="73"/>
                </a:cxn>
                <a:cxn ang="0">
                  <a:pos x="820" y="38"/>
                </a:cxn>
                <a:cxn ang="0">
                  <a:pos x="840" y="13"/>
                </a:cxn>
                <a:cxn ang="0">
                  <a:pos x="860" y="1"/>
                </a:cxn>
                <a:cxn ang="0">
                  <a:pos x="880" y="0"/>
                </a:cxn>
                <a:cxn ang="0">
                  <a:pos x="900" y="12"/>
                </a:cxn>
                <a:cxn ang="0">
                  <a:pos x="920" y="34"/>
                </a:cxn>
                <a:cxn ang="0">
                  <a:pos x="940" y="58"/>
                </a:cxn>
                <a:cxn ang="0">
                  <a:pos x="960" y="100"/>
                </a:cxn>
                <a:cxn ang="0">
                  <a:pos x="980" y="162"/>
                </a:cxn>
                <a:cxn ang="0">
                  <a:pos x="1000" y="237"/>
                </a:cxn>
                <a:cxn ang="0">
                  <a:pos x="1020" y="308"/>
                </a:cxn>
                <a:cxn ang="0">
                  <a:pos x="1040" y="367"/>
                </a:cxn>
                <a:cxn ang="0">
                  <a:pos x="1060" y="429"/>
                </a:cxn>
                <a:cxn ang="0">
                  <a:pos x="1080" y="488"/>
                </a:cxn>
                <a:cxn ang="0">
                  <a:pos x="1100" y="534"/>
                </a:cxn>
                <a:cxn ang="0">
                  <a:pos x="1120" y="566"/>
                </a:cxn>
                <a:cxn ang="0">
                  <a:pos x="1140" y="596"/>
                </a:cxn>
                <a:cxn ang="0">
                  <a:pos x="1160" y="636"/>
                </a:cxn>
                <a:cxn ang="0">
                  <a:pos x="1180" y="688"/>
                </a:cxn>
                <a:cxn ang="0">
                  <a:pos x="1200" y="736"/>
                </a:cxn>
                <a:cxn ang="0">
                  <a:pos x="1220" y="769"/>
                </a:cxn>
                <a:cxn ang="0">
                  <a:pos x="1240" y="790"/>
                </a:cxn>
              </a:cxnLst>
              <a:rect l="0" t="0" r="r" b="b"/>
              <a:pathLst>
                <a:path w="1240" h="800">
                  <a:moveTo>
                    <a:pt x="0" y="800"/>
                  </a:moveTo>
                  <a:lnTo>
                    <a:pt x="20" y="755"/>
                  </a:lnTo>
                  <a:lnTo>
                    <a:pt x="40" y="683"/>
                  </a:lnTo>
                  <a:lnTo>
                    <a:pt x="60" y="582"/>
                  </a:lnTo>
                  <a:lnTo>
                    <a:pt x="80" y="463"/>
                  </a:lnTo>
                  <a:lnTo>
                    <a:pt x="100" y="352"/>
                  </a:lnTo>
                  <a:lnTo>
                    <a:pt x="120" y="282"/>
                  </a:lnTo>
                  <a:lnTo>
                    <a:pt x="140" y="258"/>
                  </a:lnTo>
                  <a:lnTo>
                    <a:pt x="160" y="248"/>
                  </a:lnTo>
                  <a:lnTo>
                    <a:pt x="180" y="221"/>
                  </a:lnTo>
                  <a:lnTo>
                    <a:pt x="200" y="174"/>
                  </a:lnTo>
                  <a:lnTo>
                    <a:pt x="220" y="115"/>
                  </a:lnTo>
                  <a:lnTo>
                    <a:pt x="240" y="77"/>
                  </a:lnTo>
                  <a:lnTo>
                    <a:pt x="260" y="85"/>
                  </a:lnTo>
                  <a:lnTo>
                    <a:pt x="280" y="115"/>
                  </a:lnTo>
                  <a:lnTo>
                    <a:pt x="300" y="146"/>
                  </a:lnTo>
                  <a:lnTo>
                    <a:pt x="320" y="168"/>
                  </a:lnTo>
                  <a:lnTo>
                    <a:pt x="340" y="194"/>
                  </a:lnTo>
                  <a:lnTo>
                    <a:pt x="360" y="228"/>
                  </a:lnTo>
                  <a:lnTo>
                    <a:pt x="380" y="259"/>
                  </a:lnTo>
                  <a:lnTo>
                    <a:pt x="400" y="297"/>
                  </a:lnTo>
                  <a:lnTo>
                    <a:pt x="420" y="341"/>
                  </a:lnTo>
                  <a:lnTo>
                    <a:pt x="440" y="394"/>
                  </a:lnTo>
                  <a:lnTo>
                    <a:pt x="460" y="458"/>
                  </a:lnTo>
                  <a:lnTo>
                    <a:pt x="480" y="514"/>
                  </a:lnTo>
                  <a:lnTo>
                    <a:pt x="500" y="554"/>
                  </a:lnTo>
                  <a:lnTo>
                    <a:pt x="520" y="575"/>
                  </a:lnTo>
                  <a:lnTo>
                    <a:pt x="540" y="573"/>
                  </a:lnTo>
                  <a:lnTo>
                    <a:pt x="560" y="551"/>
                  </a:lnTo>
                  <a:lnTo>
                    <a:pt x="580" y="521"/>
                  </a:lnTo>
                  <a:lnTo>
                    <a:pt x="600" y="481"/>
                  </a:lnTo>
                  <a:lnTo>
                    <a:pt x="620" y="434"/>
                  </a:lnTo>
                  <a:lnTo>
                    <a:pt x="640" y="398"/>
                  </a:lnTo>
                  <a:lnTo>
                    <a:pt x="660" y="368"/>
                  </a:lnTo>
                  <a:lnTo>
                    <a:pt x="680" y="336"/>
                  </a:lnTo>
                  <a:lnTo>
                    <a:pt x="700" y="307"/>
                  </a:lnTo>
                  <a:lnTo>
                    <a:pt x="720" y="272"/>
                  </a:lnTo>
                  <a:lnTo>
                    <a:pt x="740" y="222"/>
                  </a:lnTo>
                  <a:lnTo>
                    <a:pt x="760" y="166"/>
                  </a:lnTo>
                  <a:lnTo>
                    <a:pt x="780" y="115"/>
                  </a:lnTo>
                  <a:lnTo>
                    <a:pt x="800" y="73"/>
                  </a:lnTo>
                  <a:lnTo>
                    <a:pt x="820" y="38"/>
                  </a:lnTo>
                  <a:lnTo>
                    <a:pt x="840" y="13"/>
                  </a:lnTo>
                  <a:lnTo>
                    <a:pt x="860" y="1"/>
                  </a:lnTo>
                  <a:lnTo>
                    <a:pt x="880" y="0"/>
                  </a:lnTo>
                  <a:lnTo>
                    <a:pt x="900" y="12"/>
                  </a:lnTo>
                  <a:lnTo>
                    <a:pt x="920" y="34"/>
                  </a:lnTo>
                  <a:lnTo>
                    <a:pt x="940" y="58"/>
                  </a:lnTo>
                  <a:lnTo>
                    <a:pt x="960" y="100"/>
                  </a:lnTo>
                  <a:lnTo>
                    <a:pt x="980" y="162"/>
                  </a:lnTo>
                  <a:lnTo>
                    <a:pt x="1000" y="237"/>
                  </a:lnTo>
                  <a:lnTo>
                    <a:pt x="1020" y="308"/>
                  </a:lnTo>
                  <a:lnTo>
                    <a:pt x="1040" y="367"/>
                  </a:lnTo>
                  <a:lnTo>
                    <a:pt x="1060" y="429"/>
                  </a:lnTo>
                  <a:lnTo>
                    <a:pt x="1080" y="488"/>
                  </a:lnTo>
                  <a:lnTo>
                    <a:pt x="1100" y="534"/>
                  </a:lnTo>
                  <a:lnTo>
                    <a:pt x="1120" y="566"/>
                  </a:lnTo>
                  <a:lnTo>
                    <a:pt x="1140" y="596"/>
                  </a:lnTo>
                  <a:lnTo>
                    <a:pt x="1160" y="636"/>
                  </a:lnTo>
                  <a:lnTo>
                    <a:pt x="1180" y="688"/>
                  </a:lnTo>
                  <a:lnTo>
                    <a:pt x="1200" y="736"/>
                  </a:lnTo>
                  <a:lnTo>
                    <a:pt x="1220" y="769"/>
                  </a:lnTo>
                  <a:lnTo>
                    <a:pt x="1240" y="790"/>
                  </a:lnTo>
                </a:path>
              </a:pathLst>
            </a:cu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44" name="Freeform 28"/>
            <p:cNvSpPr>
              <a:spLocks/>
            </p:cNvSpPr>
            <p:nvPr/>
          </p:nvSpPr>
          <p:spPr bwMode="auto">
            <a:xfrm>
              <a:off x="4378326" y="1966913"/>
              <a:ext cx="1968500" cy="1381125"/>
            </a:xfrm>
            <a:custGeom>
              <a:avLst/>
              <a:gdLst/>
              <a:ahLst/>
              <a:cxnLst>
                <a:cxn ang="0">
                  <a:pos x="0" y="870"/>
                </a:cxn>
                <a:cxn ang="0">
                  <a:pos x="20" y="836"/>
                </a:cxn>
                <a:cxn ang="0">
                  <a:pos x="40" y="770"/>
                </a:cxn>
                <a:cxn ang="0">
                  <a:pos x="60" y="676"/>
                </a:cxn>
                <a:cxn ang="0">
                  <a:pos x="80" y="562"/>
                </a:cxn>
                <a:cxn ang="0">
                  <a:pos x="100" y="454"/>
                </a:cxn>
                <a:cxn ang="0">
                  <a:pos x="120" y="387"/>
                </a:cxn>
                <a:cxn ang="0">
                  <a:pos x="140" y="366"/>
                </a:cxn>
                <a:cxn ang="0">
                  <a:pos x="160" y="353"/>
                </a:cxn>
                <a:cxn ang="0">
                  <a:pos x="180" y="327"/>
                </a:cxn>
                <a:cxn ang="0">
                  <a:pos x="200" y="279"/>
                </a:cxn>
                <a:cxn ang="0">
                  <a:pos x="220" y="214"/>
                </a:cxn>
                <a:cxn ang="0">
                  <a:pos x="240" y="170"/>
                </a:cxn>
                <a:cxn ang="0">
                  <a:pos x="260" y="171"/>
                </a:cxn>
                <a:cxn ang="0">
                  <a:pos x="280" y="198"/>
                </a:cxn>
                <a:cxn ang="0">
                  <a:pos x="300" y="229"/>
                </a:cxn>
                <a:cxn ang="0">
                  <a:pos x="320" y="258"/>
                </a:cxn>
                <a:cxn ang="0">
                  <a:pos x="340" y="289"/>
                </a:cxn>
                <a:cxn ang="0">
                  <a:pos x="360" y="320"/>
                </a:cxn>
                <a:cxn ang="0">
                  <a:pos x="380" y="358"/>
                </a:cxn>
                <a:cxn ang="0">
                  <a:pos x="400" y="403"/>
                </a:cxn>
                <a:cxn ang="0">
                  <a:pos x="420" y="451"/>
                </a:cxn>
                <a:cxn ang="0">
                  <a:pos x="440" y="510"/>
                </a:cxn>
                <a:cxn ang="0">
                  <a:pos x="460" y="582"/>
                </a:cxn>
                <a:cxn ang="0">
                  <a:pos x="480" y="647"/>
                </a:cxn>
                <a:cxn ang="0">
                  <a:pos x="500" y="695"/>
                </a:cxn>
                <a:cxn ang="0">
                  <a:pos x="520" y="721"/>
                </a:cxn>
                <a:cxn ang="0">
                  <a:pos x="540" y="722"/>
                </a:cxn>
                <a:cxn ang="0">
                  <a:pos x="560" y="707"/>
                </a:cxn>
                <a:cxn ang="0">
                  <a:pos x="580" y="677"/>
                </a:cxn>
                <a:cxn ang="0">
                  <a:pos x="600" y="632"/>
                </a:cxn>
                <a:cxn ang="0">
                  <a:pos x="620" y="582"/>
                </a:cxn>
                <a:cxn ang="0">
                  <a:pos x="640" y="542"/>
                </a:cxn>
                <a:cxn ang="0">
                  <a:pos x="660" y="509"/>
                </a:cxn>
                <a:cxn ang="0">
                  <a:pos x="680" y="475"/>
                </a:cxn>
                <a:cxn ang="0">
                  <a:pos x="700" y="431"/>
                </a:cxn>
                <a:cxn ang="0">
                  <a:pos x="720" y="378"/>
                </a:cxn>
                <a:cxn ang="0">
                  <a:pos x="740" y="315"/>
                </a:cxn>
                <a:cxn ang="0">
                  <a:pos x="760" y="248"/>
                </a:cxn>
                <a:cxn ang="0">
                  <a:pos x="780" y="179"/>
                </a:cxn>
                <a:cxn ang="0">
                  <a:pos x="800" y="119"/>
                </a:cxn>
                <a:cxn ang="0">
                  <a:pos x="820" y="70"/>
                </a:cxn>
                <a:cxn ang="0">
                  <a:pos x="840" y="33"/>
                </a:cxn>
                <a:cxn ang="0">
                  <a:pos x="860" y="8"/>
                </a:cxn>
                <a:cxn ang="0">
                  <a:pos x="880" y="0"/>
                </a:cxn>
                <a:cxn ang="0">
                  <a:pos x="900" y="5"/>
                </a:cxn>
                <a:cxn ang="0">
                  <a:pos x="920" y="21"/>
                </a:cxn>
                <a:cxn ang="0">
                  <a:pos x="940" y="47"/>
                </a:cxn>
                <a:cxn ang="0">
                  <a:pos x="960" y="89"/>
                </a:cxn>
                <a:cxn ang="0">
                  <a:pos x="980" y="158"/>
                </a:cxn>
                <a:cxn ang="0">
                  <a:pos x="1000" y="244"/>
                </a:cxn>
                <a:cxn ang="0">
                  <a:pos x="1020" y="325"/>
                </a:cxn>
                <a:cxn ang="0">
                  <a:pos x="1040" y="395"/>
                </a:cxn>
                <a:cxn ang="0">
                  <a:pos x="1060" y="467"/>
                </a:cxn>
                <a:cxn ang="0">
                  <a:pos x="1080" y="541"/>
                </a:cxn>
                <a:cxn ang="0">
                  <a:pos x="1100" y="599"/>
                </a:cxn>
                <a:cxn ang="0">
                  <a:pos x="1120" y="636"/>
                </a:cxn>
                <a:cxn ang="0">
                  <a:pos x="1140" y="660"/>
                </a:cxn>
                <a:cxn ang="0">
                  <a:pos x="1160" y="703"/>
                </a:cxn>
                <a:cxn ang="0">
                  <a:pos x="1180" y="759"/>
                </a:cxn>
                <a:cxn ang="0">
                  <a:pos x="1200" y="812"/>
                </a:cxn>
                <a:cxn ang="0">
                  <a:pos x="1220" y="849"/>
                </a:cxn>
                <a:cxn ang="0">
                  <a:pos x="1240" y="864"/>
                </a:cxn>
              </a:cxnLst>
              <a:rect l="0" t="0" r="r" b="b"/>
              <a:pathLst>
                <a:path w="1240" h="870">
                  <a:moveTo>
                    <a:pt x="0" y="870"/>
                  </a:moveTo>
                  <a:lnTo>
                    <a:pt x="20" y="836"/>
                  </a:lnTo>
                  <a:lnTo>
                    <a:pt x="40" y="770"/>
                  </a:lnTo>
                  <a:lnTo>
                    <a:pt x="60" y="676"/>
                  </a:lnTo>
                  <a:lnTo>
                    <a:pt x="80" y="562"/>
                  </a:lnTo>
                  <a:lnTo>
                    <a:pt x="100" y="454"/>
                  </a:lnTo>
                  <a:lnTo>
                    <a:pt x="120" y="387"/>
                  </a:lnTo>
                  <a:lnTo>
                    <a:pt x="140" y="366"/>
                  </a:lnTo>
                  <a:lnTo>
                    <a:pt x="160" y="353"/>
                  </a:lnTo>
                  <a:lnTo>
                    <a:pt x="180" y="327"/>
                  </a:lnTo>
                  <a:lnTo>
                    <a:pt x="200" y="279"/>
                  </a:lnTo>
                  <a:lnTo>
                    <a:pt x="220" y="214"/>
                  </a:lnTo>
                  <a:lnTo>
                    <a:pt x="240" y="170"/>
                  </a:lnTo>
                  <a:lnTo>
                    <a:pt x="260" y="171"/>
                  </a:lnTo>
                  <a:lnTo>
                    <a:pt x="280" y="198"/>
                  </a:lnTo>
                  <a:lnTo>
                    <a:pt x="300" y="229"/>
                  </a:lnTo>
                  <a:lnTo>
                    <a:pt x="320" y="258"/>
                  </a:lnTo>
                  <a:lnTo>
                    <a:pt x="340" y="289"/>
                  </a:lnTo>
                  <a:lnTo>
                    <a:pt x="360" y="320"/>
                  </a:lnTo>
                  <a:lnTo>
                    <a:pt x="380" y="358"/>
                  </a:lnTo>
                  <a:lnTo>
                    <a:pt x="400" y="403"/>
                  </a:lnTo>
                  <a:lnTo>
                    <a:pt x="420" y="451"/>
                  </a:lnTo>
                  <a:lnTo>
                    <a:pt x="440" y="510"/>
                  </a:lnTo>
                  <a:lnTo>
                    <a:pt x="460" y="582"/>
                  </a:lnTo>
                  <a:lnTo>
                    <a:pt x="480" y="647"/>
                  </a:lnTo>
                  <a:lnTo>
                    <a:pt x="500" y="695"/>
                  </a:lnTo>
                  <a:lnTo>
                    <a:pt x="520" y="721"/>
                  </a:lnTo>
                  <a:lnTo>
                    <a:pt x="540" y="722"/>
                  </a:lnTo>
                  <a:lnTo>
                    <a:pt x="560" y="707"/>
                  </a:lnTo>
                  <a:lnTo>
                    <a:pt x="580" y="677"/>
                  </a:lnTo>
                  <a:lnTo>
                    <a:pt x="600" y="632"/>
                  </a:lnTo>
                  <a:lnTo>
                    <a:pt x="620" y="582"/>
                  </a:lnTo>
                  <a:lnTo>
                    <a:pt x="640" y="542"/>
                  </a:lnTo>
                  <a:lnTo>
                    <a:pt x="660" y="509"/>
                  </a:lnTo>
                  <a:lnTo>
                    <a:pt x="680" y="475"/>
                  </a:lnTo>
                  <a:lnTo>
                    <a:pt x="700" y="431"/>
                  </a:lnTo>
                  <a:lnTo>
                    <a:pt x="720" y="378"/>
                  </a:lnTo>
                  <a:lnTo>
                    <a:pt x="740" y="315"/>
                  </a:lnTo>
                  <a:lnTo>
                    <a:pt x="760" y="248"/>
                  </a:lnTo>
                  <a:lnTo>
                    <a:pt x="780" y="179"/>
                  </a:lnTo>
                  <a:lnTo>
                    <a:pt x="800" y="119"/>
                  </a:lnTo>
                  <a:lnTo>
                    <a:pt x="820" y="70"/>
                  </a:lnTo>
                  <a:lnTo>
                    <a:pt x="840" y="33"/>
                  </a:lnTo>
                  <a:lnTo>
                    <a:pt x="860" y="8"/>
                  </a:lnTo>
                  <a:lnTo>
                    <a:pt x="880" y="0"/>
                  </a:lnTo>
                  <a:lnTo>
                    <a:pt x="900" y="5"/>
                  </a:lnTo>
                  <a:lnTo>
                    <a:pt x="920" y="21"/>
                  </a:lnTo>
                  <a:lnTo>
                    <a:pt x="940" y="47"/>
                  </a:lnTo>
                  <a:lnTo>
                    <a:pt x="960" y="89"/>
                  </a:lnTo>
                  <a:lnTo>
                    <a:pt x="980" y="158"/>
                  </a:lnTo>
                  <a:lnTo>
                    <a:pt x="1000" y="244"/>
                  </a:lnTo>
                  <a:lnTo>
                    <a:pt x="1020" y="325"/>
                  </a:lnTo>
                  <a:lnTo>
                    <a:pt x="1040" y="395"/>
                  </a:lnTo>
                  <a:lnTo>
                    <a:pt x="1060" y="467"/>
                  </a:lnTo>
                  <a:lnTo>
                    <a:pt x="1080" y="541"/>
                  </a:lnTo>
                  <a:lnTo>
                    <a:pt x="1100" y="599"/>
                  </a:lnTo>
                  <a:lnTo>
                    <a:pt x="1120" y="636"/>
                  </a:lnTo>
                  <a:lnTo>
                    <a:pt x="1140" y="660"/>
                  </a:lnTo>
                  <a:lnTo>
                    <a:pt x="1160" y="703"/>
                  </a:lnTo>
                  <a:lnTo>
                    <a:pt x="1180" y="759"/>
                  </a:lnTo>
                  <a:lnTo>
                    <a:pt x="1200" y="812"/>
                  </a:lnTo>
                  <a:lnTo>
                    <a:pt x="1220" y="849"/>
                  </a:lnTo>
                  <a:lnTo>
                    <a:pt x="1240" y="864"/>
                  </a:lnTo>
                </a:path>
              </a:pathLst>
            </a:custGeom>
            <a:noFill/>
            <a:ln w="19050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</p:grpSp>
      <p:grpSp>
        <p:nvGrpSpPr>
          <p:cNvPr id="345" name="Groupe 344"/>
          <p:cNvGrpSpPr/>
          <p:nvPr/>
        </p:nvGrpSpPr>
        <p:grpSpPr>
          <a:xfrm>
            <a:off x="4045260" y="7096892"/>
            <a:ext cx="2573135" cy="1478803"/>
            <a:chOff x="4314826" y="2613026"/>
            <a:chExt cx="2032000" cy="1573213"/>
          </a:xfrm>
        </p:grpSpPr>
        <p:sp>
          <p:nvSpPr>
            <p:cNvPr id="346" name="Freeform 83"/>
            <p:cNvSpPr>
              <a:spLocks/>
            </p:cNvSpPr>
            <p:nvPr/>
          </p:nvSpPr>
          <p:spPr bwMode="auto">
            <a:xfrm>
              <a:off x="4314826" y="2655888"/>
              <a:ext cx="2032000" cy="1530350"/>
            </a:xfrm>
            <a:custGeom>
              <a:avLst/>
              <a:gdLst/>
              <a:ahLst/>
              <a:cxnLst>
                <a:cxn ang="0">
                  <a:pos x="0" y="964"/>
                </a:cxn>
                <a:cxn ang="0">
                  <a:pos x="80" y="744"/>
                </a:cxn>
                <a:cxn ang="0">
                  <a:pos x="160" y="384"/>
                </a:cxn>
                <a:cxn ang="0">
                  <a:pos x="240" y="179"/>
                </a:cxn>
                <a:cxn ang="0">
                  <a:pos x="320" y="122"/>
                </a:cxn>
                <a:cxn ang="0">
                  <a:pos x="400" y="243"/>
                </a:cxn>
                <a:cxn ang="0">
                  <a:pos x="480" y="449"/>
                </a:cxn>
                <a:cxn ang="0">
                  <a:pos x="560" y="584"/>
                </a:cxn>
                <a:cxn ang="0">
                  <a:pos x="640" y="492"/>
                </a:cxn>
                <a:cxn ang="0">
                  <a:pos x="720" y="319"/>
                </a:cxn>
                <a:cxn ang="0">
                  <a:pos x="800" y="131"/>
                </a:cxn>
                <a:cxn ang="0">
                  <a:pos x="880" y="0"/>
                </a:cxn>
                <a:cxn ang="0">
                  <a:pos x="960" y="65"/>
                </a:cxn>
                <a:cxn ang="0">
                  <a:pos x="1040" y="300"/>
                </a:cxn>
                <a:cxn ang="0">
                  <a:pos x="1120" y="564"/>
                </a:cxn>
                <a:cxn ang="0">
                  <a:pos x="1200" y="793"/>
                </a:cxn>
                <a:cxn ang="0">
                  <a:pos x="1280" y="927"/>
                </a:cxn>
              </a:cxnLst>
              <a:rect l="0" t="0" r="r" b="b"/>
              <a:pathLst>
                <a:path w="1280" h="964">
                  <a:moveTo>
                    <a:pt x="0" y="964"/>
                  </a:moveTo>
                  <a:lnTo>
                    <a:pt x="80" y="744"/>
                  </a:lnTo>
                  <a:lnTo>
                    <a:pt x="160" y="384"/>
                  </a:lnTo>
                  <a:lnTo>
                    <a:pt x="240" y="179"/>
                  </a:lnTo>
                  <a:lnTo>
                    <a:pt x="320" y="122"/>
                  </a:lnTo>
                  <a:lnTo>
                    <a:pt x="400" y="243"/>
                  </a:lnTo>
                  <a:lnTo>
                    <a:pt x="480" y="449"/>
                  </a:lnTo>
                  <a:lnTo>
                    <a:pt x="560" y="584"/>
                  </a:lnTo>
                  <a:lnTo>
                    <a:pt x="640" y="492"/>
                  </a:lnTo>
                  <a:lnTo>
                    <a:pt x="720" y="319"/>
                  </a:lnTo>
                  <a:lnTo>
                    <a:pt x="800" y="131"/>
                  </a:lnTo>
                  <a:lnTo>
                    <a:pt x="880" y="0"/>
                  </a:lnTo>
                  <a:lnTo>
                    <a:pt x="960" y="65"/>
                  </a:lnTo>
                  <a:lnTo>
                    <a:pt x="1040" y="300"/>
                  </a:lnTo>
                  <a:lnTo>
                    <a:pt x="1120" y="564"/>
                  </a:lnTo>
                  <a:lnTo>
                    <a:pt x="1200" y="793"/>
                  </a:lnTo>
                  <a:lnTo>
                    <a:pt x="1280" y="927"/>
                  </a:lnTo>
                </a:path>
              </a:pathLst>
            </a:cu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47" name="Freeform 84"/>
            <p:cNvSpPr>
              <a:spLocks/>
            </p:cNvSpPr>
            <p:nvPr/>
          </p:nvSpPr>
          <p:spPr bwMode="auto">
            <a:xfrm>
              <a:off x="4314826" y="2613026"/>
              <a:ext cx="2032000" cy="1573213"/>
            </a:xfrm>
            <a:custGeom>
              <a:avLst/>
              <a:gdLst/>
              <a:ahLst/>
              <a:cxnLst>
                <a:cxn ang="0">
                  <a:pos x="0" y="991"/>
                </a:cxn>
                <a:cxn ang="0">
                  <a:pos x="80" y="733"/>
                </a:cxn>
                <a:cxn ang="0">
                  <a:pos x="160" y="376"/>
                </a:cxn>
                <a:cxn ang="0">
                  <a:pos x="240" y="226"/>
                </a:cxn>
                <a:cxn ang="0">
                  <a:pos x="320" y="205"/>
                </a:cxn>
                <a:cxn ang="0">
                  <a:pos x="400" y="328"/>
                </a:cxn>
                <a:cxn ang="0">
                  <a:pos x="480" y="512"/>
                </a:cxn>
                <a:cxn ang="0">
                  <a:pos x="560" y="589"/>
                </a:cxn>
                <a:cxn ang="0">
                  <a:pos x="640" y="437"/>
                </a:cxn>
                <a:cxn ang="0">
                  <a:pos x="720" y="214"/>
                </a:cxn>
                <a:cxn ang="0">
                  <a:pos x="800" y="38"/>
                </a:cxn>
                <a:cxn ang="0">
                  <a:pos x="880" y="0"/>
                </a:cxn>
                <a:cxn ang="0">
                  <a:pos x="960" y="167"/>
                </a:cxn>
                <a:cxn ang="0">
                  <a:pos x="1040" y="448"/>
                </a:cxn>
                <a:cxn ang="0">
                  <a:pos x="1120" y="707"/>
                </a:cxn>
                <a:cxn ang="0">
                  <a:pos x="1200" y="893"/>
                </a:cxn>
                <a:cxn ang="0">
                  <a:pos x="1280" y="987"/>
                </a:cxn>
              </a:cxnLst>
              <a:rect l="0" t="0" r="r" b="b"/>
              <a:pathLst>
                <a:path w="1280" h="991">
                  <a:moveTo>
                    <a:pt x="0" y="991"/>
                  </a:moveTo>
                  <a:lnTo>
                    <a:pt x="80" y="733"/>
                  </a:lnTo>
                  <a:lnTo>
                    <a:pt x="160" y="376"/>
                  </a:lnTo>
                  <a:lnTo>
                    <a:pt x="240" y="226"/>
                  </a:lnTo>
                  <a:lnTo>
                    <a:pt x="320" y="205"/>
                  </a:lnTo>
                  <a:lnTo>
                    <a:pt x="400" y="328"/>
                  </a:lnTo>
                  <a:lnTo>
                    <a:pt x="480" y="512"/>
                  </a:lnTo>
                  <a:lnTo>
                    <a:pt x="560" y="589"/>
                  </a:lnTo>
                  <a:lnTo>
                    <a:pt x="640" y="437"/>
                  </a:lnTo>
                  <a:lnTo>
                    <a:pt x="720" y="214"/>
                  </a:lnTo>
                  <a:lnTo>
                    <a:pt x="800" y="38"/>
                  </a:lnTo>
                  <a:lnTo>
                    <a:pt x="880" y="0"/>
                  </a:lnTo>
                  <a:lnTo>
                    <a:pt x="960" y="167"/>
                  </a:lnTo>
                  <a:lnTo>
                    <a:pt x="1040" y="448"/>
                  </a:lnTo>
                  <a:lnTo>
                    <a:pt x="1120" y="707"/>
                  </a:lnTo>
                  <a:lnTo>
                    <a:pt x="1200" y="893"/>
                  </a:lnTo>
                  <a:lnTo>
                    <a:pt x="1280" y="987"/>
                  </a:lnTo>
                </a:path>
              </a:pathLst>
            </a:custGeom>
            <a:noFill/>
            <a:ln w="19050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</p:grpSp>
      <p:sp>
        <p:nvSpPr>
          <p:cNvPr id="220" name="ZoneTexte 19"/>
          <p:cNvSpPr txBox="1">
            <a:spLocks noChangeArrowheads="1"/>
          </p:cNvSpPr>
          <p:nvPr/>
        </p:nvSpPr>
        <p:spPr bwMode="auto">
          <a:xfrm>
            <a:off x="692696" y="606944"/>
            <a:ext cx="1062673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SR-FTIR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1" name="ZoneTexte 19"/>
          <p:cNvSpPr txBox="1">
            <a:spLocks noChangeArrowheads="1"/>
          </p:cNvSpPr>
          <p:nvPr/>
        </p:nvSpPr>
        <p:spPr bwMode="auto">
          <a:xfrm>
            <a:off x="692696" y="2597587"/>
            <a:ext cx="1062673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000" b="1" dirty="0" err="1" smtClean="0">
                <a:latin typeface="Arial" pitchFamily="34" charset="0"/>
                <a:cs typeface="Arial" pitchFamily="34" charset="0"/>
              </a:rPr>
              <a:t>Globar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-FTIR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2" name="ZoneTexte 19"/>
          <p:cNvSpPr txBox="1">
            <a:spLocks noChangeArrowheads="1"/>
          </p:cNvSpPr>
          <p:nvPr/>
        </p:nvSpPr>
        <p:spPr bwMode="auto">
          <a:xfrm>
            <a:off x="4077072" y="611560"/>
            <a:ext cx="1062673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SR-FTIR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3" name="ZoneTexte 19"/>
          <p:cNvSpPr txBox="1">
            <a:spLocks noChangeArrowheads="1"/>
          </p:cNvSpPr>
          <p:nvPr/>
        </p:nvSpPr>
        <p:spPr bwMode="auto">
          <a:xfrm>
            <a:off x="4077072" y="2602203"/>
            <a:ext cx="1062673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000" b="1" dirty="0" err="1" smtClean="0">
                <a:latin typeface="Arial" pitchFamily="34" charset="0"/>
                <a:cs typeface="Arial" pitchFamily="34" charset="0"/>
              </a:rPr>
              <a:t>Globar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-FTIR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4" name="ZoneTexte 19"/>
          <p:cNvSpPr txBox="1">
            <a:spLocks noChangeArrowheads="1"/>
          </p:cNvSpPr>
          <p:nvPr/>
        </p:nvSpPr>
        <p:spPr bwMode="auto">
          <a:xfrm>
            <a:off x="692696" y="5076056"/>
            <a:ext cx="1062673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SR-FTIR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5" name="ZoneTexte 19"/>
          <p:cNvSpPr txBox="1">
            <a:spLocks noChangeArrowheads="1"/>
          </p:cNvSpPr>
          <p:nvPr/>
        </p:nvSpPr>
        <p:spPr bwMode="auto">
          <a:xfrm>
            <a:off x="692696" y="7066699"/>
            <a:ext cx="1062673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000" b="1" dirty="0" err="1" smtClean="0">
                <a:latin typeface="Arial" pitchFamily="34" charset="0"/>
                <a:cs typeface="Arial" pitchFamily="34" charset="0"/>
              </a:rPr>
              <a:t>Globar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-FTIR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6" name="ZoneTexte 19"/>
          <p:cNvSpPr txBox="1">
            <a:spLocks noChangeArrowheads="1"/>
          </p:cNvSpPr>
          <p:nvPr/>
        </p:nvSpPr>
        <p:spPr bwMode="auto">
          <a:xfrm>
            <a:off x="4077072" y="5080672"/>
            <a:ext cx="1062673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SR-FTIR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7" name="ZoneTexte 19"/>
          <p:cNvSpPr txBox="1">
            <a:spLocks noChangeArrowheads="1"/>
          </p:cNvSpPr>
          <p:nvPr/>
        </p:nvSpPr>
        <p:spPr bwMode="auto">
          <a:xfrm>
            <a:off x="4077072" y="7071315"/>
            <a:ext cx="1062673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000" b="1" dirty="0" err="1" smtClean="0">
                <a:latin typeface="Arial" pitchFamily="34" charset="0"/>
                <a:cs typeface="Arial" pitchFamily="34" charset="0"/>
              </a:rPr>
              <a:t>Globar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-FTIR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8" name="ZoneTexte 19"/>
          <p:cNvSpPr txBox="1">
            <a:spLocks noChangeArrowheads="1"/>
          </p:cNvSpPr>
          <p:nvPr/>
        </p:nvSpPr>
        <p:spPr bwMode="auto">
          <a:xfrm>
            <a:off x="3411397" y="78609"/>
            <a:ext cx="32385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sz="2000" dirty="0" smtClean="0">
                <a:latin typeface="Arial" pitchFamily="34" charset="0"/>
                <a:cs typeface="Arial" pitchFamily="34" charset="0"/>
              </a:rPr>
              <a:t>F</a:t>
            </a:r>
            <a:endParaRPr lang="en-US" sz="2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9" name="ZoneTexte 19"/>
          <p:cNvSpPr txBox="1">
            <a:spLocks noChangeArrowheads="1"/>
          </p:cNvSpPr>
          <p:nvPr/>
        </p:nvSpPr>
        <p:spPr bwMode="auto">
          <a:xfrm>
            <a:off x="3411397" y="2128778"/>
            <a:ext cx="32385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sz="2000" dirty="0" smtClean="0">
                <a:latin typeface="Arial" pitchFamily="34" charset="0"/>
                <a:cs typeface="Arial" pitchFamily="34" charset="0"/>
              </a:rPr>
              <a:t>H</a:t>
            </a:r>
            <a:endParaRPr lang="en-US" sz="2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0" name="ZoneTexte 19"/>
          <p:cNvSpPr txBox="1">
            <a:spLocks noChangeArrowheads="1"/>
          </p:cNvSpPr>
          <p:nvPr/>
        </p:nvSpPr>
        <p:spPr bwMode="auto">
          <a:xfrm>
            <a:off x="80814" y="2128778"/>
            <a:ext cx="32385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sz="2000" dirty="0" smtClean="0">
                <a:latin typeface="Arial" pitchFamily="34" charset="0"/>
                <a:cs typeface="Arial" pitchFamily="34" charset="0"/>
              </a:rPr>
              <a:t>G</a:t>
            </a:r>
            <a:endParaRPr lang="en-US" sz="2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1" name="ZoneTexte 19"/>
          <p:cNvSpPr txBox="1">
            <a:spLocks noChangeArrowheads="1"/>
          </p:cNvSpPr>
          <p:nvPr/>
        </p:nvSpPr>
        <p:spPr bwMode="auto">
          <a:xfrm>
            <a:off x="80814" y="6626850"/>
            <a:ext cx="32385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sz="2000" dirty="0" smtClean="0">
                <a:latin typeface="Arial" pitchFamily="34" charset="0"/>
                <a:cs typeface="Arial" pitchFamily="34" charset="0"/>
              </a:rPr>
              <a:t>K</a:t>
            </a:r>
            <a:endParaRPr lang="en-US" sz="2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2" name="ZoneTexte 19"/>
          <p:cNvSpPr txBox="1">
            <a:spLocks noChangeArrowheads="1"/>
          </p:cNvSpPr>
          <p:nvPr/>
        </p:nvSpPr>
        <p:spPr bwMode="auto">
          <a:xfrm>
            <a:off x="3411397" y="4531930"/>
            <a:ext cx="32385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sz="2000" dirty="0" smtClean="0">
                <a:latin typeface="Arial" pitchFamily="34" charset="0"/>
                <a:cs typeface="Arial" pitchFamily="34" charset="0"/>
              </a:rPr>
              <a:t>J</a:t>
            </a:r>
            <a:endParaRPr lang="en-US" sz="2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8" name="ZoneTexte 19"/>
          <p:cNvSpPr txBox="1">
            <a:spLocks noChangeArrowheads="1"/>
          </p:cNvSpPr>
          <p:nvPr/>
        </p:nvSpPr>
        <p:spPr bwMode="auto">
          <a:xfrm>
            <a:off x="3411397" y="6626850"/>
            <a:ext cx="32385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sz="2000" dirty="0" smtClean="0">
                <a:latin typeface="Arial" pitchFamily="34" charset="0"/>
                <a:cs typeface="Arial" pitchFamily="34" charset="0"/>
              </a:rPr>
              <a:t>L</a:t>
            </a:r>
            <a:endParaRPr lang="en-US" sz="20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591829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 bwMode="auto">
        <a:noFill/>
        <a:ln>
          <a:noFill/>
        </a:ln>
        <a:extLst>
          <a:ext uri="{909E8E84-426E-40DD-AFC4-6F175D3DCCD1}">
            <a14:hiddenFill xmlns:a14="http://schemas.microsoft.com/office/drawing/2010/main">
              <a:solidFill>
                <a:srgbClr val="FFFFFF"/>
              </a:solidFill>
            </a14:hiddenFill>
          </a:ext>
          <a:ext uri="{91240B29-F687-4F45-9708-019B960494DF}">
            <a14:hiddenLine xmlns:a14="http://schemas.microsoft.com/office/drawing/2010/main" w="9525">
              <a:solidFill>
                <a:srgbClr val="000000"/>
              </a:solidFill>
              <a:miter lim="800000"/>
              <a:headEnd/>
              <a:tailEnd/>
            </a14:hiddenLine>
          </a:ext>
        </a:extLst>
      </a:spPr>
      <a:bodyPr vert="horz" wrap="none" lIns="0" tIns="0" rIns="0" bIns="0" numCol="1" anchor="t" anchorCtr="0" compatLnSpc="1">
        <a:prstTxWarp prst="textNoShape">
          <a:avLst/>
        </a:prstTxWarp>
        <a:spAutoFit/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sz="1000" b="0" i="0" u="none" strike="noStrike" cap="none" normalizeH="0" baseline="0" dirty="0" smtClean="0">
            <a:ln>
              <a:noFill/>
            </a:ln>
            <a:solidFill>
              <a:srgbClr val="000000"/>
            </a:solidFill>
            <a:effectLst/>
            <a:cs typeface="Arial" pitchFamily="34" charset="0"/>
          </a:defRPr>
        </a:defPPr>
      </a:lstStyle>
    </a:spDef>
  </a:objectDefaults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14</TotalTime>
  <Words>375</Words>
  <Application>Microsoft Office PowerPoint</Application>
  <PresentationFormat>Affichage à l'écran (4:3)</PresentationFormat>
  <Paragraphs>154</Paragraphs>
  <Slides>2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3" baseType="lpstr">
      <vt:lpstr>Office 主题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hengyuan peng</dc:creator>
  <cp:lastModifiedBy>FLN</cp:lastModifiedBy>
  <cp:revision>168</cp:revision>
  <dcterms:created xsi:type="dcterms:W3CDTF">2013-11-11T15:45:29Z</dcterms:created>
  <dcterms:modified xsi:type="dcterms:W3CDTF">2015-12-11T11:55:17Z</dcterms:modified>
</cp:coreProperties>
</file>